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docProps/app.xml" ContentType="application/vnd.openxmlformats-officedocument.extended-properties+xml"/>
  <Override PartName="/docProps/core.xml" ContentType="application/vnd.openxmlformats-package.core-properties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s/slide1.xml" ContentType="application/vnd.openxmlformats-officedocument.presentationml.slide+xml"/>
  <Default Extension="png" ContentType="image/png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officeDocument/2006/relationships/extended-properties" Target="docProps/app.xml"/><Relationship Id="rId3" Type="http://schemas.openxmlformats.org/package/2006/relationships/metadata/core-properties" Target="docProps/core.xml"/><Relationship Id="rId4" Type="http://schemas.openxmlformats.org/officeDocument/2006/relationships/custom-properties" Target="docProps/custom.xml"/>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6"/>
  </p:sldIdLst>
  <p:sldSz cx="7556500" cy="10693400"/>
  <p:notesSz cx="7556500" cy="10693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1536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1" Type="http://schemas.openxmlformats.org/officeDocument/2006/relationships/slideMaster" Target="slideMasters/slideMaster1.xml"/><Relationship Id="rId2" Type="http://schemas.openxmlformats.org/officeDocument/2006/relationships/theme" Target="theme/theme1.xml"/><Relationship Id="rId3" Type="http://schemas.openxmlformats.org/officeDocument/2006/relationships/viewProps" Target="viewProps.xml"/><Relationship Id="rId4" Type="http://schemas.openxmlformats.org/officeDocument/2006/relationships/presProps" Target="presProps.xml"/><Relationship Id="rId5" Type="http://schemas.openxmlformats.org/officeDocument/2006/relationships/tableStyles" Target="tableStyles.xml"/><Relationship Id="rId6" Type="http://schemas.openxmlformats.org/officeDocument/2006/relationships/slide" Target="slides/slide1.xml"/>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67213" y="3314954"/>
            <a:ext cx="6428422" cy="224561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134427" y="5988304"/>
            <a:ext cx="5293995" cy="267335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idx="2" sz="half"/>
          </p:nvPr>
        </p:nvSpPr>
        <p:spPr>
          <a:xfrm>
            <a:off x="378142" y="2459482"/>
            <a:ext cx="3289839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idx="3" sz="half"/>
          </p:nvPr>
        </p:nvSpPr>
        <p:spPr>
          <a:xfrm>
            <a:off x="3894867" y="2459482"/>
            <a:ext cx="3289839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6" name="Holder 6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7" name="Holder 7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5" name="Holder 5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4" name="Holder 4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theme" Target="../theme/theme1.xml"/></Relationships>
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78142" y="427736"/>
            <a:ext cx="6806565" cy="17109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78142" y="2459482"/>
            <a:ext cx="6806565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>
          <a:xfrm>
            <a:off x="2571369" y="9944862"/>
            <a:ext cx="2420112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>
          <a:xfrm>
            <a:off x="378142" y="9944862"/>
            <a:ext cx="1739455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>
          <a:xfrm>
            <a:off x="5445252" y="9944862"/>
            <a:ext cx="1739455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 folHlink="folHlink" hlink="hlink" accent1="accent1" accent2="accent2" accent3="accent3" accent4="accent4" accent5="accent5" accent6="accent6" tx2="dk2" bg2="lt2" tx1="dk1" bg1="lt1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png"/><Relationship Id="rId24" Type="http://schemas.openxmlformats.org/officeDocument/2006/relationships/image" Target="../media/image23.png"/><Relationship Id="rId25" Type="http://schemas.openxmlformats.org/officeDocument/2006/relationships/image" Target="../media/image24.png"/><Relationship Id="rId26" Type="http://schemas.openxmlformats.org/officeDocument/2006/relationships/image" Target="../media/image25.png"/><Relationship Id="rId27" Type="http://schemas.openxmlformats.org/officeDocument/2006/relationships/image" Target="../media/image26.png"/><Relationship Id="rId28" Type="http://schemas.openxmlformats.org/officeDocument/2006/relationships/image" Target="../media/image27.png"/>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2344496" y="423174"/>
            <a:ext cx="2871470" cy="680085"/>
          </a:xfrm>
          <a:prstGeom prst="rect">
            <a:avLst/>
          </a:prstGeom>
        </p:spPr>
        <p:txBody>
          <a:bodyPr wrap="square" lIns="0" tIns="65405" rIns="0" bIns="0" rtlCol="0" vert="horz">
            <a:spAutoFit/>
          </a:bodyPr>
          <a:lstStyle/>
          <a:p>
            <a:pPr algn="ctr" marR="79375">
              <a:lnSpc>
                <a:spcPct val="100000"/>
              </a:lnSpc>
              <a:spcBef>
                <a:spcPts val="515"/>
              </a:spcBef>
            </a:pPr>
            <a:r>
              <a:rPr dirty="0" sz="1400" i="1">
                <a:solidFill>
                  <a:srgbClr val="231F20"/>
                </a:solidFill>
                <a:latin typeface="Arial"/>
                <a:cs typeface="Arial"/>
              </a:rPr>
              <a:t>Figure</a:t>
            </a:r>
            <a:r>
              <a:rPr dirty="0" sz="1400" spc="-25" i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400" i="1">
                <a:solidFill>
                  <a:srgbClr val="231F20"/>
                </a:solidFill>
                <a:latin typeface="Arial"/>
                <a:cs typeface="Arial"/>
              </a:rPr>
              <a:t>S3</a:t>
            </a:r>
            <a:endParaRPr sz="1400">
              <a:latin typeface="Arial"/>
              <a:cs typeface="Arial"/>
            </a:endParaRPr>
          </a:p>
          <a:p>
            <a:pPr marL="523875" marR="5080" indent="-511809">
              <a:lnSpc>
                <a:spcPct val="103000"/>
              </a:lnSpc>
              <a:spcBef>
                <a:spcPts val="330"/>
              </a:spcBef>
            </a:pPr>
            <a:r>
              <a:rPr dirty="0" sz="1100" spc="20" b="1">
                <a:solidFill>
                  <a:srgbClr val="231F20"/>
                </a:solidFill>
                <a:latin typeface="Arial"/>
                <a:cs typeface="Arial"/>
              </a:rPr>
              <a:t>Mouse</a:t>
            </a:r>
            <a:r>
              <a:rPr dirty="0" sz="1100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0" b="1">
                <a:solidFill>
                  <a:srgbClr val="231F20"/>
                </a:solidFill>
                <a:latin typeface="Arial"/>
                <a:cs typeface="Arial"/>
              </a:rPr>
              <a:t>bilateral</a:t>
            </a:r>
            <a:r>
              <a:rPr dirty="0" sz="1100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0" b="1">
                <a:solidFill>
                  <a:srgbClr val="231F20"/>
                </a:solidFill>
                <a:latin typeface="Arial"/>
                <a:cs typeface="Arial"/>
              </a:rPr>
              <a:t>renal</a:t>
            </a:r>
            <a:r>
              <a:rPr dirty="0" sz="1100" spc="5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0" b="1">
                <a:solidFill>
                  <a:srgbClr val="231F20"/>
                </a:solidFill>
                <a:latin typeface="Arial"/>
                <a:cs typeface="Arial"/>
              </a:rPr>
              <a:t>IRI.</a:t>
            </a:r>
            <a:r>
              <a:rPr dirty="0" sz="1100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5" b="1">
                <a:solidFill>
                  <a:srgbClr val="231F20"/>
                </a:solidFill>
                <a:latin typeface="Arial"/>
                <a:cs typeface="Arial"/>
              </a:rPr>
              <a:t>CCN2</a:t>
            </a:r>
            <a:r>
              <a:rPr dirty="0" sz="1100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20" b="1">
                <a:solidFill>
                  <a:srgbClr val="231F20"/>
                </a:solidFill>
                <a:latin typeface="Arial"/>
                <a:cs typeface="Arial"/>
              </a:rPr>
              <a:t>KO</a:t>
            </a:r>
            <a:r>
              <a:rPr dirty="0" sz="1100" spc="5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5" b="1">
                <a:solidFill>
                  <a:srgbClr val="231F20"/>
                </a:solidFill>
                <a:latin typeface="Arial"/>
                <a:cs typeface="Arial"/>
              </a:rPr>
              <a:t>vs</a:t>
            </a:r>
            <a:r>
              <a:rPr dirty="0" sz="1100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25" b="1">
                <a:solidFill>
                  <a:srgbClr val="231F20"/>
                </a:solidFill>
                <a:latin typeface="Arial"/>
                <a:cs typeface="Arial"/>
              </a:rPr>
              <a:t>WT </a:t>
            </a:r>
            <a:r>
              <a:rPr dirty="0" sz="1100" spc="-290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5" b="1">
                <a:solidFill>
                  <a:srgbClr val="231F20"/>
                </a:solidFill>
                <a:latin typeface="Arial"/>
                <a:cs typeface="Arial"/>
              </a:rPr>
              <a:t>Immediate</a:t>
            </a:r>
            <a:r>
              <a:rPr dirty="0" sz="1100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5" b="1">
                <a:solidFill>
                  <a:srgbClr val="231F20"/>
                </a:solidFill>
                <a:latin typeface="Arial"/>
                <a:cs typeface="Arial"/>
              </a:rPr>
              <a:t>phase</a:t>
            </a:r>
            <a:r>
              <a:rPr dirty="0" sz="1100" spc="5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0" b="1">
                <a:solidFill>
                  <a:srgbClr val="231F20"/>
                </a:solidFill>
                <a:latin typeface="Arial"/>
                <a:cs typeface="Arial"/>
              </a:rPr>
              <a:t>(4</a:t>
            </a:r>
            <a:r>
              <a:rPr dirty="0" sz="1100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5" b="1">
                <a:solidFill>
                  <a:srgbClr val="231F20"/>
                </a:solidFill>
                <a:latin typeface="Arial"/>
                <a:cs typeface="Arial"/>
              </a:rPr>
              <a:t>hours)</a:t>
            </a:r>
            <a:endParaRPr sz="1100">
              <a:latin typeface="Arial"/>
              <a:cs typeface="Arial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558935" y="4277691"/>
            <a:ext cx="132080" cy="202565"/>
          </a:xfrm>
          <a:prstGeom prst="rect">
            <a:avLst/>
          </a:prstGeom>
        </p:spPr>
        <p:txBody>
          <a:bodyPr wrap="square" lIns="0" tIns="1333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dirty="0" sz="1150" spc="5">
                <a:solidFill>
                  <a:srgbClr val="231F20"/>
                </a:solidFill>
                <a:latin typeface="Arial"/>
                <a:cs typeface="Arial"/>
              </a:rPr>
              <a:t>C</a:t>
            </a:r>
            <a:endParaRPr sz="1150">
              <a:latin typeface="Arial"/>
              <a:cs typeface="Arial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558935" y="1239183"/>
            <a:ext cx="123825" cy="202565"/>
          </a:xfrm>
          <a:prstGeom prst="rect">
            <a:avLst/>
          </a:prstGeom>
        </p:spPr>
        <p:txBody>
          <a:bodyPr wrap="square" lIns="0" tIns="1333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dirty="0" sz="1150" spc="5">
                <a:solidFill>
                  <a:srgbClr val="231F20"/>
                </a:solidFill>
                <a:latin typeface="Arial"/>
                <a:cs typeface="Arial"/>
              </a:rPr>
              <a:t>A</a:t>
            </a:r>
            <a:endParaRPr sz="1150">
              <a:latin typeface="Arial"/>
              <a:cs typeface="Arial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3962306" y="1239183"/>
            <a:ext cx="123825" cy="202565"/>
          </a:xfrm>
          <a:prstGeom prst="rect">
            <a:avLst/>
          </a:prstGeom>
        </p:spPr>
        <p:txBody>
          <a:bodyPr wrap="square" lIns="0" tIns="1333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dirty="0" sz="1150" spc="5">
                <a:solidFill>
                  <a:srgbClr val="231F20"/>
                </a:solidFill>
                <a:latin typeface="Arial"/>
                <a:cs typeface="Arial"/>
              </a:rPr>
              <a:t>B</a:t>
            </a:r>
            <a:endParaRPr sz="1150">
              <a:latin typeface="Arial"/>
              <a:cs typeface="Arial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3962306" y="4277691"/>
            <a:ext cx="132080" cy="202565"/>
          </a:xfrm>
          <a:prstGeom prst="rect">
            <a:avLst/>
          </a:prstGeom>
        </p:spPr>
        <p:txBody>
          <a:bodyPr wrap="square" lIns="0" tIns="1333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dirty="0" sz="1150" spc="5">
                <a:solidFill>
                  <a:srgbClr val="231F20"/>
                </a:solidFill>
                <a:latin typeface="Arial"/>
                <a:cs typeface="Arial"/>
              </a:rPr>
              <a:t>D</a:t>
            </a:r>
            <a:endParaRPr sz="1150">
              <a:latin typeface="Arial"/>
              <a:cs typeface="Arial"/>
            </a:endParaRPr>
          </a:p>
        </p:txBody>
      </p:sp>
      <p:pic>
        <p:nvPicPr>
          <p:cNvPr id="7" name="object 7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053372" y="2760933"/>
            <a:ext cx="2701328" cy="718248"/>
          </a:xfrm>
          <a:prstGeom prst="rect">
            <a:avLst/>
          </a:prstGeom>
        </p:spPr>
      </p:pic>
      <p:sp>
        <p:nvSpPr>
          <p:cNvPr id="8" name="object 8"/>
          <p:cNvSpPr txBox="1"/>
          <p:nvPr/>
        </p:nvSpPr>
        <p:spPr>
          <a:xfrm>
            <a:off x="1259532" y="3515109"/>
            <a:ext cx="431165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20" b="1">
                <a:latin typeface="Arial"/>
                <a:cs typeface="Arial"/>
              </a:rPr>
              <a:t>SHA</a:t>
            </a:r>
            <a:r>
              <a:rPr dirty="0" sz="1100" spc="-10" b="1">
                <a:latin typeface="Arial"/>
                <a:cs typeface="Arial"/>
              </a:rPr>
              <a:t>M</a:t>
            </a:r>
            <a:endParaRPr sz="1100"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2006426" y="3515109"/>
            <a:ext cx="2044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I</a:t>
            </a:r>
            <a:r>
              <a:rPr dirty="0" sz="1100" spc="5" b="1">
                <a:latin typeface="Arial"/>
                <a:cs typeface="Arial"/>
              </a:rPr>
              <a:t>R</a:t>
            </a:r>
            <a:r>
              <a:rPr dirty="0" sz="1100" spc="-5" b="1">
                <a:latin typeface="Arial"/>
                <a:cs typeface="Arial"/>
              </a:rPr>
              <a:t>I</a:t>
            </a:r>
            <a:endParaRPr sz="1100">
              <a:latin typeface="Arial"/>
              <a:cs typeface="Arial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2524701" y="3515109"/>
            <a:ext cx="431165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20" b="1">
                <a:latin typeface="Arial"/>
                <a:cs typeface="Arial"/>
              </a:rPr>
              <a:t>SHA</a:t>
            </a:r>
            <a:r>
              <a:rPr dirty="0" sz="1100" spc="-10" b="1">
                <a:latin typeface="Arial"/>
                <a:cs typeface="Arial"/>
              </a:rPr>
              <a:t>M</a:t>
            </a:r>
            <a:endParaRPr sz="1100">
              <a:latin typeface="Arial"/>
              <a:cs typeface="Arial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3271594" y="3515109"/>
            <a:ext cx="2044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I</a:t>
            </a:r>
            <a:r>
              <a:rPr dirty="0" sz="1100" spc="5" b="1">
                <a:latin typeface="Arial"/>
                <a:cs typeface="Arial"/>
              </a:rPr>
              <a:t>R</a:t>
            </a:r>
            <a:r>
              <a:rPr dirty="0" sz="1100" spc="-5" b="1">
                <a:latin typeface="Arial"/>
                <a:cs typeface="Arial"/>
              </a:rPr>
              <a:t>I</a:t>
            </a:r>
            <a:endParaRPr sz="1100">
              <a:latin typeface="Arial"/>
              <a:cs typeface="Arial"/>
            </a:endParaRPr>
          </a:p>
        </p:txBody>
      </p:sp>
      <p:grpSp>
        <p:nvGrpSpPr>
          <p:cNvPr id="12" name="object 12"/>
          <p:cNvGrpSpPr/>
          <p:nvPr/>
        </p:nvGrpSpPr>
        <p:grpSpPr>
          <a:xfrm>
            <a:off x="990052" y="1621091"/>
            <a:ext cx="2827020" cy="1908810"/>
            <a:chOff x="990052" y="1621091"/>
            <a:chExt cx="2827020" cy="1908810"/>
          </a:xfrm>
        </p:grpSpPr>
        <p:sp>
          <p:nvSpPr>
            <p:cNvPr id="13" name="object 13"/>
            <p:cNvSpPr/>
            <p:nvPr/>
          </p:nvSpPr>
          <p:spPr>
            <a:xfrm>
              <a:off x="1044990" y="3465484"/>
              <a:ext cx="2762885" cy="0"/>
            </a:xfrm>
            <a:custGeom>
              <a:avLst/>
              <a:gdLst/>
              <a:ahLst/>
              <a:cxnLst/>
              <a:rect l="l" t="t" r="r" b="b"/>
              <a:pathLst>
                <a:path w="2762885" h="0">
                  <a:moveTo>
                    <a:pt x="0" y="0"/>
                  </a:moveTo>
                  <a:lnTo>
                    <a:pt x="276230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4" name="object 14"/>
            <p:cNvSpPr/>
            <p:nvPr/>
          </p:nvSpPr>
          <p:spPr>
            <a:xfrm>
              <a:off x="1474886" y="3465484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w="0" h="55245">
                  <a:moveTo>
                    <a:pt x="0" y="54787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5" name="object 15"/>
            <p:cNvSpPr/>
            <p:nvPr/>
          </p:nvSpPr>
          <p:spPr>
            <a:xfrm>
              <a:off x="2107530" y="3465484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w="0" h="55245">
                  <a:moveTo>
                    <a:pt x="0" y="54787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6" name="object 16"/>
            <p:cNvSpPr/>
            <p:nvPr/>
          </p:nvSpPr>
          <p:spPr>
            <a:xfrm>
              <a:off x="2740179" y="3465484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w="0" h="55245">
                  <a:moveTo>
                    <a:pt x="0" y="54787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7" name="object 17"/>
            <p:cNvSpPr/>
            <p:nvPr/>
          </p:nvSpPr>
          <p:spPr>
            <a:xfrm>
              <a:off x="3372829" y="3465484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w="0" h="55245">
                  <a:moveTo>
                    <a:pt x="0" y="54787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8" name="object 18"/>
            <p:cNvSpPr/>
            <p:nvPr/>
          </p:nvSpPr>
          <p:spPr>
            <a:xfrm>
              <a:off x="1054136" y="1630299"/>
              <a:ext cx="0" cy="1844675"/>
            </a:xfrm>
            <a:custGeom>
              <a:avLst/>
              <a:gdLst/>
              <a:ahLst/>
              <a:cxnLst/>
              <a:rect l="l" t="t" r="r" b="b"/>
              <a:pathLst>
                <a:path w="0" h="1844675">
                  <a:moveTo>
                    <a:pt x="0" y="1844319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9" name="object 19"/>
            <p:cNvSpPr/>
            <p:nvPr/>
          </p:nvSpPr>
          <p:spPr>
            <a:xfrm>
              <a:off x="999260" y="3100273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4" h="0">
                  <a:moveTo>
                    <a:pt x="54876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0" name="object 20"/>
            <p:cNvSpPr/>
            <p:nvPr/>
          </p:nvSpPr>
          <p:spPr>
            <a:xfrm>
              <a:off x="999260" y="2735060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4" h="0">
                  <a:moveTo>
                    <a:pt x="54876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1" name="object 21"/>
            <p:cNvSpPr/>
            <p:nvPr/>
          </p:nvSpPr>
          <p:spPr>
            <a:xfrm>
              <a:off x="999260" y="2369849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4" h="0">
                  <a:moveTo>
                    <a:pt x="54876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2" name="object 22"/>
            <p:cNvSpPr/>
            <p:nvPr/>
          </p:nvSpPr>
          <p:spPr>
            <a:xfrm>
              <a:off x="999260" y="2004636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4" h="0">
                  <a:moveTo>
                    <a:pt x="54876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3" name="object 23"/>
            <p:cNvSpPr/>
            <p:nvPr/>
          </p:nvSpPr>
          <p:spPr>
            <a:xfrm>
              <a:off x="999260" y="1639431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4" h="0">
                  <a:moveTo>
                    <a:pt x="54876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4" name="object 24"/>
            <p:cNvSpPr/>
            <p:nvPr/>
          </p:nvSpPr>
          <p:spPr>
            <a:xfrm>
              <a:off x="999260" y="3465484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4" h="0">
                  <a:moveTo>
                    <a:pt x="54876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5" name="object 25"/>
            <p:cNvSpPr/>
            <p:nvPr/>
          </p:nvSpPr>
          <p:spPr>
            <a:xfrm>
              <a:off x="3372829" y="2560063"/>
              <a:ext cx="0" cy="201295"/>
            </a:xfrm>
            <a:custGeom>
              <a:avLst/>
              <a:gdLst/>
              <a:ahLst/>
              <a:cxnLst/>
              <a:rect l="l" t="t" r="r" b="b"/>
              <a:pathLst>
                <a:path w="0" h="201294">
                  <a:moveTo>
                    <a:pt x="0" y="0"/>
                  </a:moveTo>
                  <a:lnTo>
                    <a:pt x="0" y="200863"/>
                  </a:lnTo>
                </a:path>
              </a:pathLst>
            </a:custGeom>
            <a:ln w="9131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6" name="object 26"/>
            <p:cNvSpPr/>
            <p:nvPr/>
          </p:nvSpPr>
          <p:spPr>
            <a:xfrm>
              <a:off x="3372829" y="2760931"/>
              <a:ext cx="0" cy="201295"/>
            </a:xfrm>
            <a:custGeom>
              <a:avLst/>
              <a:gdLst/>
              <a:ahLst/>
              <a:cxnLst/>
              <a:rect l="l" t="t" r="r" b="b"/>
              <a:pathLst>
                <a:path w="0" h="201294">
                  <a:moveTo>
                    <a:pt x="0" y="0"/>
                  </a:moveTo>
                  <a:lnTo>
                    <a:pt x="0" y="200863"/>
                  </a:lnTo>
                </a:path>
              </a:pathLst>
            </a:custGeom>
            <a:ln w="9131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7" name="object 27"/>
            <p:cNvSpPr/>
            <p:nvPr/>
          </p:nvSpPr>
          <p:spPr>
            <a:xfrm>
              <a:off x="3267638" y="2560063"/>
              <a:ext cx="210820" cy="0"/>
            </a:xfrm>
            <a:custGeom>
              <a:avLst/>
              <a:gdLst/>
              <a:ahLst/>
              <a:cxnLst/>
              <a:rect l="l" t="t" r="r" b="b"/>
              <a:pathLst>
                <a:path w="210820" h="0">
                  <a:moveTo>
                    <a:pt x="0" y="0"/>
                  </a:moveTo>
                  <a:lnTo>
                    <a:pt x="210375" y="0"/>
                  </a:lnTo>
                </a:path>
              </a:pathLst>
            </a:custGeom>
            <a:ln w="9131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8" name="object 28"/>
            <p:cNvSpPr/>
            <p:nvPr/>
          </p:nvSpPr>
          <p:spPr>
            <a:xfrm>
              <a:off x="3267638" y="2961800"/>
              <a:ext cx="210820" cy="0"/>
            </a:xfrm>
            <a:custGeom>
              <a:avLst/>
              <a:gdLst/>
              <a:ahLst/>
              <a:cxnLst/>
              <a:rect l="l" t="t" r="r" b="b"/>
              <a:pathLst>
                <a:path w="210820" h="0">
                  <a:moveTo>
                    <a:pt x="0" y="0"/>
                  </a:moveTo>
                  <a:lnTo>
                    <a:pt x="210375" y="0"/>
                  </a:lnTo>
                </a:path>
              </a:pathLst>
            </a:custGeom>
            <a:ln w="9131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9" name="object 29"/>
            <p:cNvSpPr/>
            <p:nvPr/>
          </p:nvSpPr>
          <p:spPr>
            <a:xfrm>
              <a:off x="3336242" y="2677241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177" y="0"/>
                  </a:moveTo>
                  <a:lnTo>
                    <a:pt x="0" y="0"/>
                  </a:lnTo>
                  <a:lnTo>
                    <a:pt x="36588" y="73037"/>
                  </a:lnTo>
                  <a:lnTo>
                    <a:pt x="73177" y="0"/>
                  </a:lnTo>
                  <a:close/>
                </a:path>
              </a:pathLst>
            </a:custGeom>
            <a:solidFill>
              <a:srgbClr val="1349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0" name="object 30"/>
            <p:cNvSpPr/>
            <p:nvPr/>
          </p:nvSpPr>
          <p:spPr>
            <a:xfrm>
              <a:off x="3336242" y="2677241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177" y="0"/>
                  </a:lnTo>
                  <a:lnTo>
                    <a:pt x="36588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31" name="object 31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335480" y="2422348"/>
              <a:ext cx="74701" cy="74561"/>
            </a:xfrm>
            <a:prstGeom prst="rect">
              <a:avLst/>
            </a:prstGeom>
          </p:spPr>
        </p:pic>
        <p:pic>
          <p:nvPicPr>
            <p:cNvPr id="32" name="object 32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3408654" y="3263860"/>
              <a:ext cx="74701" cy="74561"/>
            </a:xfrm>
            <a:prstGeom prst="rect">
              <a:avLst/>
            </a:prstGeom>
          </p:spPr>
        </p:pic>
        <p:pic>
          <p:nvPicPr>
            <p:cNvPr id="33" name="object 33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335480" y="1783231"/>
              <a:ext cx="74701" cy="74561"/>
            </a:xfrm>
            <a:prstGeom prst="rect">
              <a:avLst/>
            </a:prstGeom>
          </p:spPr>
        </p:pic>
        <p:sp>
          <p:nvSpPr>
            <p:cNvPr id="34" name="object 34"/>
            <p:cNvSpPr/>
            <p:nvPr/>
          </p:nvSpPr>
          <p:spPr>
            <a:xfrm>
              <a:off x="3336242" y="2585934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177" y="0"/>
                  </a:moveTo>
                  <a:lnTo>
                    <a:pt x="0" y="0"/>
                  </a:lnTo>
                  <a:lnTo>
                    <a:pt x="36588" y="73037"/>
                  </a:lnTo>
                  <a:lnTo>
                    <a:pt x="73177" y="0"/>
                  </a:lnTo>
                  <a:close/>
                </a:path>
              </a:pathLst>
            </a:custGeom>
            <a:solidFill>
              <a:srgbClr val="1349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" name="object 35"/>
            <p:cNvSpPr/>
            <p:nvPr/>
          </p:nvSpPr>
          <p:spPr>
            <a:xfrm>
              <a:off x="3336242" y="2585934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177" y="0"/>
                  </a:lnTo>
                  <a:lnTo>
                    <a:pt x="36588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36" name="object 36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262307" y="3269944"/>
              <a:ext cx="74701" cy="74561"/>
            </a:xfrm>
            <a:prstGeom prst="rect">
              <a:avLst/>
            </a:prstGeom>
          </p:spPr>
        </p:pic>
        <p:pic>
          <p:nvPicPr>
            <p:cNvPr id="37" name="object 37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335480" y="3064511"/>
              <a:ext cx="74701" cy="74561"/>
            </a:xfrm>
            <a:prstGeom prst="rect">
              <a:avLst/>
            </a:prstGeom>
          </p:spPr>
        </p:pic>
        <p:pic>
          <p:nvPicPr>
            <p:cNvPr id="38" name="object 38"/>
            <p:cNvPicPr/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2529041" y="3367332"/>
              <a:ext cx="422277" cy="114132"/>
            </a:xfrm>
            <a:prstGeom prst="rect">
              <a:avLst/>
            </a:prstGeom>
          </p:spPr>
        </p:pic>
        <p:sp>
          <p:nvSpPr>
            <p:cNvPr id="39" name="object 39"/>
            <p:cNvSpPr/>
            <p:nvPr/>
          </p:nvSpPr>
          <p:spPr>
            <a:xfrm>
              <a:off x="2107530" y="2712240"/>
              <a:ext cx="0" cy="131445"/>
            </a:xfrm>
            <a:custGeom>
              <a:avLst/>
              <a:gdLst/>
              <a:ahLst/>
              <a:cxnLst/>
              <a:rect l="l" t="t" r="r" b="b"/>
              <a:pathLst>
                <a:path w="0" h="131444">
                  <a:moveTo>
                    <a:pt x="0" y="0"/>
                  </a:moveTo>
                  <a:lnTo>
                    <a:pt x="0" y="130860"/>
                  </a:lnTo>
                </a:path>
              </a:pathLst>
            </a:custGeom>
            <a:ln w="9131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0" name="object 40"/>
            <p:cNvSpPr/>
            <p:nvPr/>
          </p:nvSpPr>
          <p:spPr>
            <a:xfrm>
              <a:off x="2107530" y="2843103"/>
              <a:ext cx="0" cy="129539"/>
            </a:xfrm>
            <a:custGeom>
              <a:avLst/>
              <a:gdLst/>
              <a:ahLst/>
              <a:cxnLst/>
              <a:rect l="l" t="t" r="r" b="b"/>
              <a:pathLst>
                <a:path w="0" h="129539">
                  <a:moveTo>
                    <a:pt x="0" y="0"/>
                  </a:moveTo>
                  <a:lnTo>
                    <a:pt x="0" y="129349"/>
                  </a:lnTo>
                </a:path>
              </a:pathLst>
            </a:custGeom>
            <a:ln w="9131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1" name="object 41"/>
            <p:cNvSpPr/>
            <p:nvPr/>
          </p:nvSpPr>
          <p:spPr>
            <a:xfrm>
              <a:off x="2002345" y="2712240"/>
              <a:ext cx="210820" cy="0"/>
            </a:xfrm>
            <a:custGeom>
              <a:avLst/>
              <a:gdLst/>
              <a:ahLst/>
              <a:cxnLst/>
              <a:rect l="l" t="t" r="r" b="b"/>
              <a:pathLst>
                <a:path w="210819" h="0">
                  <a:moveTo>
                    <a:pt x="0" y="0"/>
                  </a:moveTo>
                  <a:lnTo>
                    <a:pt x="210375" y="0"/>
                  </a:lnTo>
                </a:path>
              </a:pathLst>
            </a:custGeom>
            <a:ln w="9131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2" name="object 42"/>
            <p:cNvSpPr/>
            <p:nvPr/>
          </p:nvSpPr>
          <p:spPr>
            <a:xfrm>
              <a:off x="2002345" y="2972454"/>
              <a:ext cx="210820" cy="0"/>
            </a:xfrm>
            <a:custGeom>
              <a:avLst/>
              <a:gdLst/>
              <a:ahLst/>
              <a:cxnLst/>
              <a:rect l="l" t="t" r="r" b="b"/>
              <a:pathLst>
                <a:path w="210819" h="0">
                  <a:moveTo>
                    <a:pt x="0" y="0"/>
                  </a:moveTo>
                  <a:lnTo>
                    <a:pt x="210375" y="0"/>
                  </a:lnTo>
                </a:path>
              </a:pathLst>
            </a:custGeom>
            <a:ln w="9131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3" name="object 43"/>
            <p:cNvSpPr/>
            <p:nvPr/>
          </p:nvSpPr>
          <p:spPr>
            <a:xfrm>
              <a:off x="1997773" y="2660497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164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164" y="73037"/>
                  </a:lnTo>
                  <a:lnTo>
                    <a:pt x="73164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4" name="object 44"/>
            <p:cNvSpPr/>
            <p:nvPr/>
          </p:nvSpPr>
          <p:spPr>
            <a:xfrm>
              <a:off x="1997773" y="2660497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164" y="0"/>
                  </a:lnTo>
                  <a:lnTo>
                    <a:pt x="73164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5" name="object 45"/>
            <p:cNvSpPr/>
            <p:nvPr/>
          </p:nvSpPr>
          <p:spPr>
            <a:xfrm>
              <a:off x="2070938" y="2809633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177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177" y="73037"/>
                  </a:lnTo>
                  <a:lnTo>
                    <a:pt x="73177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6" name="object 46"/>
            <p:cNvSpPr/>
            <p:nvPr/>
          </p:nvSpPr>
          <p:spPr>
            <a:xfrm>
              <a:off x="2070938" y="2809633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177" y="0"/>
                  </a:lnTo>
                  <a:lnTo>
                    <a:pt x="73177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7" name="object 47"/>
            <p:cNvSpPr/>
            <p:nvPr/>
          </p:nvSpPr>
          <p:spPr>
            <a:xfrm>
              <a:off x="2070938" y="2339416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177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177" y="73037"/>
                  </a:lnTo>
                  <a:lnTo>
                    <a:pt x="73177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8" name="object 48"/>
            <p:cNvSpPr/>
            <p:nvPr/>
          </p:nvSpPr>
          <p:spPr>
            <a:xfrm>
              <a:off x="2070938" y="2339416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177" y="0"/>
                  </a:lnTo>
                  <a:lnTo>
                    <a:pt x="73177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9" name="object 49"/>
            <p:cNvSpPr/>
            <p:nvPr/>
          </p:nvSpPr>
          <p:spPr>
            <a:xfrm>
              <a:off x="2144115" y="2698546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177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177" y="73037"/>
                  </a:lnTo>
                  <a:lnTo>
                    <a:pt x="73177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0" name="object 50"/>
            <p:cNvSpPr/>
            <p:nvPr/>
          </p:nvSpPr>
          <p:spPr>
            <a:xfrm>
              <a:off x="2144115" y="2698546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177" y="0"/>
                  </a:lnTo>
                  <a:lnTo>
                    <a:pt x="73177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1" name="object 51"/>
            <p:cNvSpPr/>
            <p:nvPr/>
          </p:nvSpPr>
          <p:spPr>
            <a:xfrm>
              <a:off x="2144115" y="3139846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177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177" y="73037"/>
                  </a:lnTo>
                  <a:lnTo>
                    <a:pt x="73177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2" name="object 52"/>
            <p:cNvSpPr/>
            <p:nvPr/>
          </p:nvSpPr>
          <p:spPr>
            <a:xfrm>
              <a:off x="2144115" y="3139846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177" y="0"/>
                  </a:lnTo>
                  <a:lnTo>
                    <a:pt x="73177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3" name="object 53"/>
            <p:cNvSpPr/>
            <p:nvPr/>
          </p:nvSpPr>
          <p:spPr>
            <a:xfrm>
              <a:off x="1997773" y="3188538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164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164" y="73037"/>
                  </a:lnTo>
                  <a:lnTo>
                    <a:pt x="73164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4" name="object 54"/>
            <p:cNvSpPr/>
            <p:nvPr/>
          </p:nvSpPr>
          <p:spPr>
            <a:xfrm>
              <a:off x="1997773" y="3188538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164" y="0"/>
                  </a:lnTo>
                  <a:lnTo>
                    <a:pt x="73164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55" name="object 55"/>
            <p:cNvPicPr/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1263746" y="3406908"/>
              <a:ext cx="422277" cy="86721"/>
            </a:xfrm>
            <a:prstGeom prst="rect">
              <a:avLst/>
            </a:prstGeom>
          </p:spPr>
        </p:pic>
      </p:grpSp>
      <p:sp>
        <p:nvSpPr>
          <p:cNvPr id="56" name="object 56"/>
          <p:cNvSpPr txBox="1"/>
          <p:nvPr/>
        </p:nvSpPr>
        <p:spPr>
          <a:xfrm>
            <a:off x="890537" y="3364496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5" b="1">
                <a:latin typeface="Arial"/>
                <a:cs typeface="Arial"/>
              </a:rPr>
              <a:t>0</a:t>
            </a:r>
            <a:endParaRPr sz="1100">
              <a:latin typeface="Arial"/>
              <a:cs typeface="Arial"/>
            </a:endParaRPr>
          </a:p>
        </p:txBody>
      </p:sp>
      <p:sp>
        <p:nvSpPr>
          <p:cNvPr id="57" name="object 57"/>
          <p:cNvSpPr txBox="1"/>
          <p:nvPr/>
        </p:nvSpPr>
        <p:spPr>
          <a:xfrm>
            <a:off x="812713" y="2999197"/>
            <a:ext cx="182245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10" b="1">
                <a:latin typeface="Arial"/>
                <a:cs typeface="Arial"/>
              </a:rPr>
              <a:t>2</a:t>
            </a:r>
            <a:r>
              <a:rPr dirty="0" sz="1100" spc="-5" b="1">
                <a:latin typeface="Arial"/>
                <a:cs typeface="Arial"/>
              </a:rPr>
              <a:t>0</a:t>
            </a:r>
            <a:endParaRPr sz="1100">
              <a:latin typeface="Arial"/>
              <a:cs typeface="Arial"/>
            </a:endParaRPr>
          </a:p>
        </p:txBody>
      </p:sp>
      <p:sp>
        <p:nvSpPr>
          <p:cNvPr id="58" name="object 58"/>
          <p:cNvSpPr txBox="1"/>
          <p:nvPr/>
        </p:nvSpPr>
        <p:spPr>
          <a:xfrm>
            <a:off x="812713" y="2634037"/>
            <a:ext cx="182245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10" b="1">
                <a:latin typeface="Arial"/>
                <a:cs typeface="Arial"/>
              </a:rPr>
              <a:t>4</a:t>
            </a:r>
            <a:r>
              <a:rPr dirty="0" sz="1100" spc="-5" b="1">
                <a:latin typeface="Arial"/>
                <a:cs typeface="Arial"/>
              </a:rPr>
              <a:t>0</a:t>
            </a:r>
            <a:endParaRPr sz="1100">
              <a:latin typeface="Arial"/>
              <a:cs typeface="Arial"/>
            </a:endParaRPr>
          </a:p>
        </p:txBody>
      </p:sp>
      <p:sp>
        <p:nvSpPr>
          <p:cNvPr id="59" name="object 59"/>
          <p:cNvSpPr txBox="1"/>
          <p:nvPr/>
        </p:nvSpPr>
        <p:spPr>
          <a:xfrm>
            <a:off x="812713" y="2268877"/>
            <a:ext cx="182245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10" b="1">
                <a:latin typeface="Arial"/>
                <a:cs typeface="Arial"/>
              </a:rPr>
              <a:t>6</a:t>
            </a:r>
            <a:r>
              <a:rPr dirty="0" sz="1100" spc="-5" b="1">
                <a:latin typeface="Arial"/>
                <a:cs typeface="Arial"/>
              </a:rPr>
              <a:t>0</a:t>
            </a:r>
            <a:endParaRPr sz="1100">
              <a:latin typeface="Arial"/>
              <a:cs typeface="Arial"/>
            </a:endParaRPr>
          </a:p>
        </p:txBody>
      </p:sp>
      <p:sp>
        <p:nvSpPr>
          <p:cNvPr id="60" name="object 60"/>
          <p:cNvSpPr txBox="1"/>
          <p:nvPr/>
        </p:nvSpPr>
        <p:spPr>
          <a:xfrm>
            <a:off x="812713" y="1903716"/>
            <a:ext cx="182245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10" b="1">
                <a:latin typeface="Arial"/>
                <a:cs typeface="Arial"/>
              </a:rPr>
              <a:t>8</a:t>
            </a:r>
            <a:r>
              <a:rPr dirty="0" sz="1100" spc="-5" b="1">
                <a:latin typeface="Arial"/>
                <a:cs typeface="Arial"/>
              </a:rPr>
              <a:t>0</a:t>
            </a:r>
            <a:endParaRPr sz="1100">
              <a:latin typeface="Arial"/>
              <a:cs typeface="Arial"/>
            </a:endParaRPr>
          </a:p>
        </p:txBody>
      </p:sp>
      <p:sp>
        <p:nvSpPr>
          <p:cNvPr id="61" name="object 61"/>
          <p:cNvSpPr txBox="1"/>
          <p:nvPr/>
        </p:nvSpPr>
        <p:spPr>
          <a:xfrm>
            <a:off x="735027" y="1538555"/>
            <a:ext cx="259715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5" b="1">
                <a:latin typeface="Arial"/>
                <a:cs typeface="Arial"/>
              </a:rPr>
              <a:t>1</a:t>
            </a:r>
            <a:r>
              <a:rPr dirty="0" sz="1100" spc="10" b="1">
                <a:latin typeface="Arial"/>
                <a:cs typeface="Arial"/>
              </a:rPr>
              <a:t>0</a:t>
            </a:r>
            <a:r>
              <a:rPr dirty="0" sz="1100" spc="-5" b="1">
                <a:latin typeface="Arial"/>
                <a:cs typeface="Arial"/>
              </a:rPr>
              <a:t>0</a:t>
            </a:r>
            <a:endParaRPr sz="1100">
              <a:latin typeface="Arial"/>
              <a:cs typeface="Arial"/>
            </a:endParaRPr>
          </a:p>
        </p:txBody>
      </p:sp>
      <p:sp>
        <p:nvSpPr>
          <p:cNvPr id="62" name="object 62"/>
          <p:cNvSpPr txBox="1"/>
          <p:nvPr/>
        </p:nvSpPr>
        <p:spPr>
          <a:xfrm>
            <a:off x="510239" y="1535029"/>
            <a:ext cx="196215" cy="2034539"/>
          </a:xfrm>
          <a:prstGeom prst="rect">
            <a:avLst/>
          </a:prstGeom>
        </p:spPr>
        <p:txBody>
          <a:bodyPr wrap="square" lIns="0" tIns="0" rIns="0" bIns="0" rtlCol="0" vert="vert270">
            <a:spAutoFit/>
          </a:bodyPr>
          <a:lstStyle/>
          <a:p>
            <a:pPr marL="12700">
              <a:lnSpc>
                <a:spcPts val="1425"/>
              </a:lnSpc>
            </a:pPr>
            <a:r>
              <a:rPr dirty="0" sz="1200" spc="-20" b="1">
                <a:latin typeface="Arial"/>
                <a:cs typeface="Arial"/>
              </a:rPr>
              <a:t>mRNA</a:t>
            </a:r>
            <a:r>
              <a:rPr dirty="0" sz="1200" spc="-40" b="1">
                <a:latin typeface="Arial"/>
                <a:cs typeface="Arial"/>
              </a:rPr>
              <a:t> </a:t>
            </a:r>
            <a:r>
              <a:rPr dirty="0" sz="1200" spc="-20" b="1">
                <a:latin typeface="Arial"/>
                <a:cs typeface="Arial"/>
              </a:rPr>
              <a:t>HMOX1</a:t>
            </a:r>
            <a:r>
              <a:rPr dirty="0" sz="1200" spc="-25" b="1">
                <a:latin typeface="Arial"/>
                <a:cs typeface="Arial"/>
              </a:rPr>
              <a:t> </a:t>
            </a:r>
            <a:r>
              <a:rPr dirty="0" sz="1200" spc="-15" b="1">
                <a:latin typeface="Arial"/>
                <a:cs typeface="Arial"/>
              </a:rPr>
              <a:t>(fold</a:t>
            </a:r>
            <a:r>
              <a:rPr dirty="0" sz="1200" spc="-40" b="1">
                <a:latin typeface="Arial"/>
                <a:cs typeface="Arial"/>
              </a:rPr>
              <a:t> </a:t>
            </a:r>
            <a:r>
              <a:rPr dirty="0" sz="1200" spc="-15" b="1">
                <a:latin typeface="Arial"/>
                <a:cs typeface="Arial"/>
              </a:rPr>
              <a:t>change)</a:t>
            </a:r>
            <a:endParaRPr sz="1200">
              <a:latin typeface="Arial"/>
              <a:cs typeface="Arial"/>
            </a:endParaRPr>
          </a:p>
        </p:txBody>
      </p:sp>
      <p:sp>
        <p:nvSpPr>
          <p:cNvPr id="63" name="object 63"/>
          <p:cNvSpPr/>
          <p:nvPr/>
        </p:nvSpPr>
        <p:spPr>
          <a:xfrm>
            <a:off x="1302623" y="3788087"/>
            <a:ext cx="1012825" cy="0"/>
          </a:xfrm>
          <a:custGeom>
            <a:avLst/>
            <a:gdLst/>
            <a:ahLst/>
            <a:cxnLst/>
            <a:rect l="l" t="t" r="r" b="b"/>
            <a:pathLst>
              <a:path w="1012825" h="0">
                <a:moveTo>
                  <a:pt x="0" y="0"/>
                </a:moveTo>
                <a:lnTo>
                  <a:pt x="1012240" y="0"/>
                </a:lnTo>
              </a:path>
            </a:pathLst>
          </a:custGeom>
          <a:ln w="18262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4" name="object 64"/>
          <p:cNvSpPr txBox="1"/>
          <p:nvPr/>
        </p:nvSpPr>
        <p:spPr>
          <a:xfrm>
            <a:off x="1704628" y="3834595"/>
            <a:ext cx="236854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45" b="1">
                <a:latin typeface="Arial"/>
                <a:cs typeface="Arial"/>
              </a:rPr>
              <a:t>W</a:t>
            </a:r>
            <a:r>
              <a:rPr dirty="0" sz="1100" spc="-5" b="1">
                <a:latin typeface="Arial"/>
                <a:cs typeface="Arial"/>
              </a:rPr>
              <a:t>T</a:t>
            </a:r>
            <a:endParaRPr sz="1100">
              <a:latin typeface="Arial"/>
              <a:cs typeface="Arial"/>
            </a:endParaRPr>
          </a:p>
        </p:txBody>
      </p:sp>
      <p:sp>
        <p:nvSpPr>
          <p:cNvPr id="65" name="object 65"/>
          <p:cNvSpPr txBox="1"/>
          <p:nvPr/>
        </p:nvSpPr>
        <p:spPr>
          <a:xfrm>
            <a:off x="2698451" y="3834595"/>
            <a:ext cx="647065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20" b="1">
                <a:latin typeface="Arial"/>
                <a:cs typeface="Arial"/>
              </a:rPr>
              <a:t>CC</a:t>
            </a:r>
            <a:r>
              <a:rPr dirty="0" sz="1100" spc="-5" b="1">
                <a:latin typeface="Arial"/>
                <a:cs typeface="Arial"/>
              </a:rPr>
              <a:t>N2</a:t>
            </a:r>
            <a:r>
              <a:rPr dirty="0" sz="1100" spc="-15" b="1">
                <a:latin typeface="Arial"/>
                <a:cs typeface="Arial"/>
              </a:rPr>
              <a:t> </a:t>
            </a:r>
            <a:r>
              <a:rPr dirty="0" sz="1100" spc="-10" b="1">
                <a:latin typeface="Arial"/>
                <a:cs typeface="Arial"/>
              </a:rPr>
              <a:t>KO</a:t>
            </a:r>
            <a:endParaRPr sz="1100">
              <a:latin typeface="Arial"/>
              <a:cs typeface="Arial"/>
            </a:endParaRPr>
          </a:p>
        </p:txBody>
      </p:sp>
      <p:sp>
        <p:nvSpPr>
          <p:cNvPr id="66" name="object 66"/>
          <p:cNvSpPr/>
          <p:nvPr/>
        </p:nvSpPr>
        <p:spPr>
          <a:xfrm>
            <a:off x="2577064" y="3791132"/>
            <a:ext cx="1012825" cy="0"/>
          </a:xfrm>
          <a:custGeom>
            <a:avLst/>
            <a:gdLst/>
            <a:ahLst/>
            <a:cxnLst/>
            <a:rect l="l" t="t" r="r" b="b"/>
            <a:pathLst>
              <a:path w="1012825" h="0">
                <a:moveTo>
                  <a:pt x="0" y="0"/>
                </a:moveTo>
                <a:lnTo>
                  <a:pt x="1012240" y="0"/>
                </a:lnTo>
              </a:path>
            </a:pathLst>
          </a:custGeom>
          <a:ln w="18262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7" name="object 67"/>
          <p:cNvSpPr txBox="1"/>
          <p:nvPr/>
        </p:nvSpPr>
        <p:spPr>
          <a:xfrm>
            <a:off x="1741040" y="1530902"/>
            <a:ext cx="117475" cy="17716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1000" spc="-60">
                <a:latin typeface="Arial"/>
                <a:cs typeface="Arial"/>
              </a:rPr>
              <a:t>*</a:t>
            </a:r>
            <a:r>
              <a:rPr dirty="0" sz="1000" spc="-5">
                <a:latin typeface="Arial"/>
                <a:cs typeface="Arial"/>
              </a:rPr>
              <a:t>*</a:t>
            </a:r>
            <a:endParaRPr sz="1000">
              <a:latin typeface="Arial"/>
              <a:cs typeface="Arial"/>
            </a:endParaRPr>
          </a:p>
        </p:txBody>
      </p:sp>
      <p:grpSp>
        <p:nvGrpSpPr>
          <p:cNvPr id="68" name="object 68"/>
          <p:cNvGrpSpPr/>
          <p:nvPr/>
        </p:nvGrpSpPr>
        <p:grpSpPr>
          <a:xfrm>
            <a:off x="1475460" y="1687169"/>
            <a:ext cx="616585" cy="47625"/>
            <a:chOff x="1475460" y="1687169"/>
            <a:chExt cx="616585" cy="47625"/>
          </a:xfrm>
        </p:grpSpPr>
        <p:sp>
          <p:nvSpPr>
            <p:cNvPr id="69" name="object 69"/>
            <p:cNvSpPr/>
            <p:nvPr/>
          </p:nvSpPr>
          <p:spPr>
            <a:xfrm>
              <a:off x="1476413" y="1687702"/>
              <a:ext cx="614680" cy="45720"/>
            </a:xfrm>
            <a:custGeom>
              <a:avLst/>
              <a:gdLst/>
              <a:ahLst/>
              <a:cxnLst/>
              <a:rect l="l" t="t" r="r" b="b"/>
              <a:pathLst>
                <a:path w="614680" h="45719">
                  <a:moveTo>
                    <a:pt x="614349" y="3810"/>
                  </a:moveTo>
                  <a:lnTo>
                    <a:pt x="612775" y="3810"/>
                  </a:lnTo>
                  <a:lnTo>
                    <a:pt x="612775" y="0"/>
                  </a:lnTo>
                  <a:lnTo>
                    <a:pt x="1562" y="0"/>
                  </a:lnTo>
                  <a:lnTo>
                    <a:pt x="1562" y="3810"/>
                  </a:lnTo>
                  <a:lnTo>
                    <a:pt x="0" y="3810"/>
                  </a:lnTo>
                  <a:lnTo>
                    <a:pt x="0" y="5080"/>
                  </a:lnTo>
                  <a:lnTo>
                    <a:pt x="0" y="6350"/>
                  </a:lnTo>
                  <a:lnTo>
                    <a:pt x="0" y="10160"/>
                  </a:lnTo>
                  <a:lnTo>
                    <a:pt x="0" y="45720"/>
                  </a:lnTo>
                  <a:lnTo>
                    <a:pt x="9144" y="45720"/>
                  </a:lnTo>
                  <a:lnTo>
                    <a:pt x="9144" y="10160"/>
                  </a:lnTo>
                  <a:lnTo>
                    <a:pt x="9144" y="9550"/>
                  </a:lnTo>
                  <a:lnTo>
                    <a:pt x="605205" y="9550"/>
                  </a:lnTo>
                  <a:lnTo>
                    <a:pt x="605205" y="10160"/>
                  </a:lnTo>
                  <a:lnTo>
                    <a:pt x="605205" y="45720"/>
                  </a:lnTo>
                  <a:lnTo>
                    <a:pt x="614349" y="45720"/>
                  </a:lnTo>
                  <a:lnTo>
                    <a:pt x="614349" y="10160"/>
                  </a:lnTo>
                  <a:lnTo>
                    <a:pt x="612597" y="10160"/>
                  </a:lnTo>
                  <a:lnTo>
                    <a:pt x="612597" y="9550"/>
                  </a:lnTo>
                  <a:lnTo>
                    <a:pt x="614349" y="9550"/>
                  </a:lnTo>
                  <a:lnTo>
                    <a:pt x="614349" y="6515"/>
                  </a:lnTo>
                  <a:lnTo>
                    <a:pt x="612597" y="8267"/>
                  </a:lnTo>
                  <a:lnTo>
                    <a:pt x="612597" y="6350"/>
                  </a:lnTo>
                  <a:lnTo>
                    <a:pt x="614349" y="6350"/>
                  </a:lnTo>
                  <a:lnTo>
                    <a:pt x="614349" y="5080"/>
                  </a:lnTo>
                  <a:lnTo>
                    <a:pt x="614349" y="3810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70" name="object 70"/>
            <p:cNvSpPr/>
            <p:nvPr/>
          </p:nvSpPr>
          <p:spPr>
            <a:xfrm>
              <a:off x="1476413" y="1688122"/>
              <a:ext cx="614680" cy="45720"/>
            </a:xfrm>
            <a:custGeom>
              <a:avLst/>
              <a:gdLst/>
              <a:ahLst/>
              <a:cxnLst/>
              <a:rect l="l" t="t" r="r" b="b"/>
              <a:pathLst>
                <a:path w="614680" h="45719">
                  <a:moveTo>
                    <a:pt x="605205" y="4559"/>
                  </a:moveTo>
                  <a:lnTo>
                    <a:pt x="614349" y="4559"/>
                  </a:lnTo>
                  <a:lnTo>
                    <a:pt x="614349" y="45643"/>
                  </a:lnTo>
                  <a:lnTo>
                    <a:pt x="605205" y="45643"/>
                  </a:lnTo>
                  <a:lnTo>
                    <a:pt x="605205" y="4559"/>
                  </a:lnTo>
                  <a:close/>
                </a:path>
                <a:path w="614680" h="45719">
                  <a:moveTo>
                    <a:pt x="605205" y="45656"/>
                  </a:moveTo>
                  <a:lnTo>
                    <a:pt x="605205" y="4559"/>
                  </a:lnTo>
                  <a:lnTo>
                    <a:pt x="614349" y="4559"/>
                  </a:lnTo>
                  <a:lnTo>
                    <a:pt x="614349" y="45656"/>
                  </a:lnTo>
                  <a:lnTo>
                    <a:pt x="605205" y="45656"/>
                  </a:lnTo>
                  <a:close/>
                </a:path>
                <a:path w="614680" h="45719">
                  <a:moveTo>
                    <a:pt x="9143" y="45656"/>
                  </a:moveTo>
                  <a:lnTo>
                    <a:pt x="0" y="45656"/>
                  </a:lnTo>
                  <a:lnTo>
                    <a:pt x="0" y="4572"/>
                  </a:lnTo>
                  <a:lnTo>
                    <a:pt x="9143" y="4572"/>
                  </a:lnTo>
                  <a:lnTo>
                    <a:pt x="9143" y="45656"/>
                  </a:lnTo>
                  <a:close/>
                </a:path>
                <a:path w="614680" h="45719">
                  <a:moveTo>
                    <a:pt x="9143" y="4559"/>
                  </a:moveTo>
                  <a:lnTo>
                    <a:pt x="9143" y="45656"/>
                  </a:lnTo>
                  <a:lnTo>
                    <a:pt x="0" y="45656"/>
                  </a:lnTo>
                  <a:lnTo>
                    <a:pt x="0" y="4559"/>
                  </a:lnTo>
                  <a:lnTo>
                    <a:pt x="9143" y="4559"/>
                  </a:lnTo>
                  <a:close/>
                </a:path>
                <a:path w="614680" h="45719">
                  <a:moveTo>
                    <a:pt x="4571" y="0"/>
                  </a:moveTo>
                  <a:lnTo>
                    <a:pt x="609777" y="0"/>
                  </a:lnTo>
                  <a:lnTo>
                    <a:pt x="611301" y="0"/>
                  </a:lnTo>
                  <a:lnTo>
                    <a:pt x="612825" y="1524"/>
                  </a:lnTo>
                  <a:lnTo>
                    <a:pt x="614349" y="3048"/>
                  </a:lnTo>
                  <a:lnTo>
                    <a:pt x="614349" y="4559"/>
                  </a:lnTo>
                  <a:lnTo>
                    <a:pt x="614349" y="6096"/>
                  </a:lnTo>
                  <a:lnTo>
                    <a:pt x="612825" y="7607"/>
                  </a:lnTo>
                  <a:lnTo>
                    <a:pt x="611301" y="9131"/>
                  </a:lnTo>
                  <a:lnTo>
                    <a:pt x="609777" y="9131"/>
                  </a:lnTo>
                  <a:lnTo>
                    <a:pt x="4571" y="9131"/>
                  </a:lnTo>
                  <a:lnTo>
                    <a:pt x="3047" y="9131"/>
                  </a:lnTo>
                  <a:lnTo>
                    <a:pt x="1524" y="7607"/>
                  </a:lnTo>
                  <a:lnTo>
                    <a:pt x="0" y="6096"/>
                  </a:lnTo>
                  <a:lnTo>
                    <a:pt x="0" y="4559"/>
                  </a:lnTo>
                  <a:lnTo>
                    <a:pt x="0" y="3048"/>
                  </a:lnTo>
                  <a:lnTo>
                    <a:pt x="1524" y="1524"/>
                  </a:lnTo>
                  <a:lnTo>
                    <a:pt x="3047" y="0"/>
                  </a:lnTo>
                  <a:lnTo>
                    <a:pt x="4571" y="0"/>
                  </a:lnTo>
                  <a:close/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71" name="object 71"/>
          <p:cNvSpPr txBox="1"/>
          <p:nvPr/>
        </p:nvSpPr>
        <p:spPr>
          <a:xfrm>
            <a:off x="2997249" y="1533879"/>
            <a:ext cx="163830" cy="17716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1000" spc="-45">
                <a:latin typeface="Arial"/>
                <a:cs typeface="Arial"/>
              </a:rPr>
              <a:t>**</a:t>
            </a:r>
            <a:r>
              <a:rPr dirty="0" sz="1000" spc="-5">
                <a:latin typeface="Arial"/>
                <a:cs typeface="Arial"/>
              </a:rPr>
              <a:t>*</a:t>
            </a:r>
            <a:endParaRPr sz="1000">
              <a:latin typeface="Arial"/>
              <a:cs typeface="Arial"/>
            </a:endParaRPr>
          </a:p>
        </p:txBody>
      </p:sp>
      <p:grpSp>
        <p:nvGrpSpPr>
          <p:cNvPr id="72" name="object 72"/>
          <p:cNvGrpSpPr/>
          <p:nvPr/>
        </p:nvGrpSpPr>
        <p:grpSpPr>
          <a:xfrm>
            <a:off x="2768384" y="1690408"/>
            <a:ext cx="615950" cy="47625"/>
            <a:chOff x="2768384" y="1690408"/>
            <a:chExt cx="615950" cy="47625"/>
          </a:xfrm>
        </p:grpSpPr>
        <p:sp>
          <p:nvSpPr>
            <p:cNvPr id="73" name="object 73"/>
            <p:cNvSpPr/>
            <p:nvPr/>
          </p:nvSpPr>
          <p:spPr>
            <a:xfrm>
              <a:off x="2769146" y="1691512"/>
              <a:ext cx="614680" cy="45720"/>
            </a:xfrm>
            <a:custGeom>
              <a:avLst/>
              <a:gdLst/>
              <a:ahLst/>
              <a:cxnLst/>
              <a:rect l="l" t="t" r="r" b="b"/>
              <a:pathLst>
                <a:path w="614679" h="45719">
                  <a:moveTo>
                    <a:pt x="614349" y="2540"/>
                  </a:moveTo>
                  <a:lnTo>
                    <a:pt x="613740" y="2540"/>
                  </a:lnTo>
                  <a:lnTo>
                    <a:pt x="613740" y="6350"/>
                  </a:lnTo>
                  <a:lnTo>
                    <a:pt x="612470" y="7620"/>
                  </a:lnTo>
                  <a:lnTo>
                    <a:pt x="612470" y="6350"/>
                  </a:lnTo>
                  <a:lnTo>
                    <a:pt x="613740" y="6350"/>
                  </a:lnTo>
                  <a:lnTo>
                    <a:pt x="613740" y="2540"/>
                  </a:lnTo>
                  <a:lnTo>
                    <a:pt x="612902" y="2540"/>
                  </a:lnTo>
                  <a:lnTo>
                    <a:pt x="612902" y="0"/>
                  </a:lnTo>
                  <a:lnTo>
                    <a:pt x="605205" y="0"/>
                  </a:lnTo>
                  <a:lnTo>
                    <a:pt x="605205" y="3810"/>
                  </a:lnTo>
                  <a:lnTo>
                    <a:pt x="605205" y="4216"/>
                  </a:lnTo>
                  <a:lnTo>
                    <a:pt x="9144" y="4216"/>
                  </a:lnTo>
                  <a:lnTo>
                    <a:pt x="9144" y="3810"/>
                  </a:lnTo>
                  <a:lnTo>
                    <a:pt x="605205" y="3810"/>
                  </a:lnTo>
                  <a:lnTo>
                    <a:pt x="605205" y="0"/>
                  </a:lnTo>
                  <a:lnTo>
                    <a:pt x="1435" y="0"/>
                  </a:lnTo>
                  <a:lnTo>
                    <a:pt x="1435" y="2540"/>
                  </a:lnTo>
                  <a:lnTo>
                    <a:pt x="0" y="2540"/>
                  </a:lnTo>
                  <a:lnTo>
                    <a:pt x="0" y="3810"/>
                  </a:lnTo>
                  <a:lnTo>
                    <a:pt x="0" y="6350"/>
                  </a:lnTo>
                  <a:lnTo>
                    <a:pt x="0" y="8890"/>
                  </a:lnTo>
                  <a:lnTo>
                    <a:pt x="0" y="45720"/>
                  </a:lnTo>
                  <a:lnTo>
                    <a:pt x="9144" y="45720"/>
                  </a:lnTo>
                  <a:lnTo>
                    <a:pt x="9144" y="8890"/>
                  </a:lnTo>
                  <a:lnTo>
                    <a:pt x="605205" y="8788"/>
                  </a:lnTo>
                  <a:lnTo>
                    <a:pt x="605205" y="45720"/>
                  </a:lnTo>
                  <a:lnTo>
                    <a:pt x="614349" y="45720"/>
                  </a:lnTo>
                  <a:lnTo>
                    <a:pt x="614349" y="8890"/>
                  </a:lnTo>
                  <a:lnTo>
                    <a:pt x="612470" y="8890"/>
                  </a:lnTo>
                  <a:lnTo>
                    <a:pt x="614349" y="8788"/>
                  </a:lnTo>
                  <a:lnTo>
                    <a:pt x="614349" y="6350"/>
                  </a:lnTo>
                  <a:lnTo>
                    <a:pt x="614349" y="5740"/>
                  </a:lnTo>
                  <a:lnTo>
                    <a:pt x="614349" y="3810"/>
                  </a:lnTo>
                  <a:lnTo>
                    <a:pt x="614349" y="2540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74" name="object 74"/>
            <p:cNvSpPr/>
            <p:nvPr/>
          </p:nvSpPr>
          <p:spPr>
            <a:xfrm>
              <a:off x="2769146" y="1691170"/>
              <a:ext cx="614680" cy="45720"/>
            </a:xfrm>
            <a:custGeom>
              <a:avLst/>
              <a:gdLst/>
              <a:ahLst/>
              <a:cxnLst/>
              <a:rect l="l" t="t" r="r" b="b"/>
              <a:pathLst>
                <a:path w="614679" h="45719">
                  <a:moveTo>
                    <a:pt x="605205" y="4559"/>
                  </a:moveTo>
                  <a:lnTo>
                    <a:pt x="614349" y="4559"/>
                  </a:lnTo>
                  <a:lnTo>
                    <a:pt x="614349" y="45643"/>
                  </a:lnTo>
                  <a:lnTo>
                    <a:pt x="605205" y="45643"/>
                  </a:lnTo>
                  <a:lnTo>
                    <a:pt x="605205" y="4559"/>
                  </a:lnTo>
                  <a:close/>
                </a:path>
                <a:path w="614679" h="45719">
                  <a:moveTo>
                    <a:pt x="605205" y="45656"/>
                  </a:moveTo>
                  <a:lnTo>
                    <a:pt x="605205" y="4559"/>
                  </a:lnTo>
                  <a:lnTo>
                    <a:pt x="614349" y="4559"/>
                  </a:lnTo>
                  <a:lnTo>
                    <a:pt x="614349" y="45656"/>
                  </a:lnTo>
                  <a:lnTo>
                    <a:pt x="605205" y="45656"/>
                  </a:lnTo>
                  <a:close/>
                </a:path>
                <a:path w="614679" h="45719">
                  <a:moveTo>
                    <a:pt x="9143" y="45656"/>
                  </a:moveTo>
                  <a:lnTo>
                    <a:pt x="0" y="45656"/>
                  </a:lnTo>
                  <a:lnTo>
                    <a:pt x="0" y="4572"/>
                  </a:lnTo>
                  <a:lnTo>
                    <a:pt x="9143" y="4572"/>
                  </a:lnTo>
                  <a:lnTo>
                    <a:pt x="9143" y="45656"/>
                  </a:lnTo>
                  <a:close/>
                </a:path>
                <a:path w="614679" h="45719">
                  <a:moveTo>
                    <a:pt x="9143" y="4559"/>
                  </a:moveTo>
                  <a:lnTo>
                    <a:pt x="9143" y="45656"/>
                  </a:lnTo>
                  <a:lnTo>
                    <a:pt x="0" y="45656"/>
                  </a:lnTo>
                  <a:lnTo>
                    <a:pt x="0" y="4559"/>
                  </a:lnTo>
                  <a:lnTo>
                    <a:pt x="9143" y="4559"/>
                  </a:lnTo>
                  <a:close/>
                </a:path>
                <a:path w="614679" h="45719">
                  <a:moveTo>
                    <a:pt x="4571" y="0"/>
                  </a:moveTo>
                  <a:lnTo>
                    <a:pt x="609777" y="0"/>
                  </a:lnTo>
                  <a:lnTo>
                    <a:pt x="611301" y="0"/>
                  </a:lnTo>
                  <a:lnTo>
                    <a:pt x="612825" y="1511"/>
                  </a:lnTo>
                  <a:lnTo>
                    <a:pt x="614349" y="3048"/>
                  </a:lnTo>
                  <a:lnTo>
                    <a:pt x="614349" y="4559"/>
                  </a:lnTo>
                  <a:lnTo>
                    <a:pt x="614349" y="6083"/>
                  </a:lnTo>
                  <a:lnTo>
                    <a:pt x="612825" y="7607"/>
                  </a:lnTo>
                  <a:lnTo>
                    <a:pt x="611301" y="9131"/>
                  </a:lnTo>
                  <a:lnTo>
                    <a:pt x="609777" y="9131"/>
                  </a:lnTo>
                  <a:lnTo>
                    <a:pt x="4571" y="9131"/>
                  </a:lnTo>
                  <a:lnTo>
                    <a:pt x="3047" y="9131"/>
                  </a:lnTo>
                  <a:lnTo>
                    <a:pt x="1524" y="7607"/>
                  </a:lnTo>
                  <a:lnTo>
                    <a:pt x="0" y="6083"/>
                  </a:lnTo>
                  <a:lnTo>
                    <a:pt x="0" y="4559"/>
                  </a:lnTo>
                  <a:lnTo>
                    <a:pt x="0" y="3048"/>
                  </a:lnTo>
                  <a:lnTo>
                    <a:pt x="1524" y="1511"/>
                  </a:lnTo>
                  <a:lnTo>
                    <a:pt x="3047" y="0"/>
                  </a:lnTo>
                  <a:lnTo>
                    <a:pt x="4571" y="0"/>
                  </a:lnTo>
                  <a:close/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  <p:pic>
        <p:nvPicPr>
          <p:cNvPr id="75" name="object 75"/>
          <p:cNvPicPr/>
          <p:nvPr/>
        </p:nvPicPr>
        <p:blipFill>
          <a:blip r:embed="rId8" cstate="print"/>
          <a:stretch>
            <a:fillRect/>
          </a:stretch>
        </p:blipFill>
        <p:spPr>
          <a:xfrm>
            <a:off x="4346833" y="2682989"/>
            <a:ext cx="2697607" cy="773036"/>
          </a:xfrm>
          <a:prstGeom prst="rect">
            <a:avLst/>
          </a:prstGeom>
        </p:spPr>
      </p:pic>
      <p:sp>
        <p:nvSpPr>
          <p:cNvPr id="76" name="object 76"/>
          <p:cNvSpPr txBox="1"/>
          <p:nvPr/>
        </p:nvSpPr>
        <p:spPr>
          <a:xfrm>
            <a:off x="4552702" y="3491955"/>
            <a:ext cx="43053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20" b="1">
                <a:latin typeface="Arial"/>
                <a:cs typeface="Arial"/>
              </a:rPr>
              <a:t>SHA</a:t>
            </a:r>
            <a:r>
              <a:rPr dirty="0" sz="1100" spc="-10" b="1">
                <a:latin typeface="Arial"/>
                <a:cs typeface="Arial"/>
              </a:rPr>
              <a:t>M</a:t>
            </a:r>
            <a:endParaRPr sz="1100">
              <a:latin typeface="Arial"/>
              <a:cs typeface="Arial"/>
            </a:endParaRPr>
          </a:p>
        </p:txBody>
      </p:sp>
      <p:sp>
        <p:nvSpPr>
          <p:cNvPr id="77" name="object 77"/>
          <p:cNvSpPr txBox="1"/>
          <p:nvPr/>
        </p:nvSpPr>
        <p:spPr>
          <a:xfrm>
            <a:off x="5298569" y="3491955"/>
            <a:ext cx="2044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I</a:t>
            </a:r>
            <a:r>
              <a:rPr dirty="0" sz="1100" spc="5" b="1">
                <a:latin typeface="Arial"/>
                <a:cs typeface="Arial"/>
              </a:rPr>
              <a:t>R</a:t>
            </a:r>
            <a:r>
              <a:rPr dirty="0" sz="1100" spc="-5" b="1">
                <a:latin typeface="Arial"/>
                <a:cs typeface="Arial"/>
              </a:rPr>
              <a:t>I</a:t>
            </a:r>
            <a:endParaRPr sz="1100">
              <a:latin typeface="Arial"/>
              <a:cs typeface="Arial"/>
            </a:endParaRPr>
          </a:p>
        </p:txBody>
      </p:sp>
      <p:sp>
        <p:nvSpPr>
          <p:cNvPr id="78" name="object 78"/>
          <p:cNvSpPr txBox="1"/>
          <p:nvPr/>
        </p:nvSpPr>
        <p:spPr>
          <a:xfrm>
            <a:off x="5816133" y="3491955"/>
            <a:ext cx="43053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20" b="1">
                <a:latin typeface="Arial"/>
                <a:cs typeface="Arial"/>
              </a:rPr>
              <a:t>SHA</a:t>
            </a:r>
            <a:r>
              <a:rPr dirty="0" sz="1100" spc="-10" b="1">
                <a:latin typeface="Arial"/>
                <a:cs typeface="Arial"/>
              </a:rPr>
              <a:t>M</a:t>
            </a:r>
            <a:endParaRPr sz="1100">
              <a:latin typeface="Arial"/>
              <a:cs typeface="Arial"/>
            </a:endParaRPr>
          </a:p>
        </p:txBody>
      </p:sp>
      <p:sp>
        <p:nvSpPr>
          <p:cNvPr id="79" name="object 79"/>
          <p:cNvSpPr txBox="1"/>
          <p:nvPr/>
        </p:nvSpPr>
        <p:spPr>
          <a:xfrm>
            <a:off x="6562139" y="3491955"/>
            <a:ext cx="2044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I</a:t>
            </a:r>
            <a:r>
              <a:rPr dirty="0" sz="1100" spc="5" b="1">
                <a:latin typeface="Arial"/>
                <a:cs typeface="Arial"/>
              </a:rPr>
              <a:t>R</a:t>
            </a:r>
            <a:r>
              <a:rPr dirty="0" sz="1100" spc="-5" b="1">
                <a:latin typeface="Arial"/>
                <a:cs typeface="Arial"/>
              </a:rPr>
              <a:t>I</a:t>
            </a:r>
            <a:endParaRPr sz="1100">
              <a:latin typeface="Arial"/>
              <a:cs typeface="Arial"/>
            </a:endParaRPr>
          </a:p>
        </p:txBody>
      </p:sp>
      <p:grpSp>
        <p:nvGrpSpPr>
          <p:cNvPr id="80" name="object 80"/>
          <p:cNvGrpSpPr/>
          <p:nvPr/>
        </p:nvGrpSpPr>
        <p:grpSpPr>
          <a:xfrm>
            <a:off x="4292791" y="1607138"/>
            <a:ext cx="2804160" cy="1890395"/>
            <a:chOff x="4292791" y="1607138"/>
            <a:chExt cx="2804160" cy="1890395"/>
          </a:xfrm>
        </p:grpSpPr>
        <p:sp>
          <p:nvSpPr>
            <p:cNvPr id="81" name="object 81"/>
            <p:cNvSpPr/>
            <p:nvPr/>
          </p:nvSpPr>
          <p:spPr>
            <a:xfrm>
              <a:off x="4338463" y="3442328"/>
              <a:ext cx="2759075" cy="0"/>
            </a:xfrm>
            <a:custGeom>
              <a:avLst/>
              <a:gdLst/>
              <a:ahLst/>
              <a:cxnLst/>
              <a:rect l="l" t="t" r="r" b="b"/>
              <a:pathLst>
                <a:path w="2759075" h="0">
                  <a:moveTo>
                    <a:pt x="0" y="0"/>
                  </a:moveTo>
                  <a:lnTo>
                    <a:pt x="275849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82" name="object 82"/>
            <p:cNvSpPr/>
            <p:nvPr/>
          </p:nvSpPr>
          <p:spPr>
            <a:xfrm>
              <a:off x="4767759" y="3442335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w="0" h="55245">
                  <a:moveTo>
                    <a:pt x="0" y="54775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83" name="object 83"/>
            <p:cNvSpPr/>
            <p:nvPr/>
          </p:nvSpPr>
          <p:spPr>
            <a:xfrm>
              <a:off x="5399534" y="3442335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w="0" h="55245">
                  <a:moveTo>
                    <a:pt x="0" y="54775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84" name="object 84"/>
            <p:cNvSpPr/>
            <p:nvPr/>
          </p:nvSpPr>
          <p:spPr>
            <a:xfrm>
              <a:off x="6031308" y="3442335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w="0" h="55245">
                  <a:moveTo>
                    <a:pt x="0" y="54775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85" name="object 85"/>
            <p:cNvSpPr/>
            <p:nvPr/>
          </p:nvSpPr>
          <p:spPr>
            <a:xfrm>
              <a:off x="6663096" y="3442335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w="0" h="55245">
                  <a:moveTo>
                    <a:pt x="0" y="54775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86" name="object 86"/>
            <p:cNvSpPr/>
            <p:nvPr/>
          </p:nvSpPr>
          <p:spPr>
            <a:xfrm>
              <a:off x="4347592" y="1607138"/>
              <a:ext cx="0" cy="1844675"/>
            </a:xfrm>
            <a:custGeom>
              <a:avLst/>
              <a:gdLst/>
              <a:ahLst/>
              <a:cxnLst/>
              <a:rect l="l" t="t" r="r" b="b"/>
              <a:pathLst>
                <a:path w="0" h="1844675">
                  <a:moveTo>
                    <a:pt x="0" y="1844319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87" name="object 87"/>
            <p:cNvSpPr/>
            <p:nvPr/>
          </p:nvSpPr>
          <p:spPr>
            <a:xfrm>
              <a:off x="4292791" y="3077117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5" h="0">
                  <a:moveTo>
                    <a:pt x="54800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88" name="object 88"/>
            <p:cNvSpPr/>
            <p:nvPr/>
          </p:nvSpPr>
          <p:spPr>
            <a:xfrm>
              <a:off x="4292791" y="2711906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5" h="0">
                  <a:moveTo>
                    <a:pt x="54800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89" name="object 89"/>
            <p:cNvSpPr/>
            <p:nvPr/>
          </p:nvSpPr>
          <p:spPr>
            <a:xfrm>
              <a:off x="4292791" y="2346693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5" h="0">
                  <a:moveTo>
                    <a:pt x="54800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90" name="object 90"/>
            <p:cNvSpPr/>
            <p:nvPr/>
          </p:nvSpPr>
          <p:spPr>
            <a:xfrm>
              <a:off x="4292791" y="1981482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5" h="0">
                  <a:moveTo>
                    <a:pt x="54800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91" name="object 91"/>
            <p:cNvSpPr/>
            <p:nvPr/>
          </p:nvSpPr>
          <p:spPr>
            <a:xfrm>
              <a:off x="4292791" y="1616270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5" h="0">
                  <a:moveTo>
                    <a:pt x="54800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92" name="object 92"/>
            <p:cNvSpPr/>
            <p:nvPr/>
          </p:nvSpPr>
          <p:spPr>
            <a:xfrm>
              <a:off x="4292791" y="3442328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5" h="0">
                  <a:moveTo>
                    <a:pt x="54800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93" name="object 93"/>
            <p:cNvSpPr/>
            <p:nvPr/>
          </p:nvSpPr>
          <p:spPr>
            <a:xfrm>
              <a:off x="6663096" y="2489736"/>
              <a:ext cx="0" cy="193675"/>
            </a:xfrm>
            <a:custGeom>
              <a:avLst/>
              <a:gdLst/>
              <a:ahLst/>
              <a:cxnLst/>
              <a:rect l="l" t="t" r="r" b="b"/>
              <a:pathLst>
                <a:path w="0" h="193675">
                  <a:moveTo>
                    <a:pt x="0" y="0"/>
                  </a:moveTo>
                  <a:lnTo>
                    <a:pt x="0" y="193255"/>
                  </a:lnTo>
                </a:path>
              </a:pathLst>
            </a:custGeom>
            <a:ln w="9131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94" name="object 94"/>
            <p:cNvSpPr/>
            <p:nvPr/>
          </p:nvSpPr>
          <p:spPr>
            <a:xfrm>
              <a:off x="6663096" y="2682995"/>
              <a:ext cx="0" cy="191770"/>
            </a:xfrm>
            <a:custGeom>
              <a:avLst/>
              <a:gdLst/>
              <a:ahLst/>
              <a:cxnLst/>
              <a:rect l="l" t="t" r="r" b="b"/>
              <a:pathLst>
                <a:path w="0" h="191769">
                  <a:moveTo>
                    <a:pt x="0" y="0"/>
                  </a:moveTo>
                  <a:lnTo>
                    <a:pt x="0" y="191731"/>
                  </a:lnTo>
                </a:path>
              </a:pathLst>
            </a:custGeom>
            <a:ln w="9131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95" name="object 95"/>
            <p:cNvSpPr/>
            <p:nvPr/>
          </p:nvSpPr>
          <p:spPr>
            <a:xfrm>
              <a:off x="6558048" y="2489736"/>
              <a:ext cx="210185" cy="0"/>
            </a:xfrm>
            <a:custGeom>
              <a:avLst/>
              <a:gdLst/>
              <a:ahLst/>
              <a:cxnLst/>
              <a:rect l="l" t="t" r="r" b="b"/>
              <a:pathLst>
                <a:path w="210184" h="0">
                  <a:moveTo>
                    <a:pt x="0" y="0"/>
                  </a:moveTo>
                  <a:lnTo>
                    <a:pt x="210083" y="0"/>
                  </a:lnTo>
                </a:path>
              </a:pathLst>
            </a:custGeom>
            <a:ln w="9131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96" name="object 96"/>
            <p:cNvSpPr/>
            <p:nvPr/>
          </p:nvSpPr>
          <p:spPr>
            <a:xfrm>
              <a:off x="6558048" y="2874730"/>
              <a:ext cx="210185" cy="0"/>
            </a:xfrm>
            <a:custGeom>
              <a:avLst/>
              <a:gdLst/>
              <a:ahLst/>
              <a:cxnLst/>
              <a:rect l="l" t="t" r="r" b="b"/>
              <a:pathLst>
                <a:path w="210184" h="0">
                  <a:moveTo>
                    <a:pt x="0" y="0"/>
                  </a:moveTo>
                  <a:lnTo>
                    <a:pt x="210083" y="0"/>
                  </a:lnTo>
                </a:path>
              </a:pathLst>
            </a:custGeom>
            <a:ln w="9131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97" name="object 97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6625798" y="2286586"/>
              <a:ext cx="74587" cy="74561"/>
            </a:xfrm>
            <a:prstGeom prst="rect">
              <a:avLst/>
            </a:prstGeom>
          </p:spPr>
        </p:pic>
        <p:sp>
          <p:nvSpPr>
            <p:cNvPr id="98" name="object 98"/>
            <p:cNvSpPr/>
            <p:nvPr/>
          </p:nvSpPr>
          <p:spPr>
            <a:xfrm>
              <a:off x="6626560" y="2602343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59" h="73660">
                  <a:moveTo>
                    <a:pt x="73063" y="0"/>
                  </a:moveTo>
                  <a:lnTo>
                    <a:pt x="0" y="0"/>
                  </a:lnTo>
                  <a:lnTo>
                    <a:pt x="36537" y="73037"/>
                  </a:lnTo>
                  <a:lnTo>
                    <a:pt x="73063" y="0"/>
                  </a:lnTo>
                  <a:close/>
                </a:path>
              </a:pathLst>
            </a:custGeom>
            <a:solidFill>
              <a:srgbClr val="1349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9" name="object 99"/>
            <p:cNvSpPr/>
            <p:nvPr/>
          </p:nvSpPr>
          <p:spPr>
            <a:xfrm>
              <a:off x="6626560" y="2602343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59" h="73660">
                  <a:moveTo>
                    <a:pt x="0" y="0"/>
                  </a:moveTo>
                  <a:lnTo>
                    <a:pt x="73063" y="0"/>
                  </a:lnTo>
                  <a:lnTo>
                    <a:pt x="36537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00" name="object 100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6625798" y="2924185"/>
              <a:ext cx="74587" cy="74561"/>
            </a:xfrm>
            <a:prstGeom prst="rect">
              <a:avLst/>
            </a:prstGeom>
          </p:spPr>
        </p:pic>
        <p:sp>
          <p:nvSpPr>
            <p:cNvPr id="101" name="object 101"/>
            <p:cNvSpPr/>
            <p:nvPr/>
          </p:nvSpPr>
          <p:spPr>
            <a:xfrm>
              <a:off x="6626560" y="2678431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59" h="73660">
                  <a:moveTo>
                    <a:pt x="73063" y="0"/>
                  </a:moveTo>
                  <a:lnTo>
                    <a:pt x="0" y="0"/>
                  </a:lnTo>
                  <a:lnTo>
                    <a:pt x="36537" y="73037"/>
                  </a:lnTo>
                  <a:lnTo>
                    <a:pt x="73063" y="0"/>
                  </a:lnTo>
                  <a:close/>
                </a:path>
              </a:pathLst>
            </a:custGeom>
            <a:solidFill>
              <a:srgbClr val="1349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2" name="object 102"/>
            <p:cNvSpPr/>
            <p:nvPr/>
          </p:nvSpPr>
          <p:spPr>
            <a:xfrm>
              <a:off x="6626560" y="2678431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59" h="73660">
                  <a:moveTo>
                    <a:pt x="0" y="0"/>
                  </a:moveTo>
                  <a:lnTo>
                    <a:pt x="73063" y="0"/>
                  </a:lnTo>
                  <a:lnTo>
                    <a:pt x="36537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03" name="object 103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6625798" y="1726595"/>
              <a:ext cx="74587" cy="74561"/>
            </a:xfrm>
            <a:prstGeom prst="rect">
              <a:avLst/>
            </a:prstGeom>
          </p:spPr>
        </p:pic>
        <p:pic>
          <p:nvPicPr>
            <p:cNvPr id="104" name="object 104"/>
            <p:cNvPicPr/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6625798" y="3105272"/>
              <a:ext cx="74587" cy="162816"/>
            </a:xfrm>
            <a:prstGeom prst="rect">
              <a:avLst/>
            </a:prstGeom>
          </p:spPr>
        </p:pic>
        <p:pic>
          <p:nvPicPr>
            <p:cNvPr id="105" name="object 105"/>
            <p:cNvPicPr/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5926273" y="2678430"/>
              <a:ext cx="210083" cy="258691"/>
            </a:xfrm>
            <a:prstGeom prst="rect">
              <a:avLst/>
            </a:prstGeom>
          </p:spPr>
        </p:pic>
        <p:pic>
          <p:nvPicPr>
            <p:cNvPr id="106" name="object 106"/>
            <p:cNvPicPr/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5994021" y="2432673"/>
              <a:ext cx="74587" cy="74561"/>
            </a:xfrm>
            <a:prstGeom prst="rect">
              <a:avLst/>
            </a:prstGeom>
          </p:spPr>
        </p:pic>
        <p:pic>
          <p:nvPicPr>
            <p:cNvPr id="107" name="object 107"/>
            <p:cNvPicPr/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6067084" y="2998748"/>
              <a:ext cx="74599" cy="74561"/>
            </a:xfrm>
            <a:prstGeom prst="rect">
              <a:avLst/>
            </a:prstGeom>
          </p:spPr>
        </p:pic>
        <p:pic>
          <p:nvPicPr>
            <p:cNvPr id="108" name="object 108"/>
            <p:cNvPicPr/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5994021" y="2533101"/>
              <a:ext cx="74587" cy="74561"/>
            </a:xfrm>
            <a:prstGeom prst="rect">
              <a:avLst/>
            </a:prstGeom>
          </p:spPr>
        </p:pic>
        <p:pic>
          <p:nvPicPr>
            <p:cNvPr id="109" name="object 109"/>
            <p:cNvPicPr/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5920947" y="3062663"/>
              <a:ext cx="74599" cy="74561"/>
            </a:xfrm>
            <a:prstGeom prst="rect">
              <a:avLst/>
            </a:prstGeom>
          </p:spPr>
        </p:pic>
        <p:sp>
          <p:nvSpPr>
            <p:cNvPr id="110" name="object 110"/>
            <p:cNvSpPr/>
            <p:nvPr/>
          </p:nvSpPr>
          <p:spPr>
            <a:xfrm>
              <a:off x="5399534" y="2789513"/>
              <a:ext cx="0" cy="43180"/>
            </a:xfrm>
            <a:custGeom>
              <a:avLst/>
              <a:gdLst/>
              <a:ahLst/>
              <a:cxnLst/>
              <a:rect l="l" t="t" r="r" b="b"/>
              <a:pathLst>
                <a:path w="0" h="43180">
                  <a:moveTo>
                    <a:pt x="0" y="0"/>
                  </a:moveTo>
                  <a:lnTo>
                    <a:pt x="0" y="42608"/>
                  </a:lnTo>
                </a:path>
              </a:pathLst>
            </a:custGeom>
            <a:ln w="9131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11" name="object 111"/>
            <p:cNvSpPr/>
            <p:nvPr/>
          </p:nvSpPr>
          <p:spPr>
            <a:xfrm>
              <a:off x="5399534" y="2832121"/>
              <a:ext cx="0" cy="43180"/>
            </a:xfrm>
            <a:custGeom>
              <a:avLst/>
              <a:gdLst/>
              <a:ahLst/>
              <a:cxnLst/>
              <a:rect l="l" t="t" r="r" b="b"/>
              <a:pathLst>
                <a:path w="0" h="43180">
                  <a:moveTo>
                    <a:pt x="0" y="0"/>
                  </a:moveTo>
                  <a:lnTo>
                    <a:pt x="0" y="42608"/>
                  </a:lnTo>
                </a:path>
              </a:pathLst>
            </a:custGeom>
            <a:ln w="9131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12" name="object 112"/>
            <p:cNvSpPr/>
            <p:nvPr/>
          </p:nvSpPr>
          <p:spPr>
            <a:xfrm>
              <a:off x="5294497" y="2789513"/>
              <a:ext cx="210185" cy="0"/>
            </a:xfrm>
            <a:custGeom>
              <a:avLst/>
              <a:gdLst/>
              <a:ahLst/>
              <a:cxnLst/>
              <a:rect l="l" t="t" r="r" b="b"/>
              <a:pathLst>
                <a:path w="210185" h="0">
                  <a:moveTo>
                    <a:pt x="0" y="0"/>
                  </a:moveTo>
                  <a:lnTo>
                    <a:pt x="210083" y="0"/>
                  </a:lnTo>
                </a:path>
              </a:pathLst>
            </a:custGeom>
            <a:ln w="9131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13" name="object 113"/>
            <p:cNvSpPr/>
            <p:nvPr/>
          </p:nvSpPr>
          <p:spPr>
            <a:xfrm>
              <a:off x="5294497" y="2874730"/>
              <a:ext cx="210185" cy="0"/>
            </a:xfrm>
            <a:custGeom>
              <a:avLst/>
              <a:gdLst/>
              <a:ahLst/>
              <a:cxnLst/>
              <a:rect l="l" t="t" r="r" b="b"/>
              <a:pathLst>
                <a:path w="210185" h="0">
                  <a:moveTo>
                    <a:pt x="0" y="0"/>
                  </a:moveTo>
                  <a:lnTo>
                    <a:pt x="210083" y="0"/>
                  </a:lnTo>
                </a:path>
              </a:pathLst>
            </a:custGeom>
            <a:ln w="9131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14" name="object 114"/>
            <p:cNvSpPr/>
            <p:nvPr/>
          </p:nvSpPr>
          <p:spPr>
            <a:xfrm>
              <a:off x="5276227" y="2902127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75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075" y="73037"/>
                  </a:lnTo>
                  <a:lnTo>
                    <a:pt x="73075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5" name="object 115"/>
            <p:cNvSpPr/>
            <p:nvPr/>
          </p:nvSpPr>
          <p:spPr>
            <a:xfrm>
              <a:off x="5276227" y="2902115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075" y="0"/>
                  </a:lnTo>
                  <a:lnTo>
                    <a:pt x="73075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16" name="object 116"/>
            <p:cNvSpPr/>
            <p:nvPr/>
          </p:nvSpPr>
          <p:spPr>
            <a:xfrm>
              <a:off x="5449773" y="2891472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75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075" y="73037"/>
                  </a:lnTo>
                  <a:lnTo>
                    <a:pt x="73075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7" name="object 117"/>
            <p:cNvSpPr/>
            <p:nvPr/>
          </p:nvSpPr>
          <p:spPr>
            <a:xfrm>
              <a:off x="5449773" y="2891472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075" y="0"/>
                  </a:lnTo>
                  <a:lnTo>
                    <a:pt x="73075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18" name="object 118"/>
            <p:cNvSpPr/>
            <p:nvPr/>
          </p:nvSpPr>
          <p:spPr>
            <a:xfrm>
              <a:off x="5536552" y="2815387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75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075" y="73037"/>
                  </a:lnTo>
                  <a:lnTo>
                    <a:pt x="73075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9" name="object 119"/>
            <p:cNvSpPr/>
            <p:nvPr/>
          </p:nvSpPr>
          <p:spPr>
            <a:xfrm>
              <a:off x="5536552" y="2815387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075" y="0"/>
                  </a:lnTo>
                  <a:lnTo>
                    <a:pt x="73075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20" name="object 120"/>
            <p:cNvSpPr/>
            <p:nvPr/>
          </p:nvSpPr>
          <p:spPr>
            <a:xfrm>
              <a:off x="5363006" y="2617571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63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063" y="73037"/>
                  </a:lnTo>
                  <a:lnTo>
                    <a:pt x="73063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1" name="object 121"/>
            <p:cNvSpPr/>
            <p:nvPr/>
          </p:nvSpPr>
          <p:spPr>
            <a:xfrm>
              <a:off x="5363006" y="2617559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063" y="0"/>
                  </a:lnTo>
                  <a:lnTo>
                    <a:pt x="73063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22" name="object 122"/>
            <p:cNvSpPr/>
            <p:nvPr/>
          </p:nvSpPr>
          <p:spPr>
            <a:xfrm>
              <a:off x="5189448" y="2798648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75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075" y="73037"/>
                  </a:lnTo>
                  <a:lnTo>
                    <a:pt x="73075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3" name="object 123"/>
            <p:cNvSpPr/>
            <p:nvPr/>
          </p:nvSpPr>
          <p:spPr>
            <a:xfrm>
              <a:off x="5189448" y="2798635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075" y="0"/>
                  </a:lnTo>
                  <a:lnTo>
                    <a:pt x="73075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24" name="object 124"/>
            <p:cNvSpPr/>
            <p:nvPr/>
          </p:nvSpPr>
          <p:spPr>
            <a:xfrm>
              <a:off x="5363006" y="2751480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63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063" y="73037"/>
                  </a:lnTo>
                  <a:lnTo>
                    <a:pt x="73063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5" name="object 125"/>
            <p:cNvSpPr/>
            <p:nvPr/>
          </p:nvSpPr>
          <p:spPr>
            <a:xfrm>
              <a:off x="5363006" y="2751467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063" y="0"/>
                  </a:lnTo>
                  <a:lnTo>
                    <a:pt x="73063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26" name="object 126"/>
            <p:cNvSpPr/>
            <p:nvPr/>
          </p:nvSpPr>
          <p:spPr>
            <a:xfrm>
              <a:off x="4767759" y="2993427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w="0" h="79375">
                  <a:moveTo>
                    <a:pt x="0" y="0"/>
                  </a:moveTo>
                  <a:lnTo>
                    <a:pt x="0" y="79121"/>
                  </a:lnTo>
                </a:path>
              </a:pathLst>
            </a:custGeom>
            <a:ln w="9131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27" name="object 127"/>
            <p:cNvSpPr/>
            <p:nvPr/>
          </p:nvSpPr>
          <p:spPr>
            <a:xfrm>
              <a:off x="4767759" y="3072553"/>
              <a:ext cx="0" cy="81280"/>
            </a:xfrm>
            <a:custGeom>
              <a:avLst/>
              <a:gdLst/>
              <a:ahLst/>
              <a:cxnLst/>
              <a:rect l="l" t="t" r="r" b="b"/>
              <a:pathLst>
                <a:path w="0" h="81280">
                  <a:moveTo>
                    <a:pt x="0" y="0"/>
                  </a:moveTo>
                  <a:lnTo>
                    <a:pt x="0" y="80657"/>
                  </a:lnTo>
                </a:path>
              </a:pathLst>
            </a:custGeom>
            <a:ln w="9131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28" name="object 128"/>
            <p:cNvSpPr/>
            <p:nvPr/>
          </p:nvSpPr>
          <p:spPr>
            <a:xfrm>
              <a:off x="4662723" y="2993427"/>
              <a:ext cx="210185" cy="0"/>
            </a:xfrm>
            <a:custGeom>
              <a:avLst/>
              <a:gdLst/>
              <a:ahLst/>
              <a:cxnLst/>
              <a:rect l="l" t="t" r="r" b="b"/>
              <a:pathLst>
                <a:path w="210185" h="0">
                  <a:moveTo>
                    <a:pt x="0" y="0"/>
                  </a:moveTo>
                  <a:lnTo>
                    <a:pt x="210083" y="0"/>
                  </a:lnTo>
                </a:path>
              </a:pathLst>
            </a:custGeom>
            <a:ln w="9131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29" name="object 129"/>
            <p:cNvSpPr/>
            <p:nvPr/>
          </p:nvSpPr>
          <p:spPr>
            <a:xfrm>
              <a:off x="4662723" y="3153205"/>
              <a:ext cx="210185" cy="0"/>
            </a:xfrm>
            <a:custGeom>
              <a:avLst/>
              <a:gdLst/>
              <a:ahLst/>
              <a:cxnLst/>
              <a:rect l="l" t="t" r="r" b="b"/>
              <a:pathLst>
                <a:path w="210185" h="0">
                  <a:moveTo>
                    <a:pt x="0" y="0"/>
                  </a:moveTo>
                  <a:lnTo>
                    <a:pt x="210083" y="0"/>
                  </a:lnTo>
                </a:path>
              </a:pathLst>
            </a:custGeom>
            <a:ln w="9131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30" name="object 130"/>
            <p:cNvPicPr/>
            <p:nvPr/>
          </p:nvPicPr>
          <p:blipFill>
            <a:blip r:embed="rId15" cstate="print"/>
            <a:stretch>
              <a:fillRect/>
            </a:stretch>
          </p:blipFill>
          <p:spPr>
            <a:xfrm>
              <a:off x="4730470" y="2866358"/>
              <a:ext cx="74587" cy="74561"/>
            </a:xfrm>
            <a:prstGeom prst="rect">
              <a:avLst/>
            </a:prstGeom>
          </p:spPr>
        </p:pic>
        <p:pic>
          <p:nvPicPr>
            <p:cNvPr id="131" name="object 131"/>
            <p:cNvPicPr/>
            <p:nvPr/>
          </p:nvPicPr>
          <p:blipFill>
            <a:blip r:embed="rId16" cstate="print"/>
            <a:stretch>
              <a:fillRect/>
            </a:stretch>
          </p:blipFill>
          <p:spPr>
            <a:xfrm>
              <a:off x="4730470" y="2747674"/>
              <a:ext cx="74587" cy="74548"/>
            </a:xfrm>
            <a:prstGeom prst="rect">
              <a:avLst/>
            </a:prstGeom>
          </p:spPr>
        </p:pic>
        <p:sp>
          <p:nvSpPr>
            <p:cNvPr id="132" name="object 132"/>
            <p:cNvSpPr/>
            <p:nvPr/>
          </p:nvSpPr>
          <p:spPr>
            <a:xfrm>
              <a:off x="4731232" y="3014733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39573" y="0"/>
                  </a:moveTo>
                  <a:lnTo>
                    <a:pt x="33489" y="0"/>
                  </a:lnTo>
                  <a:lnTo>
                    <a:pt x="28917" y="1511"/>
                  </a:lnTo>
                  <a:lnTo>
                    <a:pt x="22834" y="3035"/>
                  </a:lnTo>
                  <a:lnTo>
                    <a:pt x="1511" y="28905"/>
                  </a:lnTo>
                  <a:lnTo>
                    <a:pt x="0" y="33477"/>
                  </a:lnTo>
                  <a:lnTo>
                    <a:pt x="0" y="39560"/>
                  </a:lnTo>
                  <a:lnTo>
                    <a:pt x="1511" y="44119"/>
                  </a:lnTo>
                  <a:lnTo>
                    <a:pt x="3035" y="50215"/>
                  </a:lnTo>
                  <a:lnTo>
                    <a:pt x="6095" y="56299"/>
                  </a:lnTo>
                  <a:lnTo>
                    <a:pt x="10655" y="62382"/>
                  </a:lnTo>
                  <a:lnTo>
                    <a:pt x="16738" y="66941"/>
                  </a:lnTo>
                  <a:lnTo>
                    <a:pt x="28917" y="73037"/>
                  </a:lnTo>
                  <a:lnTo>
                    <a:pt x="44145" y="73037"/>
                  </a:lnTo>
                  <a:lnTo>
                    <a:pt x="56324" y="66941"/>
                  </a:lnTo>
                  <a:lnTo>
                    <a:pt x="62407" y="62382"/>
                  </a:lnTo>
                  <a:lnTo>
                    <a:pt x="66979" y="56299"/>
                  </a:lnTo>
                  <a:lnTo>
                    <a:pt x="73063" y="44119"/>
                  </a:lnTo>
                  <a:lnTo>
                    <a:pt x="73063" y="36512"/>
                  </a:lnTo>
                  <a:lnTo>
                    <a:pt x="73063" y="28905"/>
                  </a:lnTo>
                  <a:lnTo>
                    <a:pt x="44145" y="1511"/>
                  </a:lnTo>
                  <a:lnTo>
                    <a:pt x="39573" y="0"/>
                  </a:lnTo>
                  <a:close/>
                </a:path>
              </a:pathLst>
            </a:custGeom>
            <a:solidFill>
              <a:srgbClr val="EE332E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3" name="object 133"/>
            <p:cNvSpPr/>
            <p:nvPr/>
          </p:nvSpPr>
          <p:spPr>
            <a:xfrm>
              <a:off x="4731232" y="3014733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63" y="36512"/>
                  </a:moveTo>
                  <a:lnTo>
                    <a:pt x="73063" y="44119"/>
                  </a:lnTo>
                  <a:lnTo>
                    <a:pt x="70027" y="50215"/>
                  </a:lnTo>
                  <a:lnTo>
                    <a:pt x="66979" y="56299"/>
                  </a:lnTo>
                  <a:lnTo>
                    <a:pt x="62407" y="62382"/>
                  </a:lnTo>
                  <a:lnTo>
                    <a:pt x="56324" y="66941"/>
                  </a:lnTo>
                  <a:lnTo>
                    <a:pt x="50228" y="69989"/>
                  </a:lnTo>
                  <a:lnTo>
                    <a:pt x="44145" y="73037"/>
                  </a:lnTo>
                  <a:lnTo>
                    <a:pt x="36525" y="73037"/>
                  </a:lnTo>
                  <a:lnTo>
                    <a:pt x="28917" y="73037"/>
                  </a:lnTo>
                  <a:lnTo>
                    <a:pt x="22834" y="69989"/>
                  </a:lnTo>
                  <a:lnTo>
                    <a:pt x="1511" y="44119"/>
                  </a:lnTo>
                  <a:lnTo>
                    <a:pt x="0" y="39560"/>
                  </a:lnTo>
                  <a:lnTo>
                    <a:pt x="0" y="36512"/>
                  </a:lnTo>
                  <a:lnTo>
                    <a:pt x="0" y="33477"/>
                  </a:lnTo>
                  <a:lnTo>
                    <a:pt x="1511" y="28905"/>
                  </a:lnTo>
                  <a:lnTo>
                    <a:pt x="28917" y="1511"/>
                  </a:lnTo>
                  <a:lnTo>
                    <a:pt x="33489" y="0"/>
                  </a:lnTo>
                  <a:lnTo>
                    <a:pt x="36525" y="0"/>
                  </a:lnTo>
                  <a:lnTo>
                    <a:pt x="39573" y="0"/>
                  </a:lnTo>
                  <a:lnTo>
                    <a:pt x="44145" y="1511"/>
                  </a:lnTo>
                  <a:lnTo>
                    <a:pt x="73063" y="28905"/>
                  </a:lnTo>
                  <a:lnTo>
                    <a:pt x="73063" y="36512"/>
                  </a:lnTo>
                </a:path>
              </a:pathLst>
            </a:custGeom>
            <a:ln w="3175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34" name="object 134"/>
            <p:cNvSpPr/>
            <p:nvPr/>
          </p:nvSpPr>
          <p:spPr>
            <a:xfrm>
              <a:off x="4731232" y="3176039"/>
              <a:ext cx="73660" cy="73025"/>
            </a:xfrm>
            <a:custGeom>
              <a:avLst/>
              <a:gdLst/>
              <a:ahLst/>
              <a:cxnLst/>
              <a:rect l="l" t="t" r="r" b="b"/>
              <a:pathLst>
                <a:path w="73660" h="73025">
                  <a:moveTo>
                    <a:pt x="39573" y="0"/>
                  </a:moveTo>
                  <a:lnTo>
                    <a:pt x="33489" y="0"/>
                  </a:lnTo>
                  <a:lnTo>
                    <a:pt x="28917" y="1511"/>
                  </a:lnTo>
                  <a:lnTo>
                    <a:pt x="22834" y="3035"/>
                  </a:lnTo>
                  <a:lnTo>
                    <a:pt x="1511" y="28905"/>
                  </a:lnTo>
                  <a:lnTo>
                    <a:pt x="0" y="33464"/>
                  </a:lnTo>
                  <a:lnTo>
                    <a:pt x="0" y="39560"/>
                  </a:lnTo>
                  <a:lnTo>
                    <a:pt x="1511" y="44119"/>
                  </a:lnTo>
                  <a:lnTo>
                    <a:pt x="3035" y="50215"/>
                  </a:lnTo>
                  <a:lnTo>
                    <a:pt x="6095" y="56299"/>
                  </a:lnTo>
                  <a:lnTo>
                    <a:pt x="10655" y="62382"/>
                  </a:lnTo>
                  <a:lnTo>
                    <a:pt x="16738" y="66941"/>
                  </a:lnTo>
                  <a:lnTo>
                    <a:pt x="28917" y="73025"/>
                  </a:lnTo>
                  <a:lnTo>
                    <a:pt x="44145" y="73025"/>
                  </a:lnTo>
                  <a:lnTo>
                    <a:pt x="56324" y="66941"/>
                  </a:lnTo>
                  <a:lnTo>
                    <a:pt x="62407" y="62382"/>
                  </a:lnTo>
                  <a:lnTo>
                    <a:pt x="66979" y="56299"/>
                  </a:lnTo>
                  <a:lnTo>
                    <a:pt x="73063" y="44119"/>
                  </a:lnTo>
                  <a:lnTo>
                    <a:pt x="73063" y="36512"/>
                  </a:lnTo>
                  <a:lnTo>
                    <a:pt x="73063" y="28905"/>
                  </a:lnTo>
                  <a:lnTo>
                    <a:pt x="44145" y="1511"/>
                  </a:lnTo>
                  <a:lnTo>
                    <a:pt x="39573" y="0"/>
                  </a:lnTo>
                  <a:close/>
                </a:path>
              </a:pathLst>
            </a:custGeom>
            <a:solidFill>
              <a:srgbClr val="EE332E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5" name="object 135"/>
            <p:cNvSpPr/>
            <p:nvPr/>
          </p:nvSpPr>
          <p:spPr>
            <a:xfrm>
              <a:off x="4731232" y="3176039"/>
              <a:ext cx="73660" cy="73025"/>
            </a:xfrm>
            <a:custGeom>
              <a:avLst/>
              <a:gdLst/>
              <a:ahLst/>
              <a:cxnLst/>
              <a:rect l="l" t="t" r="r" b="b"/>
              <a:pathLst>
                <a:path w="73660" h="73025">
                  <a:moveTo>
                    <a:pt x="73063" y="36512"/>
                  </a:moveTo>
                  <a:lnTo>
                    <a:pt x="73063" y="44119"/>
                  </a:lnTo>
                  <a:lnTo>
                    <a:pt x="70027" y="50215"/>
                  </a:lnTo>
                  <a:lnTo>
                    <a:pt x="44145" y="73025"/>
                  </a:lnTo>
                  <a:lnTo>
                    <a:pt x="36525" y="73025"/>
                  </a:lnTo>
                  <a:lnTo>
                    <a:pt x="28917" y="73025"/>
                  </a:lnTo>
                  <a:lnTo>
                    <a:pt x="1511" y="44119"/>
                  </a:lnTo>
                  <a:lnTo>
                    <a:pt x="0" y="39560"/>
                  </a:lnTo>
                  <a:lnTo>
                    <a:pt x="0" y="36512"/>
                  </a:lnTo>
                  <a:lnTo>
                    <a:pt x="0" y="33464"/>
                  </a:lnTo>
                  <a:lnTo>
                    <a:pt x="1511" y="28905"/>
                  </a:lnTo>
                  <a:lnTo>
                    <a:pt x="28917" y="1511"/>
                  </a:lnTo>
                  <a:lnTo>
                    <a:pt x="33489" y="0"/>
                  </a:lnTo>
                  <a:lnTo>
                    <a:pt x="36525" y="0"/>
                  </a:lnTo>
                  <a:lnTo>
                    <a:pt x="39573" y="0"/>
                  </a:lnTo>
                  <a:lnTo>
                    <a:pt x="44145" y="1511"/>
                  </a:lnTo>
                  <a:lnTo>
                    <a:pt x="73063" y="28905"/>
                  </a:lnTo>
                  <a:lnTo>
                    <a:pt x="73063" y="36512"/>
                  </a:lnTo>
                </a:path>
              </a:pathLst>
            </a:custGeom>
            <a:ln w="3175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36" name="object 136"/>
            <p:cNvPicPr/>
            <p:nvPr/>
          </p:nvPicPr>
          <p:blipFill>
            <a:blip r:embed="rId17" cstate="print"/>
            <a:stretch>
              <a:fillRect/>
            </a:stretch>
          </p:blipFill>
          <p:spPr>
            <a:xfrm>
              <a:off x="4904016" y="3188962"/>
              <a:ext cx="74599" cy="74561"/>
            </a:xfrm>
            <a:prstGeom prst="rect">
              <a:avLst/>
            </a:prstGeom>
          </p:spPr>
        </p:pic>
        <p:pic>
          <p:nvPicPr>
            <p:cNvPr id="137" name="object 137"/>
            <p:cNvPicPr/>
            <p:nvPr/>
          </p:nvPicPr>
          <p:blipFill>
            <a:blip r:embed="rId18" cstate="print"/>
            <a:stretch>
              <a:fillRect/>
            </a:stretch>
          </p:blipFill>
          <p:spPr>
            <a:xfrm>
              <a:off x="4556912" y="3223961"/>
              <a:ext cx="74599" cy="74561"/>
            </a:xfrm>
            <a:prstGeom prst="rect">
              <a:avLst/>
            </a:prstGeom>
          </p:spPr>
        </p:pic>
      </p:grpSp>
      <p:sp>
        <p:nvSpPr>
          <p:cNvPr id="138" name="object 138"/>
          <p:cNvSpPr txBox="1"/>
          <p:nvPr/>
        </p:nvSpPr>
        <p:spPr>
          <a:xfrm>
            <a:off x="4184203" y="3341341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0</a:t>
            </a:r>
            <a:endParaRPr sz="1100">
              <a:latin typeface="Arial"/>
              <a:cs typeface="Arial"/>
            </a:endParaRPr>
          </a:p>
        </p:txBody>
      </p:sp>
      <p:sp>
        <p:nvSpPr>
          <p:cNvPr id="139" name="object 139"/>
          <p:cNvSpPr txBox="1"/>
          <p:nvPr/>
        </p:nvSpPr>
        <p:spPr>
          <a:xfrm>
            <a:off x="4184203" y="2976041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1</a:t>
            </a:r>
            <a:endParaRPr sz="1100">
              <a:latin typeface="Arial"/>
              <a:cs typeface="Arial"/>
            </a:endParaRPr>
          </a:p>
        </p:txBody>
      </p:sp>
      <p:sp>
        <p:nvSpPr>
          <p:cNvPr id="140" name="object 140"/>
          <p:cNvSpPr txBox="1"/>
          <p:nvPr/>
        </p:nvSpPr>
        <p:spPr>
          <a:xfrm>
            <a:off x="4184203" y="2610881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2</a:t>
            </a:r>
            <a:endParaRPr sz="1100">
              <a:latin typeface="Arial"/>
              <a:cs typeface="Arial"/>
            </a:endParaRPr>
          </a:p>
        </p:txBody>
      </p:sp>
      <p:sp>
        <p:nvSpPr>
          <p:cNvPr id="141" name="object 141"/>
          <p:cNvSpPr txBox="1"/>
          <p:nvPr/>
        </p:nvSpPr>
        <p:spPr>
          <a:xfrm>
            <a:off x="4184203" y="2245721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3</a:t>
            </a:r>
            <a:endParaRPr sz="1100">
              <a:latin typeface="Arial"/>
              <a:cs typeface="Arial"/>
            </a:endParaRPr>
          </a:p>
        </p:txBody>
      </p:sp>
      <p:sp>
        <p:nvSpPr>
          <p:cNvPr id="142" name="object 142"/>
          <p:cNvSpPr txBox="1"/>
          <p:nvPr/>
        </p:nvSpPr>
        <p:spPr>
          <a:xfrm>
            <a:off x="4184203" y="1880560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4</a:t>
            </a:r>
            <a:endParaRPr sz="1100">
              <a:latin typeface="Arial"/>
              <a:cs typeface="Arial"/>
            </a:endParaRPr>
          </a:p>
        </p:txBody>
      </p:sp>
      <p:sp>
        <p:nvSpPr>
          <p:cNvPr id="143" name="object 143"/>
          <p:cNvSpPr txBox="1"/>
          <p:nvPr/>
        </p:nvSpPr>
        <p:spPr>
          <a:xfrm>
            <a:off x="4184203" y="1515400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5</a:t>
            </a:r>
            <a:endParaRPr sz="1100">
              <a:latin typeface="Arial"/>
              <a:cs typeface="Arial"/>
            </a:endParaRPr>
          </a:p>
        </p:txBody>
      </p:sp>
      <p:sp>
        <p:nvSpPr>
          <p:cNvPr id="144" name="object 144"/>
          <p:cNvSpPr txBox="1"/>
          <p:nvPr/>
        </p:nvSpPr>
        <p:spPr>
          <a:xfrm>
            <a:off x="3955107" y="1561904"/>
            <a:ext cx="195580" cy="1934210"/>
          </a:xfrm>
          <a:prstGeom prst="rect">
            <a:avLst/>
          </a:prstGeom>
        </p:spPr>
        <p:txBody>
          <a:bodyPr wrap="square" lIns="0" tIns="0" rIns="0" bIns="0" rtlCol="0" vert="vert270">
            <a:spAutoFit/>
          </a:bodyPr>
          <a:lstStyle/>
          <a:p>
            <a:pPr marL="12700">
              <a:lnSpc>
                <a:spcPts val="1425"/>
              </a:lnSpc>
            </a:pPr>
            <a:r>
              <a:rPr dirty="0" sz="1200" spc="-15" b="1">
                <a:latin typeface="Arial"/>
                <a:cs typeface="Arial"/>
              </a:rPr>
              <a:t>mRNA</a:t>
            </a:r>
            <a:r>
              <a:rPr dirty="0" sz="1200" spc="-45" b="1">
                <a:latin typeface="Arial"/>
                <a:cs typeface="Arial"/>
              </a:rPr>
              <a:t> </a:t>
            </a:r>
            <a:r>
              <a:rPr dirty="0" sz="1200" spc="-15" b="1">
                <a:latin typeface="Arial"/>
                <a:cs typeface="Arial"/>
              </a:rPr>
              <a:t>NQO1</a:t>
            </a:r>
            <a:r>
              <a:rPr dirty="0" sz="1200" spc="-30" b="1">
                <a:latin typeface="Arial"/>
                <a:cs typeface="Arial"/>
              </a:rPr>
              <a:t> </a:t>
            </a:r>
            <a:r>
              <a:rPr dirty="0" sz="1200" spc="-10" b="1">
                <a:latin typeface="Arial"/>
                <a:cs typeface="Arial"/>
              </a:rPr>
              <a:t>(fold</a:t>
            </a:r>
            <a:r>
              <a:rPr dirty="0" sz="1200" spc="-30" b="1">
                <a:latin typeface="Arial"/>
                <a:cs typeface="Arial"/>
              </a:rPr>
              <a:t> </a:t>
            </a:r>
            <a:r>
              <a:rPr dirty="0" sz="1200" spc="-15" b="1">
                <a:latin typeface="Arial"/>
                <a:cs typeface="Arial"/>
              </a:rPr>
              <a:t>change)</a:t>
            </a:r>
            <a:endParaRPr sz="1200">
              <a:latin typeface="Arial"/>
              <a:cs typeface="Arial"/>
            </a:endParaRPr>
          </a:p>
        </p:txBody>
      </p:sp>
      <p:sp>
        <p:nvSpPr>
          <p:cNvPr id="145" name="object 145"/>
          <p:cNvSpPr/>
          <p:nvPr/>
        </p:nvSpPr>
        <p:spPr>
          <a:xfrm>
            <a:off x="4595737" y="3764932"/>
            <a:ext cx="1010919" cy="0"/>
          </a:xfrm>
          <a:custGeom>
            <a:avLst/>
            <a:gdLst/>
            <a:ahLst/>
            <a:cxnLst/>
            <a:rect l="l" t="t" r="r" b="b"/>
            <a:pathLst>
              <a:path w="1010920" h="0">
                <a:moveTo>
                  <a:pt x="0" y="0"/>
                </a:moveTo>
                <a:lnTo>
                  <a:pt x="1010843" y="0"/>
                </a:lnTo>
              </a:path>
            </a:pathLst>
          </a:custGeom>
          <a:ln w="18262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6" name="object 146"/>
          <p:cNvSpPr txBox="1"/>
          <p:nvPr/>
        </p:nvSpPr>
        <p:spPr>
          <a:xfrm>
            <a:off x="4997202" y="3811440"/>
            <a:ext cx="236854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45" b="1">
                <a:latin typeface="Arial"/>
                <a:cs typeface="Arial"/>
              </a:rPr>
              <a:t>W</a:t>
            </a:r>
            <a:r>
              <a:rPr dirty="0" sz="1100" spc="-10" b="1">
                <a:latin typeface="Arial"/>
                <a:cs typeface="Arial"/>
              </a:rPr>
              <a:t>T</a:t>
            </a:r>
            <a:endParaRPr sz="1100">
              <a:latin typeface="Arial"/>
              <a:cs typeface="Arial"/>
            </a:endParaRPr>
          </a:p>
        </p:txBody>
      </p:sp>
      <p:sp>
        <p:nvSpPr>
          <p:cNvPr id="147" name="object 147"/>
          <p:cNvSpPr txBox="1"/>
          <p:nvPr/>
        </p:nvSpPr>
        <p:spPr>
          <a:xfrm>
            <a:off x="5989799" y="3811440"/>
            <a:ext cx="64643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20" b="1">
                <a:latin typeface="Arial"/>
                <a:cs typeface="Arial"/>
              </a:rPr>
              <a:t>CC</a:t>
            </a:r>
            <a:r>
              <a:rPr dirty="0" sz="1100" spc="-10" b="1">
                <a:latin typeface="Arial"/>
                <a:cs typeface="Arial"/>
              </a:rPr>
              <a:t>N2</a:t>
            </a:r>
            <a:r>
              <a:rPr dirty="0" sz="1100" spc="-15" b="1">
                <a:latin typeface="Arial"/>
                <a:cs typeface="Arial"/>
              </a:rPr>
              <a:t> </a:t>
            </a:r>
            <a:r>
              <a:rPr dirty="0" sz="1100" spc="-10" b="1">
                <a:latin typeface="Arial"/>
                <a:cs typeface="Arial"/>
              </a:rPr>
              <a:t>KO</a:t>
            </a:r>
            <a:endParaRPr sz="1100">
              <a:latin typeface="Arial"/>
              <a:cs typeface="Arial"/>
            </a:endParaRPr>
          </a:p>
        </p:txBody>
      </p:sp>
      <p:sp>
        <p:nvSpPr>
          <p:cNvPr id="148" name="object 148"/>
          <p:cNvSpPr/>
          <p:nvPr/>
        </p:nvSpPr>
        <p:spPr>
          <a:xfrm>
            <a:off x="5868429" y="3767976"/>
            <a:ext cx="1010919" cy="0"/>
          </a:xfrm>
          <a:custGeom>
            <a:avLst/>
            <a:gdLst/>
            <a:ahLst/>
            <a:cxnLst/>
            <a:rect l="l" t="t" r="r" b="b"/>
            <a:pathLst>
              <a:path w="1010920" h="0">
                <a:moveTo>
                  <a:pt x="0" y="0"/>
                </a:moveTo>
                <a:lnTo>
                  <a:pt x="1010843" y="0"/>
                </a:lnTo>
              </a:path>
            </a:pathLst>
          </a:custGeom>
          <a:ln w="18262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pic>
        <p:nvPicPr>
          <p:cNvPr id="149" name="object 149"/>
          <p:cNvPicPr/>
          <p:nvPr/>
        </p:nvPicPr>
        <p:blipFill>
          <a:blip r:embed="rId19" cstate="print"/>
          <a:stretch>
            <a:fillRect/>
          </a:stretch>
        </p:blipFill>
        <p:spPr>
          <a:xfrm>
            <a:off x="901976" y="5518225"/>
            <a:ext cx="2697607" cy="960208"/>
          </a:xfrm>
          <a:prstGeom prst="rect">
            <a:avLst/>
          </a:prstGeom>
        </p:spPr>
      </p:pic>
      <p:sp>
        <p:nvSpPr>
          <p:cNvPr id="150" name="object 150"/>
          <p:cNvSpPr txBox="1"/>
          <p:nvPr/>
        </p:nvSpPr>
        <p:spPr>
          <a:xfrm>
            <a:off x="1107845" y="6514369"/>
            <a:ext cx="43053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20" b="1">
                <a:latin typeface="Arial"/>
                <a:cs typeface="Arial"/>
              </a:rPr>
              <a:t>SHA</a:t>
            </a:r>
            <a:r>
              <a:rPr dirty="0" sz="1100" spc="-10" b="1">
                <a:latin typeface="Arial"/>
                <a:cs typeface="Arial"/>
              </a:rPr>
              <a:t>M</a:t>
            </a:r>
            <a:endParaRPr sz="1100">
              <a:latin typeface="Arial"/>
              <a:cs typeface="Arial"/>
            </a:endParaRPr>
          </a:p>
        </p:txBody>
      </p:sp>
      <p:sp>
        <p:nvSpPr>
          <p:cNvPr id="151" name="object 151"/>
          <p:cNvSpPr txBox="1"/>
          <p:nvPr/>
        </p:nvSpPr>
        <p:spPr>
          <a:xfrm>
            <a:off x="1853713" y="6514369"/>
            <a:ext cx="2044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I</a:t>
            </a:r>
            <a:r>
              <a:rPr dirty="0" sz="1100" spc="5" b="1">
                <a:latin typeface="Arial"/>
                <a:cs typeface="Arial"/>
              </a:rPr>
              <a:t>R</a:t>
            </a:r>
            <a:r>
              <a:rPr dirty="0" sz="1100" spc="-5" b="1">
                <a:latin typeface="Arial"/>
                <a:cs typeface="Arial"/>
              </a:rPr>
              <a:t>I</a:t>
            </a:r>
            <a:endParaRPr sz="1100">
              <a:latin typeface="Arial"/>
              <a:cs typeface="Arial"/>
            </a:endParaRPr>
          </a:p>
        </p:txBody>
      </p:sp>
      <p:sp>
        <p:nvSpPr>
          <p:cNvPr id="152" name="object 152"/>
          <p:cNvSpPr txBox="1"/>
          <p:nvPr/>
        </p:nvSpPr>
        <p:spPr>
          <a:xfrm>
            <a:off x="2371276" y="6514369"/>
            <a:ext cx="43053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20" b="1">
                <a:latin typeface="Arial"/>
                <a:cs typeface="Arial"/>
              </a:rPr>
              <a:t>SHA</a:t>
            </a:r>
            <a:r>
              <a:rPr dirty="0" sz="1100" spc="-10" b="1">
                <a:latin typeface="Arial"/>
                <a:cs typeface="Arial"/>
              </a:rPr>
              <a:t>M</a:t>
            </a:r>
            <a:endParaRPr sz="1100">
              <a:latin typeface="Arial"/>
              <a:cs typeface="Arial"/>
            </a:endParaRPr>
          </a:p>
        </p:txBody>
      </p:sp>
      <p:sp>
        <p:nvSpPr>
          <p:cNvPr id="153" name="object 153"/>
          <p:cNvSpPr txBox="1"/>
          <p:nvPr/>
        </p:nvSpPr>
        <p:spPr>
          <a:xfrm>
            <a:off x="3117282" y="6514369"/>
            <a:ext cx="2044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I</a:t>
            </a:r>
            <a:r>
              <a:rPr dirty="0" sz="1100" spc="5" b="1">
                <a:latin typeface="Arial"/>
                <a:cs typeface="Arial"/>
              </a:rPr>
              <a:t>R</a:t>
            </a:r>
            <a:r>
              <a:rPr dirty="0" sz="1100" spc="-5" b="1">
                <a:latin typeface="Arial"/>
                <a:cs typeface="Arial"/>
              </a:rPr>
              <a:t>I</a:t>
            </a:r>
            <a:endParaRPr sz="1100">
              <a:latin typeface="Arial"/>
              <a:cs typeface="Arial"/>
            </a:endParaRPr>
          </a:p>
        </p:txBody>
      </p:sp>
      <p:grpSp>
        <p:nvGrpSpPr>
          <p:cNvPr id="154" name="object 154"/>
          <p:cNvGrpSpPr/>
          <p:nvPr/>
        </p:nvGrpSpPr>
        <p:grpSpPr>
          <a:xfrm>
            <a:off x="838727" y="4620338"/>
            <a:ext cx="2823210" cy="1908810"/>
            <a:chOff x="838727" y="4620338"/>
            <a:chExt cx="2823210" cy="1908810"/>
          </a:xfrm>
        </p:grpSpPr>
        <p:sp>
          <p:nvSpPr>
            <p:cNvPr id="155" name="object 155"/>
            <p:cNvSpPr/>
            <p:nvPr/>
          </p:nvSpPr>
          <p:spPr>
            <a:xfrm>
              <a:off x="893607" y="6464736"/>
              <a:ext cx="2759075" cy="0"/>
            </a:xfrm>
            <a:custGeom>
              <a:avLst/>
              <a:gdLst/>
              <a:ahLst/>
              <a:cxnLst/>
              <a:rect l="l" t="t" r="r" b="b"/>
              <a:pathLst>
                <a:path w="2759075" h="0">
                  <a:moveTo>
                    <a:pt x="0" y="0"/>
                  </a:moveTo>
                  <a:lnTo>
                    <a:pt x="2758503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56" name="object 156"/>
            <p:cNvSpPr/>
            <p:nvPr/>
          </p:nvSpPr>
          <p:spPr>
            <a:xfrm>
              <a:off x="1322908" y="6464743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w="0" h="55245">
                  <a:moveTo>
                    <a:pt x="0" y="54775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57" name="object 157"/>
            <p:cNvSpPr/>
            <p:nvPr/>
          </p:nvSpPr>
          <p:spPr>
            <a:xfrm>
              <a:off x="1954683" y="6464743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w="0" h="55245">
                  <a:moveTo>
                    <a:pt x="0" y="54775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58" name="object 158"/>
            <p:cNvSpPr/>
            <p:nvPr/>
          </p:nvSpPr>
          <p:spPr>
            <a:xfrm>
              <a:off x="2586459" y="6464743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w="0" h="55245">
                  <a:moveTo>
                    <a:pt x="0" y="54775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59" name="object 159"/>
            <p:cNvSpPr/>
            <p:nvPr/>
          </p:nvSpPr>
          <p:spPr>
            <a:xfrm>
              <a:off x="3218234" y="6464743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w="0" h="55245">
                  <a:moveTo>
                    <a:pt x="0" y="54775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60" name="object 160"/>
            <p:cNvSpPr/>
            <p:nvPr/>
          </p:nvSpPr>
          <p:spPr>
            <a:xfrm>
              <a:off x="902735" y="4629546"/>
              <a:ext cx="0" cy="1844675"/>
            </a:xfrm>
            <a:custGeom>
              <a:avLst/>
              <a:gdLst/>
              <a:ahLst/>
              <a:cxnLst/>
              <a:rect l="l" t="t" r="r" b="b"/>
              <a:pathLst>
                <a:path w="0" h="1844675">
                  <a:moveTo>
                    <a:pt x="0" y="1844319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61" name="object 161"/>
            <p:cNvSpPr/>
            <p:nvPr/>
          </p:nvSpPr>
          <p:spPr>
            <a:xfrm>
              <a:off x="847934" y="6099525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4" h="0">
                  <a:moveTo>
                    <a:pt x="54800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62" name="object 162"/>
            <p:cNvSpPr/>
            <p:nvPr/>
          </p:nvSpPr>
          <p:spPr>
            <a:xfrm>
              <a:off x="847934" y="5734313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4" h="0">
                  <a:moveTo>
                    <a:pt x="54800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63" name="object 163"/>
            <p:cNvSpPr/>
            <p:nvPr/>
          </p:nvSpPr>
          <p:spPr>
            <a:xfrm>
              <a:off x="847934" y="5369101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4" h="0">
                  <a:moveTo>
                    <a:pt x="54800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64" name="object 164"/>
            <p:cNvSpPr/>
            <p:nvPr/>
          </p:nvSpPr>
          <p:spPr>
            <a:xfrm>
              <a:off x="847934" y="5003890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4" h="0">
                  <a:moveTo>
                    <a:pt x="54800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65" name="object 165"/>
            <p:cNvSpPr/>
            <p:nvPr/>
          </p:nvSpPr>
          <p:spPr>
            <a:xfrm>
              <a:off x="847934" y="4638677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4" h="0">
                  <a:moveTo>
                    <a:pt x="54800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66" name="object 166"/>
            <p:cNvSpPr/>
            <p:nvPr/>
          </p:nvSpPr>
          <p:spPr>
            <a:xfrm>
              <a:off x="847934" y="6464736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4" h="0">
                  <a:moveTo>
                    <a:pt x="54800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67" name="object 167"/>
            <p:cNvSpPr/>
            <p:nvPr/>
          </p:nvSpPr>
          <p:spPr>
            <a:xfrm>
              <a:off x="3218234" y="5422357"/>
              <a:ext cx="0" cy="95885"/>
            </a:xfrm>
            <a:custGeom>
              <a:avLst/>
              <a:gdLst/>
              <a:ahLst/>
              <a:cxnLst/>
              <a:rect l="l" t="t" r="r" b="b"/>
              <a:pathLst>
                <a:path w="0" h="95885">
                  <a:moveTo>
                    <a:pt x="0" y="0"/>
                  </a:moveTo>
                  <a:lnTo>
                    <a:pt x="0" y="95872"/>
                  </a:lnTo>
                </a:path>
              </a:pathLst>
            </a:custGeom>
            <a:ln w="9131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68" name="object 168"/>
            <p:cNvSpPr/>
            <p:nvPr/>
          </p:nvSpPr>
          <p:spPr>
            <a:xfrm>
              <a:off x="3218234" y="5518227"/>
              <a:ext cx="0" cy="94615"/>
            </a:xfrm>
            <a:custGeom>
              <a:avLst/>
              <a:gdLst/>
              <a:ahLst/>
              <a:cxnLst/>
              <a:rect l="l" t="t" r="r" b="b"/>
              <a:pathLst>
                <a:path w="0" h="94614">
                  <a:moveTo>
                    <a:pt x="0" y="0"/>
                  </a:moveTo>
                  <a:lnTo>
                    <a:pt x="0" y="94348"/>
                  </a:lnTo>
                </a:path>
              </a:pathLst>
            </a:custGeom>
            <a:ln w="9131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69" name="object 169"/>
            <p:cNvSpPr/>
            <p:nvPr/>
          </p:nvSpPr>
          <p:spPr>
            <a:xfrm>
              <a:off x="3113192" y="5422357"/>
              <a:ext cx="210185" cy="0"/>
            </a:xfrm>
            <a:custGeom>
              <a:avLst/>
              <a:gdLst/>
              <a:ahLst/>
              <a:cxnLst/>
              <a:rect l="l" t="t" r="r" b="b"/>
              <a:pathLst>
                <a:path w="210185" h="0">
                  <a:moveTo>
                    <a:pt x="0" y="0"/>
                  </a:moveTo>
                  <a:lnTo>
                    <a:pt x="210083" y="0"/>
                  </a:lnTo>
                </a:path>
              </a:pathLst>
            </a:custGeom>
            <a:ln w="9131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70" name="object 170"/>
            <p:cNvSpPr/>
            <p:nvPr/>
          </p:nvSpPr>
          <p:spPr>
            <a:xfrm>
              <a:off x="3113192" y="5612572"/>
              <a:ext cx="210185" cy="0"/>
            </a:xfrm>
            <a:custGeom>
              <a:avLst/>
              <a:gdLst/>
              <a:ahLst/>
              <a:cxnLst/>
              <a:rect l="l" t="t" r="r" b="b"/>
              <a:pathLst>
                <a:path w="210185" h="0">
                  <a:moveTo>
                    <a:pt x="0" y="0"/>
                  </a:moveTo>
                  <a:lnTo>
                    <a:pt x="210083" y="0"/>
                  </a:lnTo>
                </a:path>
              </a:pathLst>
            </a:custGeom>
            <a:ln w="9131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71" name="object 171"/>
            <p:cNvSpPr/>
            <p:nvPr/>
          </p:nvSpPr>
          <p:spPr>
            <a:xfrm>
              <a:off x="3108622" y="5455844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75" y="0"/>
                  </a:moveTo>
                  <a:lnTo>
                    <a:pt x="0" y="0"/>
                  </a:lnTo>
                  <a:lnTo>
                    <a:pt x="36537" y="73037"/>
                  </a:lnTo>
                  <a:lnTo>
                    <a:pt x="73075" y="0"/>
                  </a:lnTo>
                  <a:close/>
                </a:path>
              </a:pathLst>
            </a:custGeom>
            <a:solidFill>
              <a:srgbClr val="1349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72" name="object 172"/>
            <p:cNvSpPr/>
            <p:nvPr/>
          </p:nvSpPr>
          <p:spPr>
            <a:xfrm>
              <a:off x="3108622" y="5455844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075" y="0"/>
                  </a:lnTo>
                  <a:lnTo>
                    <a:pt x="36537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73" name="object 173"/>
            <p:cNvSpPr/>
            <p:nvPr/>
          </p:nvSpPr>
          <p:spPr>
            <a:xfrm>
              <a:off x="3108622" y="5340191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75" y="0"/>
                  </a:moveTo>
                  <a:lnTo>
                    <a:pt x="0" y="0"/>
                  </a:lnTo>
                  <a:lnTo>
                    <a:pt x="36537" y="73037"/>
                  </a:lnTo>
                  <a:lnTo>
                    <a:pt x="73075" y="0"/>
                  </a:lnTo>
                  <a:close/>
                </a:path>
              </a:pathLst>
            </a:custGeom>
            <a:solidFill>
              <a:srgbClr val="1349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74" name="object 174"/>
            <p:cNvSpPr/>
            <p:nvPr/>
          </p:nvSpPr>
          <p:spPr>
            <a:xfrm>
              <a:off x="3108622" y="5340191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075" y="0"/>
                  </a:lnTo>
                  <a:lnTo>
                    <a:pt x="36537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75" name="object 175"/>
            <p:cNvSpPr/>
            <p:nvPr/>
          </p:nvSpPr>
          <p:spPr>
            <a:xfrm>
              <a:off x="3181696" y="5621699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75" y="0"/>
                  </a:moveTo>
                  <a:lnTo>
                    <a:pt x="0" y="0"/>
                  </a:lnTo>
                  <a:lnTo>
                    <a:pt x="36537" y="73050"/>
                  </a:lnTo>
                  <a:lnTo>
                    <a:pt x="73075" y="0"/>
                  </a:lnTo>
                  <a:close/>
                </a:path>
              </a:pathLst>
            </a:custGeom>
            <a:solidFill>
              <a:srgbClr val="1349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76" name="object 176"/>
            <p:cNvSpPr/>
            <p:nvPr/>
          </p:nvSpPr>
          <p:spPr>
            <a:xfrm>
              <a:off x="3181696" y="5621699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075" y="0"/>
                  </a:lnTo>
                  <a:lnTo>
                    <a:pt x="36537" y="73050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77" name="object 177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180934" y="5196388"/>
              <a:ext cx="74599" cy="74561"/>
            </a:xfrm>
            <a:prstGeom prst="rect">
              <a:avLst/>
            </a:prstGeom>
          </p:spPr>
        </p:pic>
        <p:sp>
          <p:nvSpPr>
            <p:cNvPr id="178" name="object 178"/>
            <p:cNvSpPr/>
            <p:nvPr/>
          </p:nvSpPr>
          <p:spPr>
            <a:xfrm>
              <a:off x="3254771" y="5408664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75" y="0"/>
                  </a:moveTo>
                  <a:lnTo>
                    <a:pt x="0" y="0"/>
                  </a:lnTo>
                  <a:lnTo>
                    <a:pt x="36537" y="73037"/>
                  </a:lnTo>
                  <a:lnTo>
                    <a:pt x="73075" y="0"/>
                  </a:lnTo>
                  <a:close/>
                </a:path>
              </a:pathLst>
            </a:custGeom>
            <a:solidFill>
              <a:srgbClr val="1349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79" name="object 179"/>
            <p:cNvSpPr/>
            <p:nvPr/>
          </p:nvSpPr>
          <p:spPr>
            <a:xfrm>
              <a:off x="3254771" y="5408664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075" y="0"/>
                  </a:lnTo>
                  <a:lnTo>
                    <a:pt x="36537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80" name="object 180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180934" y="5862895"/>
              <a:ext cx="74599" cy="74574"/>
            </a:xfrm>
            <a:prstGeom prst="rect">
              <a:avLst/>
            </a:prstGeom>
          </p:spPr>
        </p:pic>
        <p:sp>
          <p:nvSpPr>
            <p:cNvPr id="181" name="object 181"/>
            <p:cNvSpPr/>
            <p:nvPr/>
          </p:nvSpPr>
          <p:spPr>
            <a:xfrm>
              <a:off x="2586459" y="6078217"/>
              <a:ext cx="0" cy="30480"/>
            </a:xfrm>
            <a:custGeom>
              <a:avLst/>
              <a:gdLst/>
              <a:ahLst/>
              <a:cxnLst/>
              <a:rect l="l" t="t" r="r" b="b"/>
              <a:pathLst>
                <a:path w="0" h="30479">
                  <a:moveTo>
                    <a:pt x="0" y="0"/>
                  </a:moveTo>
                  <a:lnTo>
                    <a:pt x="0" y="30429"/>
                  </a:lnTo>
                </a:path>
              </a:pathLst>
            </a:custGeom>
            <a:ln w="9131">
              <a:solidFill>
                <a:srgbClr val="63BC46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82" name="object 182"/>
            <p:cNvSpPr/>
            <p:nvPr/>
          </p:nvSpPr>
          <p:spPr>
            <a:xfrm>
              <a:off x="2586459" y="6108653"/>
              <a:ext cx="0" cy="30480"/>
            </a:xfrm>
            <a:custGeom>
              <a:avLst/>
              <a:gdLst/>
              <a:ahLst/>
              <a:cxnLst/>
              <a:rect l="l" t="t" r="r" b="b"/>
              <a:pathLst>
                <a:path w="0" h="30479">
                  <a:moveTo>
                    <a:pt x="0" y="0"/>
                  </a:moveTo>
                  <a:lnTo>
                    <a:pt x="0" y="30429"/>
                  </a:lnTo>
                </a:path>
              </a:pathLst>
            </a:custGeom>
            <a:ln w="9131">
              <a:solidFill>
                <a:srgbClr val="63BC46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83" name="object 183"/>
            <p:cNvSpPr/>
            <p:nvPr/>
          </p:nvSpPr>
          <p:spPr>
            <a:xfrm>
              <a:off x="2481417" y="6078217"/>
              <a:ext cx="210185" cy="0"/>
            </a:xfrm>
            <a:custGeom>
              <a:avLst/>
              <a:gdLst/>
              <a:ahLst/>
              <a:cxnLst/>
              <a:rect l="l" t="t" r="r" b="b"/>
              <a:pathLst>
                <a:path w="210185" h="0">
                  <a:moveTo>
                    <a:pt x="0" y="0"/>
                  </a:moveTo>
                  <a:lnTo>
                    <a:pt x="210083" y="0"/>
                  </a:lnTo>
                </a:path>
              </a:pathLst>
            </a:custGeom>
            <a:ln w="9131">
              <a:solidFill>
                <a:srgbClr val="63BC46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84" name="object 184"/>
            <p:cNvSpPr/>
            <p:nvPr/>
          </p:nvSpPr>
          <p:spPr>
            <a:xfrm>
              <a:off x="2481417" y="6139088"/>
              <a:ext cx="210185" cy="0"/>
            </a:xfrm>
            <a:custGeom>
              <a:avLst/>
              <a:gdLst/>
              <a:ahLst/>
              <a:cxnLst/>
              <a:rect l="l" t="t" r="r" b="b"/>
              <a:pathLst>
                <a:path w="210185" h="0">
                  <a:moveTo>
                    <a:pt x="0" y="0"/>
                  </a:moveTo>
                  <a:lnTo>
                    <a:pt x="210083" y="0"/>
                  </a:lnTo>
                </a:path>
              </a:pathLst>
            </a:custGeom>
            <a:ln w="9131">
              <a:solidFill>
                <a:srgbClr val="63BC46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85" name="object 185"/>
            <p:cNvSpPr/>
            <p:nvPr/>
          </p:nvSpPr>
          <p:spPr>
            <a:xfrm>
              <a:off x="2549921" y="6009744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36537" y="0"/>
                  </a:moveTo>
                  <a:lnTo>
                    <a:pt x="0" y="73037"/>
                  </a:lnTo>
                  <a:lnTo>
                    <a:pt x="73075" y="73037"/>
                  </a:lnTo>
                  <a:lnTo>
                    <a:pt x="36537" y="0"/>
                  </a:lnTo>
                  <a:close/>
                </a:path>
              </a:pathLst>
            </a:custGeom>
            <a:solidFill>
              <a:srgbClr val="63BC46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86" name="object 186"/>
            <p:cNvSpPr/>
            <p:nvPr/>
          </p:nvSpPr>
          <p:spPr>
            <a:xfrm>
              <a:off x="2549921" y="6009744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36537" y="0"/>
                  </a:moveTo>
                  <a:lnTo>
                    <a:pt x="73075" y="73037"/>
                  </a:lnTo>
                  <a:lnTo>
                    <a:pt x="0" y="73037"/>
                  </a:lnTo>
                  <a:lnTo>
                    <a:pt x="36537" y="0"/>
                  </a:lnTo>
                  <a:close/>
                </a:path>
              </a:pathLst>
            </a:custGeom>
            <a:ln w="3175">
              <a:solidFill>
                <a:srgbClr val="63BC46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87" name="object 187"/>
            <p:cNvPicPr/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2375613" y="5995290"/>
              <a:ext cx="74587" cy="74561"/>
            </a:xfrm>
            <a:prstGeom prst="rect">
              <a:avLst/>
            </a:prstGeom>
          </p:spPr>
        </p:pic>
        <p:pic>
          <p:nvPicPr>
            <p:cNvPr id="188" name="object 188"/>
            <p:cNvPicPr/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2375613" y="6148980"/>
              <a:ext cx="74587" cy="74561"/>
            </a:xfrm>
            <a:prstGeom prst="rect">
              <a:avLst/>
            </a:prstGeom>
          </p:spPr>
        </p:pic>
        <p:sp>
          <p:nvSpPr>
            <p:cNvPr id="189" name="object 189"/>
            <p:cNvSpPr/>
            <p:nvPr/>
          </p:nvSpPr>
          <p:spPr>
            <a:xfrm>
              <a:off x="2549921" y="6082782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36537" y="0"/>
                  </a:moveTo>
                  <a:lnTo>
                    <a:pt x="0" y="73050"/>
                  </a:lnTo>
                  <a:lnTo>
                    <a:pt x="73075" y="73050"/>
                  </a:lnTo>
                  <a:lnTo>
                    <a:pt x="36537" y="0"/>
                  </a:lnTo>
                  <a:close/>
                </a:path>
              </a:pathLst>
            </a:custGeom>
            <a:solidFill>
              <a:srgbClr val="63BC46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90" name="object 190"/>
            <p:cNvSpPr/>
            <p:nvPr/>
          </p:nvSpPr>
          <p:spPr>
            <a:xfrm>
              <a:off x="2549921" y="6082782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36537" y="0"/>
                  </a:moveTo>
                  <a:lnTo>
                    <a:pt x="73075" y="73050"/>
                  </a:lnTo>
                  <a:lnTo>
                    <a:pt x="0" y="73050"/>
                  </a:lnTo>
                  <a:lnTo>
                    <a:pt x="36537" y="0"/>
                  </a:lnTo>
                  <a:close/>
                </a:path>
              </a:pathLst>
            </a:custGeom>
            <a:ln w="3175">
              <a:solidFill>
                <a:srgbClr val="63BC46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191" name="object 191"/>
            <p:cNvPicPr/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2722704" y="6120070"/>
              <a:ext cx="74599" cy="74561"/>
            </a:xfrm>
            <a:prstGeom prst="rect">
              <a:avLst/>
            </a:prstGeom>
          </p:spPr>
        </p:pic>
        <p:sp>
          <p:nvSpPr>
            <p:cNvPr id="192" name="object 192"/>
            <p:cNvSpPr/>
            <p:nvPr/>
          </p:nvSpPr>
          <p:spPr>
            <a:xfrm>
              <a:off x="1954683" y="5344755"/>
              <a:ext cx="0" cy="176530"/>
            </a:xfrm>
            <a:custGeom>
              <a:avLst/>
              <a:gdLst/>
              <a:ahLst/>
              <a:cxnLst/>
              <a:rect l="l" t="t" r="r" b="b"/>
              <a:pathLst>
                <a:path w="0" h="176529">
                  <a:moveTo>
                    <a:pt x="0" y="0"/>
                  </a:moveTo>
                  <a:lnTo>
                    <a:pt x="0" y="176517"/>
                  </a:lnTo>
                </a:path>
              </a:pathLst>
            </a:custGeom>
            <a:ln w="9131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93" name="object 193"/>
            <p:cNvSpPr/>
            <p:nvPr/>
          </p:nvSpPr>
          <p:spPr>
            <a:xfrm>
              <a:off x="1954683" y="5521278"/>
              <a:ext cx="0" cy="176530"/>
            </a:xfrm>
            <a:custGeom>
              <a:avLst/>
              <a:gdLst/>
              <a:ahLst/>
              <a:cxnLst/>
              <a:rect l="l" t="t" r="r" b="b"/>
              <a:pathLst>
                <a:path w="0" h="176529">
                  <a:moveTo>
                    <a:pt x="0" y="0"/>
                  </a:moveTo>
                  <a:lnTo>
                    <a:pt x="0" y="176504"/>
                  </a:lnTo>
                </a:path>
              </a:pathLst>
            </a:custGeom>
            <a:ln w="9131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94" name="object 194"/>
            <p:cNvSpPr/>
            <p:nvPr/>
          </p:nvSpPr>
          <p:spPr>
            <a:xfrm>
              <a:off x="1849641" y="5344755"/>
              <a:ext cx="210185" cy="0"/>
            </a:xfrm>
            <a:custGeom>
              <a:avLst/>
              <a:gdLst/>
              <a:ahLst/>
              <a:cxnLst/>
              <a:rect l="l" t="t" r="r" b="b"/>
              <a:pathLst>
                <a:path w="210185" h="0">
                  <a:moveTo>
                    <a:pt x="0" y="0"/>
                  </a:moveTo>
                  <a:lnTo>
                    <a:pt x="210083" y="0"/>
                  </a:lnTo>
                </a:path>
              </a:pathLst>
            </a:custGeom>
            <a:ln w="9131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95" name="object 195"/>
            <p:cNvSpPr/>
            <p:nvPr/>
          </p:nvSpPr>
          <p:spPr>
            <a:xfrm>
              <a:off x="1849641" y="5697789"/>
              <a:ext cx="210185" cy="0"/>
            </a:xfrm>
            <a:custGeom>
              <a:avLst/>
              <a:gdLst/>
              <a:ahLst/>
              <a:cxnLst/>
              <a:rect l="l" t="t" r="r" b="b"/>
              <a:pathLst>
                <a:path w="210185" h="0">
                  <a:moveTo>
                    <a:pt x="0" y="0"/>
                  </a:moveTo>
                  <a:lnTo>
                    <a:pt x="210083" y="0"/>
                  </a:lnTo>
                </a:path>
              </a:pathLst>
            </a:custGeom>
            <a:ln w="9131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96" name="object 196"/>
            <p:cNvSpPr/>
            <p:nvPr/>
          </p:nvSpPr>
          <p:spPr>
            <a:xfrm>
              <a:off x="1918144" y="6015837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75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075" y="73037"/>
                  </a:lnTo>
                  <a:lnTo>
                    <a:pt x="73075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97" name="object 197"/>
            <p:cNvSpPr/>
            <p:nvPr/>
          </p:nvSpPr>
          <p:spPr>
            <a:xfrm>
              <a:off x="1918144" y="6015837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075" y="0"/>
                  </a:lnTo>
                  <a:lnTo>
                    <a:pt x="73075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98" name="object 198"/>
            <p:cNvSpPr/>
            <p:nvPr/>
          </p:nvSpPr>
          <p:spPr>
            <a:xfrm>
              <a:off x="1991220" y="5783008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63" y="0"/>
                  </a:moveTo>
                  <a:lnTo>
                    <a:pt x="0" y="0"/>
                  </a:lnTo>
                  <a:lnTo>
                    <a:pt x="0" y="73050"/>
                  </a:lnTo>
                  <a:lnTo>
                    <a:pt x="73063" y="73050"/>
                  </a:lnTo>
                  <a:lnTo>
                    <a:pt x="73063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99" name="object 199"/>
            <p:cNvSpPr/>
            <p:nvPr/>
          </p:nvSpPr>
          <p:spPr>
            <a:xfrm>
              <a:off x="1991220" y="5783008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063" y="0"/>
                  </a:lnTo>
                  <a:lnTo>
                    <a:pt x="73063" y="73050"/>
                  </a:lnTo>
                  <a:lnTo>
                    <a:pt x="0" y="73050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00" name="object 200"/>
            <p:cNvSpPr/>
            <p:nvPr/>
          </p:nvSpPr>
          <p:spPr>
            <a:xfrm>
              <a:off x="1845068" y="5781497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75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075" y="73037"/>
                  </a:lnTo>
                  <a:lnTo>
                    <a:pt x="73075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01" name="object 201"/>
            <p:cNvSpPr/>
            <p:nvPr/>
          </p:nvSpPr>
          <p:spPr>
            <a:xfrm>
              <a:off x="1845068" y="5781497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075" y="0"/>
                  </a:lnTo>
                  <a:lnTo>
                    <a:pt x="73075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02" name="object 202"/>
            <p:cNvSpPr/>
            <p:nvPr/>
          </p:nvSpPr>
          <p:spPr>
            <a:xfrm>
              <a:off x="1918144" y="4936947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75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075" y="73037"/>
                  </a:lnTo>
                  <a:lnTo>
                    <a:pt x="73075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03" name="object 203"/>
            <p:cNvSpPr/>
            <p:nvPr/>
          </p:nvSpPr>
          <p:spPr>
            <a:xfrm>
              <a:off x="1918144" y="4936934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075" y="0"/>
                  </a:lnTo>
                  <a:lnTo>
                    <a:pt x="73075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04" name="object 204"/>
            <p:cNvSpPr/>
            <p:nvPr/>
          </p:nvSpPr>
          <p:spPr>
            <a:xfrm>
              <a:off x="1918144" y="5139334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75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075" y="73037"/>
                  </a:lnTo>
                  <a:lnTo>
                    <a:pt x="73075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05" name="object 205"/>
            <p:cNvSpPr/>
            <p:nvPr/>
          </p:nvSpPr>
          <p:spPr>
            <a:xfrm>
              <a:off x="1918144" y="5139321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075" y="0"/>
                  </a:lnTo>
                  <a:lnTo>
                    <a:pt x="73075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06" name="object 206"/>
            <p:cNvSpPr/>
            <p:nvPr/>
          </p:nvSpPr>
          <p:spPr>
            <a:xfrm>
              <a:off x="1918144" y="5253456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075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075" y="73037"/>
                  </a:lnTo>
                  <a:lnTo>
                    <a:pt x="73075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07" name="object 207"/>
            <p:cNvSpPr/>
            <p:nvPr/>
          </p:nvSpPr>
          <p:spPr>
            <a:xfrm>
              <a:off x="1918144" y="5253444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075" y="0"/>
                  </a:lnTo>
                  <a:lnTo>
                    <a:pt x="73075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08" name="object 208"/>
            <p:cNvSpPr/>
            <p:nvPr/>
          </p:nvSpPr>
          <p:spPr>
            <a:xfrm>
              <a:off x="1322908" y="6183216"/>
              <a:ext cx="0" cy="36830"/>
            </a:xfrm>
            <a:custGeom>
              <a:avLst/>
              <a:gdLst/>
              <a:ahLst/>
              <a:cxnLst/>
              <a:rect l="l" t="t" r="r" b="b"/>
              <a:pathLst>
                <a:path w="0" h="36829">
                  <a:moveTo>
                    <a:pt x="0" y="0"/>
                  </a:moveTo>
                  <a:lnTo>
                    <a:pt x="0" y="36525"/>
                  </a:lnTo>
                </a:path>
              </a:pathLst>
            </a:custGeom>
            <a:ln w="9131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09" name="object 209"/>
            <p:cNvSpPr/>
            <p:nvPr/>
          </p:nvSpPr>
          <p:spPr>
            <a:xfrm>
              <a:off x="1322908" y="6219741"/>
              <a:ext cx="0" cy="38100"/>
            </a:xfrm>
            <a:custGeom>
              <a:avLst/>
              <a:gdLst/>
              <a:ahLst/>
              <a:cxnLst/>
              <a:rect l="l" t="t" r="r" b="b"/>
              <a:pathLst>
                <a:path w="0" h="38100">
                  <a:moveTo>
                    <a:pt x="0" y="0"/>
                  </a:moveTo>
                  <a:lnTo>
                    <a:pt x="0" y="38036"/>
                  </a:lnTo>
                </a:path>
              </a:pathLst>
            </a:custGeom>
            <a:ln w="9131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10" name="object 210"/>
            <p:cNvSpPr/>
            <p:nvPr/>
          </p:nvSpPr>
          <p:spPr>
            <a:xfrm>
              <a:off x="1217866" y="6183216"/>
              <a:ext cx="210185" cy="0"/>
            </a:xfrm>
            <a:custGeom>
              <a:avLst/>
              <a:gdLst/>
              <a:ahLst/>
              <a:cxnLst/>
              <a:rect l="l" t="t" r="r" b="b"/>
              <a:pathLst>
                <a:path w="210184" h="0">
                  <a:moveTo>
                    <a:pt x="0" y="0"/>
                  </a:moveTo>
                  <a:lnTo>
                    <a:pt x="210083" y="0"/>
                  </a:lnTo>
                </a:path>
              </a:pathLst>
            </a:custGeom>
            <a:ln w="9131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11" name="object 211"/>
            <p:cNvSpPr/>
            <p:nvPr/>
          </p:nvSpPr>
          <p:spPr>
            <a:xfrm>
              <a:off x="1217866" y="6257779"/>
              <a:ext cx="210185" cy="0"/>
            </a:xfrm>
            <a:custGeom>
              <a:avLst/>
              <a:gdLst/>
              <a:ahLst/>
              <a:cxnLst/>
              <a:rect l="l" t="t" r="r" b="b"/>
              <a:pathLst>
                <a:path w="210184" h="0">
                  <a:moveTo>
                    <a:pt x="0" y="0"/>
                  </a:moveTo>
                  <a:lnTo>
                    <a:pt x="210083" y="0"/>
                  </a:lnTo>
                </a:path>
              </a:pathLst>
            </a:custGeom>
            <a:ln w="9131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12" name="object 212"/>
            <p:cNvSpPr/>
            <p:nvPr/>
          </p:nvSpPr>
          <p:spPr>
            <a:xfrm>
              <a:off x="1459915" y="6082782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59" h="73660">
                  <a:moveTo>
                    <a:pt x="39585" y="0"/>
                  </a:moveTo>
                  <a:lnTo>
                    <a:pt x="33489" y="0"/>
                  </a:lnTo>
                  <a:lnTo>
                    <a:pt x="28930" y="1523"/>
                  </a:lnTo>
                  <a:lnTo>
                    <a:pt x="22834" y="3047"/>
                  </a:lnTo>
                  <a:lnTo>
                    <a:pt x="1524" y="28917"/>
                  </a:lnTo>
                  <a:lnTo>
                    <a:pt x="0" y="33489"/>
                  </a:lnTo>
                  <a:lnTo>
                    <a:pt x="0" y="39560"/>
                  </a:lnTo>
                  <a:lnTo>
                    <a:pt x="1524" y="44132"/>
                  </a:lnTo>
                  <a:lnTo>
                    <a:pt x="3048" y="50215"/>
                  </a:lnTo>
                  <a:lnTo>
                    <a:pt x="6096" y="56311"/>
                  </a:lnTo>
                  <a:lnTo>
                    <a:pt x="10655" y="62395"/>
                  </a:lnTo>
                  <a:lnTo>
                    <a:pt x="16751" y="66954"/>
                  </a:lnTo>
                  <a:lnTo>
                    <a:pt x="28930" y="73050"/>
                  </a:lnTo>
                  <a:lnTo>
                    <a:pt x="44157" y="73050"/>
                  </a:lnTo>
                  <a:lnTo>
                    <a:pt x="56337" y="66954"/>
                  </a:lnTo>
                  <a:lnTo>
                    <a:pt x="62420" y="62395"/>
                  </a:lnTo>
                  <a:lnTo>
                    <a:pt x="66992" y="56311"/>
                  </a:lnTo>
                  <a:lnTo>
                    <a:pt x="73075" y="44132"/>
                  </a:lnTo>
                  <a:lnTo>
                    <a:pt x="73075" y="36525"/>
                  </a:lnTo>
                  <a:lnTo>
                    <a:pt x="73075" y="28917"/>
                  </a:lnTo>
                  <a:lnTo>
                    <a:pt x="44157" y="1523"/>
                  </a:lnTo>
                  <a:lnTo>
                    <a:pt x="39585" y="0"/>
                  </a:lnTo>
                  <a:close/>
                </a:path>
              </a:pathLst>
            </a:custGeom>
            <a:solidFill>
              <a:srgbClr val="EE332E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13" name="object 213"/>
            <p:cNvSpPr/>
            <p:nvPr/>
          </p:nvSpPr>
          <p:spPr>
            <a:xfrm>
              <a:off x="1459915" y="6082782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59" h="73660">
                  <a:moveTo>
                    <a:pt x="73075" y="36525"/>
                  </a:moveTo>
                  <a:lnTo>
                    <a:pt x="73075" y="44132"/>
                  </a:lnTo>
                  <a:lnTo>
                    <a:pt x="70027" y="50215"/>
                  </a:lnTo>
                  <a:lnTo>
                    <a:pt x="66992" y="56311"/>
                  </a:lnTo>
                  <a:lnTo>
                    <a:pt x="62420" y="62395"/>
                  </a:lnTo>
                  <a:lnTo>
                    <a:pt x="56337" y="66954"/>
                  </a:lnTo>
                  <a:lnTo>
                    <a:pt x="50241" y="70002"/>
                  </a:lnTo>
                  <a:lnTo>
                    <a:pt x="44157" y="73050"/>
                  </a:lnTo>
                  <a:lnTo>
                    <a:pt x="36537" y="73050"/>
                  </a:lnTo>
                  <a:lnTo>
                    <a:pt x="28930" y="73050"/>
                  </a:lnTo>
                  <a:lnTo>
                    <a:pt x="22834" y="70002"/>
                  </a:lnTo>
                  <a:lnTo>
                    <a:pt x="1524" y="44132"/>
                  </a:lnTo>
                  <a:lnTo>
                    <a:pt x="0" y="39560"/>
                  </a:lnTo>
                  <a:lnTo>
                    <a:pt x="0" y="36525"/>
                  </a:lnTo>
                  <a:lnTo>
                    <a:pt x="0" y="33489"/>
                  </a:lnTo>
                  <a:lnTo>
                    <a:pt x="1524" y="28917"/>
                  </a:lnTo>
                  <a:lnTo>
                    <a:pt x="28930" y="1523"/>
                  </a:lnTo>
                  <a:lnTo>
                    <a:pt x="33489" y="0"/>
                  </a:lnTo>
                  <a:lnTo>
                    <a:pt x="36537" y="0"/>
                  </a:lnTo>
                  <a:lnTo>
                    <a:pt x="39585" y="0"/>
                  </a:lnTo>
                  <a:lnTo>
                    <a:pt x="44157" y="1523"/>
                  </a:lnTo>
                  <a:lnTo>
                    <a:pt x="70027" y="22834"/>
                  </a:lnTo>
                  <a:lnTo>
                    <a:pt x="73075" y="28917"/>
                  </a:lnTo>
                  <a:lnTo>
                    <a:pt x="73075" y="36525"/>
                  </a:lnTo>
                </a:path>
              </a:pathLst>
            </a:custGeom>
            <a:ln w="3175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14" name="object 214"/>
            <p:cNvSpPr/>
            <p:nvPr/>
          </p:nvSpPr>
          <p:spPr>
            <a:xfrm>
              <a:off x="1286370" y="6120832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59" h="73660">
                  <a:moveTo>
                    <a:pt x="39585" y="0"/>
                  </a:moveTo>
                  <a:lnTo>
                    <a:pt x="33489" y="0"/>
                  </a:lnTo>
                  <a:lnTo>
                    <a:pt x="28917" y="1511"/>
                  </a:lnTo>
                  <a:lnTo>
                    <a:pt x="22834" y="3035"/>
                  </a:lnTo>
                  <a:lnTo>
                    <a:pt x="1524" y="28905"/>
                  </a:lnTo>
                  <a:lnTo>
                    <a:pt x="0" y="33477"/>
                  </a:lnTo>
                  <a:lnTo>
                    <a:pt x="0" y="39560"/>
                  </a:lnTo>
                  <a:lnTo>
                    <a:pt x="1524" y="44132"/>
                  </a:lnTo>
                  <a:lnTo>
                    <a:pt x="3048" y="50215"/>
                  </a:lnTo>
                  <a:lnTo>
                    <a:pt x="6096" y="56299"/>
                  </a:lnTo>
                  <a:lnTo>
                    <a:pt x="10655" y="62382"/>
                  </a:lnTo>
                  <a:lnTo>
                    <a:pt x="16738" y="66941"/>
                  </a:lnTo>
                  <a:lnTo>
                    <a:pt x="28917" y="73037"/>
                  </a:lnTo>
                  <a:lnTo>
                    <a:pt x="44145" y="73037"/>
                  </a:lnTo>
                  <a:lnTo>
                    <a:pt x="56324" y="66941"/>
                  </a:lnTo>
                  <a:lnTo>
                    <a:pt x="62420" y="62382"/>
                  </a:lnTo>
                  <a:lnTo>
                    <a:pt x="66992" y="56299"/>
                  </a:lnTo>
                  <a:lnTo>
                    <a:pt x="73075" y="44132"/>
                  </a:lnTo>
                  <a:lnTo>
                    <a:pt x="73075" y="36512"/>
                  </a:lnTo>
                  <a:lnTo>
                    <a:pt x="73075" y="28905"/>
                  </a:lnTo>
                  <a:lnTo>
                    <a:pt x="44145" y="1511"/>
                  </a:lnTo>
                  <a:lnTo>
                    <a:pt x="39585" y="0"/>
                  </a:lnTo>
                  <a:close/>
                </a:path>
              </a:pathLst>
            </a:custGeom>
            <a:solidFill>
              <a:srgbClr val="EE332E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15" name="object 215"/>
            <p:cNvSpPr/>
            <p:nvPr/>
          </p:nvSpPr>
          <p:spPr>
            <a:xfrm>
              <a:off x="1286370" y="6120832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59" h="73660">
                  <a:moveTo>
                    <a:pt x="73075" y="36512"/>
                  </a:moveTo>
                  <a:lnTo>
                    <a:pt x="73075" y="44132"/>
                  </a:lnTo>
                  <a:lnTo>
                    <a:pt x="70027" y="50215"/>
                  </a:lnTo>
                  <a:lnTo>
                    <a:pt x="66992" y="56299"/>
                  </a:lnTo>
                  <a:lnTo>
                    <a:pt x="62420" y="62382"/>
                  </a:lnTo>
                  <a:lnTo>
                    <a:pt x="56324" y="66941"/>
                  </a:lnTo>
                  <a:lnTo>
                    <a:pt x="50241" y="70002"/>
                  </a:lnTo>
                  <a:lnTo>
                    <a:pt x="44145" y="73037"/>
                  </a:lnTo>
                  <a:lnTo>
                    <a:pt x="36537" y="73037"/>
                  </a:lnTo>
                  <a:lnTo>
                    <a:pt x="28917" y="73037"/>
                  </a:lnTo>
                  <a:lnTo>
                    <a:pt x="1524" y="44132"/>
                  </a:lnTo>
                  <a:lnTo>
                    <a:pt x="0" y="39560"/>
                  </a:lnTo>
                  <a:lnTo>
                    <a:pt x="0" y="36512"/>
                  </a:lnTo>
                  <a:lnTo>
                    <a:pt x="0" y="33477"/>
                  </a:lnTo>
                  <a:lnTo>
                    <a:pt x="1524" y="28905"/>
                  </a:lnTo>
                  <a:lnTo>
                    <a:pt x="28917" y="1511"/>
                  </a:lnTo>
                  <a:lnTo>
                    <a:pt x="33489" y="0"/>
                  </a:lnTo>
                  <a:lnTo>
                    <a:pt x="36537" y="0"/>
                  </a:lnTo>
                  <a:lnTo>
                    <a:pt x="39585" y="0"/>
                  </a:lnTo>
                  <a:lnTo>
                    <a:pt x="44145" y="1511"/>
                  </a:lnTo>
                  <a:lnTo>
                    <a:pt x="70027" y="22821"/>
                  </a:lnTo>
                  <a:lnTo>
                    <a:pt x="73075" y="28905"/>
                  </a:lnTo>
                  <a:lnTo>
                    <a:pt x="73075" y="36512"/>
                  </a:lnTo>
                </a:path>
              </a:pathLst>
            </a:custGeom>
            <a:ln w="3175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216" name="object 216"/>
            <p:cNvPicPr/>
            <p:nvPr/>
          </p:nvPicPr>
          <p:blipFill>
            <a:blip r:embed="rId20" cstate="print"/>
            <a:stretch>
              <a:fillRect/>
            </a:stretch>
          </p:blipFill>
          <p:spPr>
            <a:xfrm>
              <a:off x="1112067" y="6156583"/>
              <a:ext cx="74587" cy="74574"/>
            </a:xfrm>
            <a:prstGeom prst="rect">
              <a:avLst/>
            </a:prstGeom>
          </p:spPr>
        </p:pic>
        <p:sp>
          <p:nvSpPr>
            <p:cNvPr id="217" name="object 217"/>
            <p:cNvSpPr/>
            <p:nvPr/>
          </p:nvSpPr>
          <p:spPr>
            <a:xfrm>
              <a:off x="1459915" y="6174087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59" h="73660">
                  <a:moveTo>
                    <a:pt x="39585" y="0"/>
                  </a:moveTo>
                  <a:lnTo>
                    <a:pt x="33489" y="0"/>
                  </a:lnTo>
                  <a:lnTo>
                    <a:pt x="28930" y="1523"/>
                  </a:lnTo>
                  <a:lnTo>
                    <a:pt x="22834" y="3035"/>
                  </a:lnTo>
                  <a:lnTo>
                    <a:pt x="1524" y="28905"/>
                  </a:lnTo>
                  <a:lnTo>
                    <a:pt x="0" y="33477"/>
                  </a:lnTo>
                  <a:lnTo>
                    <a:pt x="0" y="39560"/>
                  </a:lnTo>
                  <a:lnTo>
                    <a:pt x="1524" y="44132"/>
                  </a:lnTo>
                  <a:lnTo>
                    <a:pt x="3048" y="50215"/>
                  </a:lnTo>
                  <a:lnTo>
                    <a:pt x="6096" y="56311"/>
                  </a:lnTo>
                  <a:lnTo>
                    <a:pt x="10655" y="62395"/>
                  </a:lnTo>
                  <a:lnTo>
                    <a:pt x="16751" y="66954"/>
                  </a:lnTo>
                  <a:lnTo>
                    <a:pt x="28930" y="73037"/>
                  </a:lnTo>
                  <a:lnTo>
                    <a:pt x="44157" y="73037"/>
                  </a:lnTo>
                  <a:lnTo>
                    <a:pt x="56337" y="66954"/>
                  </a:lnTo>
                  <a:lnTo>
                    <a:pt x="62420" y="62395"/>
                  </a:lnTo>
                  <a:lnTo>
                    <a:pt x="66992" y="56311"/>
                  </a:lnTo>
                  <a:lnTo>
                    <a:pt x="73075" y="44132"/>
                  </a:lnTo>
                  <a:lnTo>
                    <a:pt x="73075" y="36525"/>
                  </a:lnTo>
                  <a:lnTo>
                    <a:pt x="73075" y="28905"/>
                  </a:lnTo>
                  <a:lnTo>
                    <a:pt x="44157" y="1523"/>
                  </a:lnTo>
                  <a:lnTo>
                    <a:pt x="39585" y="0"/>
                  </a:lnTo>
                  <a:close/>
                </a:path>
              </a:pathLst>
            </a:custGeom>
            <a:solidFill>
              <a:srgbClr val="EE332E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18" name="object 218"/>
            <p:cNvSpPr/>
            <p:nvPr/>
          </p:nvSpPr>
          <p:spPr>
            <a:xfrm>
              <a:off x="1459915" y="6174087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59" h="73660">
                  <a:moveTo>
                    <a:pt x="73075" y="36525"/>
                  </a:moveTo>
                  <a:lnTo>
                    <a:pt x="73075" y="44132"/>
                  </a:lnTo>
                  <a:lnTo>
                    <a:pt x="70027" y="50215"/>
                  </a:lnTo>
                  <a:lnTo>
                    <a:pt x="66992" y="56311"/>
                  </a:lnTo>
                  <a:lnTo>
                    <a:pt x="62420" y="62395"/>
                  </a:lnTo>
                  <a:lnTo>
                    <a:pt x="56337" y="66954"/>
                  </a:lnTo>
                  <a:lnTo>
                    <a:pt x="50241" y="70002"/>
                  </a:lnTo>
                  <a:lnTo>
                    <a:pt x="44157" y="73037"/>
                  </a:lnTo>
                  <a:lnTo>
                    <a:pt x="36537" y="73037"/>
                  </a:lnTo>
                  <a:lnTo>
                    <a:pt x="28930" y="73037"/>
                  </a:lnTo>
                  <a:lnTo>
                    <a:pt x="1524" y="44132"/>
                  </a:lnTo>
                  <a:lnTo>
                    <a:pt x="0" y="39560"/>
                  </a:lnTo>
                  <a:lnTo>
                    <a:pt x="0" y="36525"/>
                  </a:lnTo>
                  <a:lnTo>
                    <a:pt x="0" y="33477"/>
                  </a:lnTo>
                  <a:lnTo>
                    <a:pt x="1524" y="28905"/>
                  </a:lnTo>
                  <a:lnTo>
                    <a:pt x="28930" y="1523"/>
                  </a:lnTo>
                  <a:lnTo>
                    <a:pt x="33489" y="0"/>
                  </a:lnTo>
                  <a:lnTo>
                    <a:pt x="36537" y="0"/>
                  </a:lnTo>
                  <a:lnTo>
                    <a:pt x="39585" y="0"/>
                  </a:lnTo>
                  <a:lnTo>
                    <a:pt x="44157" y="1523"/>
                  </a:lnTo>
                  <a:lnTo>
                    <a:pt x="70027" y="22821"/>
                  </a:lnTo>
                  <a:lnTo>
                    <a:pt x="73075" y="28905"/>
                  </a:lnTo>
                  <a:lnTo>
                    <a:pt x="73075" y="36525"/>
                  </a:lnTo>
                </a:path>
              </a:pathLst>
            </a:custGeom>
            <a:ln w="3175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19" name="object 219"/>
            <p:cNvSpPr/>
            <p:nvPr/>
          </p:nvSpPr>
          <p:spPr>
            <a:xfrm>
              <a:off x="1286370" y="6224304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59" h="73660">
                  <a:moveTo>
                    <a:pt x="39585" y="0"/>
                  </a:moveTo>
                  <a:lnTo>
                    <a:pt x="33489" y="0"/>
                  </a:lnTo>
                  <a:lnTo>
                    <a:pt x="28917" y="1523"/>
                  </a:lnTo>
                  <a:lnTo>
                    <a:pt x="22834" y="3035"/>
                  </a:lnTo>
                  <a:lnTo>
                    <a:pt x="1524" y="28905"/>
                  </a:lnTo>
                  <a:lnTo>
                    <a:pt x="0" y="33477"/>
                  </a:lnTo>
                  <a:lnTo>
                    <a:pt x="0" y="39560"/>
                  </a:lnTo>
                  <a:lnTo>
                    <a:pt x="1524" y="44132"/>
                  </a:lnTo>
                  <a:lnTo>
                    <a:pt x="3048" y="50215"/>
                  </a:lnTo>
                  <a:lnTo>
                    <a:pt x="6096" y="56311"/>
                  </a:lnTo>
                  <a:lnTo>
                    <a:pt x="10655" y="62395"/>
                  </a:lnTo>
                  <a:lnTo>
                    <a:pt x="16738" y="66954"/>
                  </a:lnTo>
                  <a:lnTo>
                    <a:pt x="28917" y="73037"/>
                  </a:lnTo>
                  <a:lnTo>
                    <a:pt x="44145" y="73037"/>
                  </a:lnTo>
                  <a:lnTo>
                    <a:pt x="56324" y="66954"/>
                  </a:lnTo>
                  <a:lnTo>
                    <a:pt x="62420" y="62395"/>
                  </a:lnTo>
                  <a:lnTo>
                    <a:pt x="66992" y="56311"/>
                  </a:lnTo>
                  <a:lnTo>
                    <a:pt x="73075" y="44132"/>
                  </a:lnTo>
                  <a:lnTo>
                    <a:pt x="73075" y="36525"/>
                  </a:lnTo>
                  <a:lnTo>
                    <a:pt x="73075" y="28905"/>
                  </a:lnTo>
                  <a:lnTo>
                    <a:pt x="44145" y="1523"/>
                  </a:lnTo>
                  <a:lnTo>
                    <a:pt x="39585" y="0"/>
                  </a:lnTo>
                  <a:close/>
                </a:path>
              </a:pathLst>
            </a:custGeom>
            <a:solidFill>
              <a:srgbClr val="EE332E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20" name="object 220"/>
            <p:cNvSpPr/>
            <p:nvPr/>
          </p:nvSpPr>
          <p:spPr>
            <a:xfrm>
              <a:off x="1286370" y="6224304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59" h="73660">
                  <a:moveTo>
                    <a:pt x="73075" y="36525"/>
                  </a:moveTo>
                  <a:lnTo>
                    <a:pt x="73075" y="44132"/>
                  </a:lnTo>
                  <a:lnTo>
                    <a:pt x="70027" y="50215"/>
                  </a:lnTo>
                  <a:lnTo>
                    <a:pt x="66992" y="56311"/>
                  </a:lnTo>
                  <a:lnTo>
                    <a:pt x="62420" y="62395"/>
                  </a:lnTo>
                  <a:lnTo>
                    <a:pt x="56324" y="66954"/>
                  </a:lnTo>
                  <a:lnTo>
                    <a:pt x="50241" y="70002"/>
                  </a:lnTo>
                  <a:lnTo>
                    <a:pt x="44145" y="73037"/>
                  </a:lnTo>
                  <a:lnTo>
                    <a:pt x="36537" y="73037"/>
                  </a:lnTo>
                  <a:lnTo>
                    <a:pt x="28917" y="73037"/>
                  </a:lnTo>
                  <a:lnTo>
                    <a:pt x="1524" y="44132"/>
                  </a:lnTo>
                  <a:lnTo>
                    <a:pt x="0" y="39560"/>
                  </a:lnTo>
                  <a:lnTo>
                    <a:pt x="0" y="36525"/>
                  </a:lnTo>
                  <a:lnTo>
                    <a:pt x="0" y="33477"/>
                  </a:lnTo>
                  <a:lnTo>
                    <a:pt x="1524" y="28905"/>
                  </a:lnTo>
                  <a:lnTo>
                    <a:pt x="28917" y="1523"/>
                  </a:lnTo>
                  <a:lnTo>
                    <a:pt x="33489" y="0"/>
                  </a:lnTo>
                  <a:lnTo>
                    <a:pt x="36537" y="0"/>
                  </a:lnTo>
                  <a:lnTo>
                    <a:pt x="39585" y="0"/>
                  </a:lnTo>
                  <a:lnTo>
                    <a:pt x="44145" y="1523"/>
                  </a:lnTo>
                  <a:lnTo>
                    <a:pt x="70027" y="22821"/>
                  </a:lnTo>
                  <a:lnTo>
                    <a:pt x="73075" y="28905"/>
                  </a:lnTo>
                  <a:lnTo>
                    <a:pt x="73075" y="36525"/>
                  </a:lnTo>
                </a:path>
              </a:pathLst>
            </a:custGeom>
            <a:ln w="3175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221" name="object 221"/>
            <p:cNvPicPr/>
            <p:nvPr/>
          </p:nvPicPr>
          <p:blipFill>
            <a:blip r:embed="rId21" cstate="print"/>
            <a:stretch>
              <a:fillRect/>
            </a:stretch>
          </p:blipFill>
          <p:spPr>
            <a:xfrm>
              <a:off x="1285608" y="6342232"/>
              <a:ext cx="74599" cy="74574"/>
            </a:xfrm>
            <a:prstGeom prst="rect">
              <a:avLst/>
            </a:prstGeom>
          </p:spPr>
        </p:pic>
      </p:grpSp>
      <p:sp>
        <p:nvSpPr>
          <p:cNvPr id="222" name="object 222"/>
          <p:cNvSpPr txBox="1"/>
          <p:nvPr/>
        </p:nvSpPr>
        <p:spPr>
          <a:xfrm>
            <a:off x="739347" y="6363755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0</a:t>
            </a:r>
            <a:endParaRPr sz="1100">
              <a:latin typeface="Arial"/>
              <a:cs typeface="Arial"/>
            </a:endParaRPr>
          </a:p>
        </p:txBody>
      </p:sp>
      <p:sp>
        <p:nvSpPr>
          <p:cNvPr id="223" name="object 223"/>
          <p:cNvSpPr txBox="1"/>
          <p:nvPr/>
        </p:nvSpPr>
        <p:spPr>
          <a:xfrm>
            <a:off x="739347" y="5998456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1</a:t>
            </a:r>
            <a:endParaRPr sz="1100">
              <a:latin typeface="Arial"/>
              <a:cs typeface="Arial"/>
            </a:endParaRPr>
          </a:p>
        </p:txBody>
      </p:sp>
      <p:sp>
        <p:nvSpPr>
          <p:cNvPr id="224" name="object 224"/>
          <p:cNvSpPr txBox="1"/>
          <p:nvPr/>
        </p:nvSpPr>
        <p:spPr>
          <a:xfrm>
            <a:off x="739347" y="5633296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2</a:t>
            </a:r>
            <a:endParaRPr sz="1100">
              <a:latin typeface="Arial"/>
              <a:cs typeface="Arial"/>
            </a:endParaRPr>
          </a:p>
        </p:txBody>
      </p:sp>
      <p:sp>
        <p:nvSpPr>
          <p:cNvPr id="225" name="object 225"/>
          <p:cNvSpPr txBox="1"/>
          <p:nvPr/>
        </p:nvSpPr>
        <p:spPr>
          <a:xfrm>
            <a:off x="739347" y="5268135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3</a:t>
            </a:r>
            <a:endParaRPr sz="1100">
              <a:latin typeface="Arial"/>
              <a:cs typeface="Arial"/>
            </a:endParaRPr>
          </a:p>
        </p:txBody>
      </p:sp>
      <p:sp>
        <p:nvSpPr>
          <p:cNvPr id="226" name="object 226"/>
          <p:cNvSpPr txBox="1"/>
          <p:nvPr/>
        </p:nvSpPr>
        <p:spPr>
          <a:xfrm>
            <a:off x="739347" y="4902975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4</a:t>
            </a:r>
            <a:endParaRPr sz="1100">
              <a:latin typeface="Arial"/>
              <a:cs typeface="Arial"/>
            </a:endParaRPr>
          </a:p>
        </p:txBody>
      </p:sp>
      <p:sp>
        <p:nvSpPr>
          <p:cNvPr id="227" name="object 227"/>
          <p:cNvSpPr txBox="1"/>
          <p:nvPr/>
        </p:nvSpPr>
        <p:spPr>
          <a:xfrm>
            <a:off x="739347" y="4537814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5</a:t>
            </a:r>
            <a:endParaRPr sz="1100">
              <a:latin typeface="Arial"/>
              <a:cs typeface="Arial"/>
            </a:endParaRPr>
          </a:p>
        </p:txBody>
      </p:sp>
      <p:sp>
        <p:nvSpPr>
          <p:cNvPr id="228" name="object 228"/>
          <p:cNvSpPr txBox="1"/>
          <p:nvPr/>
        </p:nvSpPr>
        <p:spPr>
          <a:xfrm>
            <a:off x="510250" y="4584469"/>
            <a:ext cx="195580" cy="1934210"/>
          </a:xfrm>
          <a:prstGeom prst="rect">
            <a:avLst/>
          </a:prstGeom>
        </p:spPr>
        <p:txBody>
          <a:bodyPr wrap="square" lIns="0" tIns="0" rIns="0" bIns="0" rtlCol="0" vert="vert270">
            <a:spAutoFit/>
          </a:bodyPr>
          <a:lstStyle/>
          <a:p>
            <a:pPr marL="12700">
              <a:lnSpc>
                <a:spcPts val="1425"/>
              </a:lnSpc>
            </a:pPr>
            <a:r>
              <a:rPr dirty="0" sz="1200" spc="-15" b="1">
                <a:latin typeface="Arial"/>
                <a:cs typeface="Arial"/>
              </a:rPr>
              <a:t>mRNA</a:t>
            </a:r>
            <a:r>
              <a:rPr dirty="0" sz="1200" spc="-35" b="1">
                <a:latin typeface="Arial"/>
                <a:cs typeface="Arial"/>
              </a:rPr>
              <a:t> </a:t>
            </a:r>
            <a:r>
              <a:rPr dirty="0" sz="1200" spc="-15" b="1">
                <a:latin typeface="Arial"/>
                <a:cs typeface="Arial"/>
              </a:rPr>
              <a:t>GCLC</a:t>
            </a:r>
            <a:r>
              <a:rPr dirty="0" sz="1200" spc="-40" b="1">
                <a:latin typeface="Arial"/>
                <a:cs typeface="Arial"/>
              </a:rPr>
              <a:t> </a:t>
            </a:r>
            <a:r>
              <a:rPr dirty="0" sz="1200" spc="-10" b="1">
                <a:latin typeface="Arial"/>
                <a:cs typeface="Arial"/>
              </a:rPr>
              <a:t>(fold</a:t>
            </a:r>
            <a:r>
              <a:rPr dirty="0" sz="1200" spc="-35" b="1">
                <a:latin typeface="Arial"/>
                <a:cs typeface="Arial"/>
              </a:rPr>
              <a:t> </a:t>
            </a:r>
            <a:r>
              <a:rPr dirty="0" sz="1200" spc="-15" b="1">
                <a:latin typeface="Arial"/>
                <a:cs typeface="Arial"/>
              </a:rPr>
              <a:t>change)</a:t>
            </a:r>
            <a:endParaRPr sz="1200">
              <a:latin typeface="Arial"/>
              <a:cs typeface="Arial"/>
            </a:endParaRPr>
          </a:p>
        </p:txBody>
      </p:sp>
      <p:sp>
        <p:nvSpPr>
          <p:cNvPr id="229" name="object 229"/>
          <p:cNvSpPr/>
          <p:nvPr/>
        </p:nvSpPr>
        <p:spPr>
          <a:xfrm>
            <a:off x="1150881" y="6787334"/>
            <a:ext cx="1010919" cy="0"/>
          </a:xfrm>
          <a:custGeom>
            <a:avLst/>
            <a:gdLst/>
            <a:ahLst/>
            <a:cxnLst/>
            <a:rect l="l" t="t" r="r" b="b"/>
            <a:pathLst>
              <a:path w="1010919" h="0">
                <a:moveTo>
                  <a:pt x="0" y="0"/>
                </a:moveTo>
                <a:lnTo>
                  <a:pt x="1010843" y="0"/>
                </a:lnTo>
              </a:path>
            </a:pathLst>
          </a:custGeom>
          <a:ln w="18262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30" name="object 230"/>
          <p:cNvSpPr txBox="1"/>
          <p:nvPr/>
        </p:nvSpPr>
        <p:spPr>
          <a:xfrm>
            <a:off x="1552345" y="6833853"/>
            <a:ext cx="236854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45" b="1">
                <a:latin typeface="Arial"/>
                <a:cs typeface="Arial"/>
              </a:rPr>
              <a:t>W</a:t>
            </a:r>
            <a:r>
              <a:rPr dirty="0" sz="1100" spc="-10" b="1">
                <a:latin typeface="Arial"/>
                <a:cs typeface="Arial"/>
              </a:rPr>
              <a:t>T</a:t>
            </a:r>
            <a:endParaRPr sz="1100">
              <a:latin typeface="Arial"/>
              <a:cs typeface="Arial"/>
            </a:endParaRPr>
          </a:p>
        </p:txBody>
      </p:sp>
      <p:sp>
        <p:nvSpPr>
          <p:cNvPr id="231" name="object 231"/>
          <p:cNvSpPr txBox="1"/>
          <p:nvPr/>
        </p:nvSpPr>
        <p:spPr>
          <a:xfrm>
            <a:off x="2544942" y="6833853"/>
            <a:ext cx="64643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20" b="1">
                <a:latin typeface="Arial"/>
                <a:cs typeface="Arial"/>
              </a:rPr>
              <a:t>CC</a:t>
            </a:r>
            <a:r>
              <a:rPr dirty="0" sz="1100" spc="-10" b="1">
                <a:latin typeface="Arial"/>
                <a:cs typeface="Arial"/>
              </a:rPr>
              <a:t>N2</a:t>
            </a:r>
            <a:r>
              <a:rPr dirty="0" sz="1100" spc="-15" b="1">
                <a:latin typeface="Arial"/>
                <a:cs typeface="Arial"/>
              </a:rPr>
              <a:t> </a:t>
            </a:r>
            <a:r>
              <a:rPr dirty="0" sz="1100" spc="-10" b="1">
                <a:latin typeface="Arial"/>
                <a:cs typeface="Arial"/>
              </a:rPr>
              <a:t>KO</a:t>
            </a:r>
            <a:endParaRPr sz="1100">
              <a:latin typeface="Arial"/>
              <a:cs typeface="Arial"/>
            </a:endParaRPr>
          </a:p>
        </p:txBody>
      </p:sp>
      <p:sp>
        <p:nvSpPr>
          <p:cNvPr id="232" name="object 232"/>
          <p:cNvSpPr/>
          <p:nvPr/>
        </p:nvSpPr>
        <p:spPr>
          <a:xfrm>
            <a:off x="2423566" y="6790385"/>
            <a:ext cx="1010919" cy="0"/>
          </a:xfrm>
          <a:custGeom>
            <a:avLst/>
            <a:gdLst/>
            <a:ahLst/>
            <a:cxnLst/>
            <a:rect l="l" t="t" r="r" b="b"/>
            <a:pathLst>
              <a:path w="1010920" h="0">
                <a:moveTo>
                  <a:pt x="0" y="0"/>
                </a:moveTo>
                <a:lnTo>
                  <a:pt x="1010843" y="0"/>
                </a:lnTo>
              </a:path>
            </a:pathLst>
          </a:custGeom>
          <a:ln w="18262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33" name="object 233"/>
          <p:cNvSpPr txBox="1"/>
          <p:nvPr/>
        </p:nvSpPr>
        <p:spPr>
          <a:xfrm>
            <a:off x="1552246" y="4530161"/>
            <a:ext cx="163195" cy="17716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1000" spc="-45">
                <a:latin typeface="Arial"/>
                <a:cs typeface="Arial"/>
              </a:rPr>
              <a:t>**</a:t>
            </a:r>
            <a:r>
              <a:rPr dirty="0" sz="1000" spc="-5">
                <a:latin typeface="Arial"/>
                <a:cs typeface="Arial"/>
              </a:rPr>
              <a:t>*</a:t>
            </a:r>
            <a:endParaRPr sz="1000">
              <a:latin typeface="Arial"/>
              <a:cs typeface="Arial"/>
            </a:endParaRPr>
          </a:p>
        </p:txBody>
      </p:sp>
      <p:grpSp>
        <p:nvGrpSpPr>
          <p:cNvPr id="234" name="object 234"/>
          <p:cNvGrpSpPr/>
          <p:nvPr/>
        </p:nvGrpSpPr>
        <p:grpSpPr>
          <a:xfrm>
            <a:off x="1323479" y="4686427"/>
            <a:ext cx="615950" cy="47625"/>
            <a:chOff x="1323479" y="4686427"/>
            <a:chExt cx="615950" cy="47625"/>
          </a:xfrm>
        </p:grpSpPr>
        <p:sp>
          <p:nvSpPr>
            <p:cNvPr id="235" name="object 235"/>
            <p:cNvSpPr/>
            <p:nvPr/>
          </p:nvSpPr>
          <p:spPr>
            <a:xfrm>
              <a:off x="1324432" y="4687442"/>
              <a:ext cx="614045" cy="45720"/>
            </a:xfrm>
            <a:custGeom>
              <a:avLst/>
              <a:gdLst/>
              <a:ahLst/>
              <a:cxnLst/>
              <a:rect l="l" t="t" r="r" b="b"/>
              <a:pathLst>
                <a:path w="614044" h="45720">
                  <a:moveTo>
                    <a:pt x="613498" y="2540"/>
                  </a:moveTo>
                  <a:lnTo>
                    <a:pt x="613168" y="2540"/>
                  </a:lnTo>
                  <a:lnTo>
                    <a:pt x="613168" y="6350"/>
                  </a:lnTo>
                  <a:lnTo>
                    <a:pt x="611898" y="7620"/>
                  </a:lnTo>
                  <a:lnTo>
                    <a:pt x="611898" y="6350"/>
                  </a:lnTo>
                  <a:lnTo>
                    <a:pt x="613168" y="6350"/>
                  </a:lnTo>
                  <a:lnTo>
                    <a:pt x="613168" y="2540"/>
                  </a:lnTo>
                  <a:lnTo>
                    <a:pt x="611784" y="2540"/>
                  </a:lnTo>
                  <a:lnTo>
                    <a:pt x="611784" y="0"/>
                  </a:lnTo>
                  <a:lnTo>
                    <a:pt x="1701" y="0"/>
                  </a:lnTo>
                  <a:lnTo>
                    <a:pt x="1701" y="2540"/>
                  </a:lnTo>
                  <a:lnTo>
                    <a:pt x="0" y="2540"/>
                  </a:lnTo>
                  <a:lnTo>
                    <a:pt x="0" y="5080"/>
                  </a:lnTo>
                  <a:lnTo>
                    <a:pt x="0" y="6350"/>
                  </a:lnTo>
                  <a:lnTo>
                    <a:pt x="0" y="8890"/>
                  </a:lnTo>
                  <a:lnTo>
                    <a:pt x="0" y="45720"/>
                  </a:lnTo>
                  <a:lnTo>
                    <a:pt x="9131" y="45720"/>
                  </a:lnTo>
                  <a:lnTo>
                    <a:pt x="9131" y="9055"/>
                  </a:lnTo>
                  <a:lnTo>
                    <a:pt x="604367" y="9055"/>
                  </a:lnTo>
                  <a:lnTo>
                    <a:pt x="604367" y="45720"/>
                  </a:lnTo>
                  <a:lnTo>
                    <a:pt x="613498" y="45720"/>
                  </a:lnTo>
                  <a:lnTo>
                    <a:pt x="613498" y="5080"/>
                  </a:lnTo>
                  <a:lnTo>
                    <a:pt x="613498" y="2540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36" name="object 236"/>
            <p:cNvSpPr/>
            <p:nvPr/>
          </p:nvSpPr>
          <p:spPr>
            <a:xfrm>
              <a:off x="1324432" y="4687379"/>
              <a:ext cx="614045" cy="45720"/>
            </a:xfrm>
            <a:custGeom>
              <a:avLst/>
              <a:gdLst/>
              <a:ahLst/>
              <a:cxnLst/>
              <a:rect l="l" t="t" r="r" b="b"/>
              <a:pathLst>
                <a:path w="614044" h="45720">
                  <a:moveTo>
                    <a:pt x="604367" y="4559"/>
                  </a:moveTo>
                  <a:lnTo>
                    <a:pt x="613498" y="4559"/>
                  </a:lnTo>
                  <a:lnTo>
                    <a:pt x="613498" y="45643"/>
                  </a:lnTo>
                  <a:lnTo>
                    <a:pt x="604367" y="45643"/>
                  </a:lnTo>
                  <a:lnTo>
                    <a:pt x="604367" y="4559"/>
                  </a:lnTo>
                  <a:close/>
                </a:path>
                <a:path w="614044" h="45720">
                  <a:moveTo>
                    <a:pt x="604367" y="45643"/>
                  </a:moveTo>
                  <a:lnTo>
                    <a:pt x="604367" y="4559"/>
                  </a:lnTo>
                  <a:lnTo>
                    <a:pt x="613498" y="4559"/>
                  </a:lnTo>
                  <a:lnTo>
                    <a:pt x="613498" y="45643"/>
                  </a:lnTo>
                  <a:lnTo>
                    <a:pt x="604367" y="45643"/>
                  </a:lnTo>
                  <a:close/>
                </a:path>
                <a:path w="614044" h="45720">
                  <a:moveTo>
                    <a:pt x="9131" y="45643"/>
                  </a:moveTo>
                  <a:lnTo>
                    <a:pt x="0" y="45643"/>
                  </a:lnTo>
                  <a:lnTo>
                    <a:pt x="0" y="4559"/>
                  </a:lnTo>
                  <a:lnTo>
                    <a:pt x="9131" y="4559"/>
                  </a:lnTo>
                  <a:lnTo>
                    <a:pt x="9131" y="45643"/>
                  </a:lnTo>
                  <a:close/>
                </a:path>
                <a:path w="614044" h="45720">
                  <a:moveTo>
                    <a:pt x="9131" y="4559"/>
                  </a:moveTo>
                  <a:lnTo>
                    <a:pt x="9131" y="45643"/>
                  </a:lnTo>
                  <a:lnTo>
                    <a:pt x="0" y="45643"/>
                  </a:lnTo>
                  <a:lnTo>
                    <a:pt x="0" y="4559"/>
                  </a:lnTo>
                  <a:lnTo>
                    <a:pt x="9131" y="4559"/>
                  </a:lnTo>
                  <a:close/>
                </a:path>
                <a:path w="614044" h="45720">
                  <a:moveTo>
                    <a:pt x="4571" y="0"/>
                  </a:moveTo>
                  <a:lnTo>
                    <a:pt x="608939" y="0"/>
                  </a:lnTo>
                  <a:lnTo>
                    <a:pt x="610463" y="0"/>
                  </a:lnTo>
                  <a:lnTo>
                    <a:pt x="611987" y="1511"/>
                  </a:lnTo>
                  <a:lnTo>
                    <a:pt x="613498" y="3035"/>
                  </a:lnTo>
                  <a:lnTo>
                    <a:pt x="613498" y="4559"/>
                  </a:lnTo>
                  <a:lnTo>
                    <a:pt x="613498" y="6083"/>
                  </a:lnTo>
                  <a:lnTo>
                    <a:pt x="611987" y="7594"/>
                  </a:lnTo>
                  <a:lnTo>
                    <a:pt x="610463" y="9118"/>
                  </a:lnTo>
                  <a:lnTo>
                    <a:pt x="608939" y="9118"/>
                  </a:lnTo>
                  <a:lnTo>
                    <a:pt x="4571" y="9118"/>
                  </a:lnTo>
                  <a:lnTo>
                    <a:pt x="3035" y="9118"/>
                  </a:lnTo>
                  <a:lnTo>
                    <a:pt x="1524" y="7594"/>
                  </a:lnTo>
                  <a:lnTo>
                    <a:pt x="0" y="6083"/>
                  </a:lnTo>
                  <a:lnTo>
                    <a:pt x="0" y="4559"/>
                  </a:lnTo>
                  <a:lnTo>
                    <a:pt x="0" y="3035"/>
                  </a:lnTo>
                  <a:lnTo>
                    <a:pt x="1524" y="1511"/>
                  </a:lnTo>
                  <a:lnTo>
                    <a:pt x="3035" y="0"/>
                  </a:lnTo>
                  <a:lnTo>
                    <a:pt x="4571" y="0"/>
                  </a:lnTo>
                  <a:close/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237" name="object 237"/>
          <p:cNvSpPr txBox="1"/>
          <p:nvPr/>
        </p:nvSpPr>
        <p:spPr>
          <a:xfrm>
            <a:off x="2834053" y="4533138"/>
            <a:ext cx="163195" cy="17716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1000" spc="-45">
                <a:latin typeface="Arial"/>
                <a:cs typeface="Arial"/>
              </a:rPr>
              <a:t>**</a:t>
            </a:r>
            <a:r>
              <a:rPr dirty="0" sz="1000" spc="-5">
                <a:latin typeface="Arial"/>
                <a:cs typeface="Arial"/>
              </a:rPr>
              <a:t>*</a:t>
            </a:r>
            <a:endParaRPr sz="1000">
              <a:latin typeface="Arial"/>
              <a:cs typeface="Arial"/>
            </a:endParaRPr>
          </a:p>
        </p:txBody>
      </p:sp>
      <p:grpSp>
        <p:nvGrpSpPr>
          <p:cNvPr id="238" name="object 238"/>
          <p:cNvGrpSpPr/>
          <p:nvPr/>
        </p:nvGrpSpPr>
        <p:grpSpPr>
          <a:xfrm>
            <a:off x="2605481" y="4689652"/>
            <a:ext cx="615315" cy="47625"/>
            <a:chOff x="2605481" y="4689652"/>
            <a:chExt cx="615315" cy="47625"/>
          </a:xfrm>
        </p:grpSpPr>
        <p:sp>
          <p:nvSpPr>
            <p:cNvPr id="239" name="object 239"/>
            <p:cNvSpPr/>
            <p:nvPr/>
          </p:nvSpPr>
          <p:spPr>
            <a:xfrm>
              <a:off x="2606243" y="4690414"/>
              <a:ext cx="614045" cy="45720"/>
            </a:xfrm>
            <a:custGeom>
              <a:avLst/>
              <a:gdLst/>
              <a:ahLst/>
              <a:cxnLst/>
              <a:rect l="l" t="t" r="r" b="b"/>
              <a:pathLst>
                <a:path w="614044" h="45720">
                  <a:moveTo>
                    <a:pt x="0" y="6083"/>
                  </a:moveTo>
                  <a:lnTo>
                    <a:pt x="0" y="45656"/>
                  </a:lnTo>
                  <a:lnTo>
                    <a:pt x="0" y="6083"/>
                  </a:lnTo>
                  <a:close/>
                </a:path>
                <a:path w="614044" h="45720">
                  <a:moveTo>
                    <a:pt x="12" y="6096"/>
                  </a:moveTo>
                  <a:lnTo>
                    <a:pt x="12" y="45656"/>
                  </a:lnTo>
                  <a:lnTo>
                    <a:pt x="9143" y="45656"/>
                  </a:lnTo>
                  <a:lnTo>
                    <a:pt x="9143" y="9131"/>
                  </a:lnTo>
                  <a:lnTo>
                    <a:pt x="3047" y="9131"/>
                  </a:lnTo>
                  <a:lnTo>
                    <a:pt x="12" y="6096"/>
                  </a:lnTo>
                  <a:close/>
                </a:path>
                <a:path w="614044" h="45720">
                  <a:moveTo>
                    <a:pt x="613511" y="4559"/>
                  </a:moveTo>
                  <a:lnTo>
                    <a:pt x="604380" y="4559"/>
                  </a:lnTo>
                  <a:lnTo>
                    <a:pt x="604380" y="45656"/>
                  </a:lnTo>
                  <a:lnTo>
                    <a:pt x="613511" y="45656"/>
                  </a:lnTo>
                  <a:lnTo>
                    <a:pt x="613511" y="9131"/>
                  </a:lnTo>
                  <a:lnTo>
                    <a:pt x="610476" y="9131"/>
                  </a:lnTo>
                  <a:lnTo>
                    <a:pt x="613498" y="6096"/>
                  </a:lnTo>
                  <a:lnTo>
                    <a:pt x="613511" y="4559"/>
                  </a:lnTo>
                  <a:close/>
                </a:path>
                <a:path w="614044" h="45720">
                  <a:moveTo>
                    <a:pt x="9143" y="4571"/>
                  </a:moveTo>
                  <a:lnTo>
                    <a:pt x="12" y="4571"/>
                  </a:lnTo>
                  <a:lnTo>
                    <a:pt x="12" y="6096"/>
                  </a:lnTo>
                  <a:lnTo>
                    <a:pt x="3047" y="9131"/>
                  </a:lnTo>
                  <a:lnTo>
                    <a:pt x="9143" y="9131"/>
                  </a:lnTo>
                  <a:lnTo>
                    <a:pt x="9143" y="4571"/>
                  </a:lnTo>
                  <a:close/>
                </a:path>
                <a:path w="614044" h="45720">
                  <a:moveTo>
                    <a:pt x="604380" y="4559"/>
                  </a:moveTo>
                  <a:lnTo>
                    <a:pt x="9143" y="4559"/>
                  </a:lnTo>
                  <a:lnTo>
                    <a:pt x="9143" y="9131"/>
                  </a:lnTo>
                  <a:lnTo>
                    <a:pt x="604380" y="9131"/>
                  </a:lnTo>
                  <a:lnTo>
                    <a:pt x="604380" y="4559"/>
                  </a:lnTo>
                  <a:close/>
                </a:path>
                <a:path w="614044" h="45720">
                  <a:moveTo>
                    <a:pt x="613511" y="6083"/>
                  </a:moveTo>
                  <a:lnTo>
                    <a:pt x="610476" y="9131"/>
                  </a:lnTo>
                  <a:lnTo>
                    <a:pt x="613511" y="9131"/>
                  </a:lnTo>
                  <a:lnTo>
                    <a:pt x="613511" y="6083"/>
                  </a:lnTo>
                  <a:close/>
                </a:path>
                <a:path w="614044" h="45720">
                  <a:moveTo>
                    <a:pt x="610476" y="0"/>
                  </a:moveTo>
                  <a:lnTo>
                    <a:pt x="3047" y="0"/>
                  </a:lnTo>
                  <a:lnTo>
                    <a:pt x="0" y="3047"/>
                  </a:lnTo>
                  <a:lnTo>
                    <a:pt x="12" y="6096"/>
                  </a:lnTo>
                  <a:lnTo>
                    <a:pt x="12" y="4571"/>
                  </a:lnTo>
                  <a:lnTo>
                    <a:pt x="9143" y="4571"/>
                  </a:lnTo>
                  <a:lnTo>
                    <a:pt x="613511" y="4559"/>
                  </a:lnTo>
                  <a:lnTo>
                    <a:pt x="613511" y="3047"/>
                  </a:lnTo>
                  <a:lnTo>
                    <a:pt x="610476" y="0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40" name="object 240"/>
            <p:cNvSpPr/>
            <p:nvPr/>
          </p:nvSpPr>
          <p:spPr>
            <a:xfrm>
              <a:off x="2606243" y="4690414"/>
              <a:ext cx="614045" cy="45720"/>
            </a:xfrm>
            <a:custGeom>
              <a:avLst/>
              <a:gdLst/>
              <a:ahLst/>
              <a:cxnLst/>
              <a:rect l="l" t="t" r="r" b="b"/>
              <a:pathLst>
                <a:path w="614044" h="45720">
                  <a:moveTo>
                    <a:pt x="604380" y="4559"/>
                  </a:moveTo>
                  <a:lnTo>
                    <a:pt x="613511" y="4559"/>
                  </a:lnTo>
                  <a:lnTo>
                    <a:pt x="613511" y="45643"/>
                  </a:lnTo>
                  <a:lnTo>
                    <a:pt x="604380" y="45643"/>
                  </a:lnTo>
                  <a:lnTo>
                    <a:pt x="604380" y="4559"/>
                  </a:lnTo>
                  <a:close/>
                </a:path>
                <a:path w="614044" h="45720">
                  <a:moveTo>
                    <a:pt x="604380" y="45656"/>
                  </a:moveTo>
                  <a:lnTo>
                    <a:pt x="604380" y="4559"/>
                  </a:lnTo>
                  <a:lnTo>
                    <a:pt x="613511" y="4559"/>
                  </a:lnTo>
                  <a:lnTo>
                    <a:pt x="613511" y="45656"/>
                  </a:lnTo>
                  <a:lnTo>
                    <a:pt x="604380" y="45656"/>
                  </a:lnTo>
                  <a:close/>
                </a:path>
                <a:path w="614044" h="45720">
                  <a:moveTo>
                    <a:pt x="9143" y="45656"/>
                  </a:moveTo>
                  <a:lnTo>
                    <a:pt x="12" y="45656"/>
                  </a:lnTo>
                  <a:lnTo>
                    <a:pt x="12" y="4571"/>
                  </a:lnTo>
                  <a:lnTo>
                    <a:pt x="9143" y="4571"/>
                  </a:lnTo>
                  <a:lnTo>
                    <a:pt x="9143" y="45656"/>
                  </a:lnTo>
                  <a:close/>
                </a:path>
                <a:path w="614044" h="45720">
                  <a:moveTo>
                    <a:pt x="9143" y="4559"/>
                  </a:moveTo>
                  <a:lnTo>
                    <a:pt x="9143" y="45656"/>
                  </a:lnTo>
                  <a:lnTo>
                    <a:pt x="0" y="45656"/>
                  </a:lnTo>
                  <a:lnTo>
                    <a:pt x="0" y="4559"/>
                  </a:lnTo>
                  <a:lnTo>
                    <a:pt x="9143" y="4559"/>
                  </a:lnTo>
                  <a:close/>
                </a:path>
                <a:path w="614044" h="45720">
                  <a:moveTo>
                    <a:pt x="4571" y="0"/>
                  </a:moveTo>
                  <a:lnTo>
                    <a:pt x="608952" y="0"/>
                  </a:lnTo>
                  <a:lnTo>
                    <a:pt x="610476" y="0"/>
                  </a:lnTo>
                  <a:lnTo>
                    <a:pt x="611987" y="1523"/>
                  </a:lnTo>
                  <a:lnTo>
                    <a:pt x="613511" y="3047"/>
                  </a:lnTo>
                  <a:lnTo>
                    <a:pt x="613511" y="4559"/>
                  </a:lnTo>
                  <a:lnTo>
                    <a:pt x="613511" y="6083"/>
                  </a:lnTo>
                  <a:lnTo>
                    <a:pt x="611987" y="7607"/>
                  </a:lnTo>
                  <a:lnTo>
                    <a:pt x="610476" y="9131"/>
                  </a:lnTo>
                  <a:lnTo>
                    <a:pt x="608952" y="9131"/>
                  </a:lnTo>
                  <a:lnTo>
                    <a:pt x="4571" y="9131"/>
                  </a:lnTo>
                  <a:lnTo>
                    <a:pt x="3047" y="9131"/>
                  </a:lnTo>
                  <a:lnTo>
                    <a:pt x="1524" y="7607"/>
                  </a:lnTo>
                  <a:lnTo>
                    <a:pt x="0" y="6083"/>
                  </a:lnTo>
                  <a:lnTo>
                    <a:pt x="0" y="4559"/>
                  </a:lnTo>
                  <a:lnTo>
                    <a:pt x="0" y="3047"/>
                  </a:lnTo>
                  <a:lnTo>
                    <a:pt x="1524" y="1523"/>
                  </a:lnTo>
                  <a:lnTo>
                    <a:pt x="3047" y="0"/>
                  </a:lnTo>
                  <a:lnTo>
                    <a:pt x="4571" y="0"/>
                  </a:lnTo>
                  <a:close/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  <p:pic>
        <p:nvPicPr>
          <p:cNvPr id="241" name="object 241"/>
          <p:cNvPicPr/>
          <p:nvPr/>
        </p:nvPicPr>
        <p:blipFill>
          <a:blip r:embed="rId22" cstate="print"/>
          <a:stretch>
            <a:fillRect/>
          </a:stretch>
        </p:blipFill>
        <p:spPr>
          <a:xfrm>
            <a:off x="4342922" y="5551594"/>
            <a:ext cx="2700959" cy="917600"/>
          </a:xfrm>
          <a:prstGeom prst="rect">
            <a:avLst/>
          </a:prstGeom>
        </p:spPr>
      </p:pic>
      <p:sp>
        <p:nvSpPr>
          <p:cNvPr id="242" name="object 242"/>
          <p:cNvSpPr txBox="1"/>
          <p:nvPr/>
        </p:nvSpPr>
        <p:spPr>
          <a:xfrm>
            <a:off x="4548994" y="6505129"/>
            <a:ext cx="431165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20" b="1">
                <a:latin typeface="Arial"/>
                <a:cs typeface="Arial"/>
              </a:rPr>
              <a:t>SHA</a:t>
            </a:r>
            <a:r>
              <a:rPr dirty="0" sz="1100" spc="-10" b="1">
                <a:latin typeface="Arial"/>
                <a:cs typeface="Arial"/>
              </a:rPr>
              <a:t>M</a:t>
            </a:r>
            <a:endParaRPr sz="1100">
              <a:latin typeface="Arial"/>
              <a:cs typeface="Arial"/>
            </a:endParaRPr>
          </a:p>
        </p:txBody>
      </p:sp>
      <p:sp>
        <p:nvSpPr>
          <p:cNvPr id="243" name="object 243"/>
          <p:cNvSpPr txBox="1"/>
          <p:nvPr/>
        </p:nvSpPr>
        <p:spPr>
          <a:xfrm>
            <a:off x="5295784" y="6505129"/>
            <a:ext cx="2044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I</a:t>
            </a:r>
            <a:r>
              <a:rPr dirty="0" sz="1100" spc="5" b="1">
                <a:latin typeface="Arial"/>
                <a:cs typeface="Arial"/>
              </a:rPr>
              <a:t>R</a:t>
            </a:r>
            <a:r>
              <a:rPr dirty="0" sz="1100" spc="-5" b="1">
                <a:latin typeface="Arial"/>
                <a:cs typeface="Arial"/>
              </a:rPr>
              <a:t>I</a:t>
            </a:r>
            <a:endParaRPr sz="1100">
              <a:latin typeface="Arial"/>
              <a:cs typeface="Arial"/>
            </a:endParaRPr>
          </a:p>
        </p:txBody>
      </p:sp>
      <p:sp>
        <p:nvSpPr>
          <p:cNvPr id="244" name="object 244"/>
          <p:cNvSpPr txBox="1"/>
          <p:nvPr/>
        </p:nvSpPr>
        <p:spPr>
          <a:xfrm>
            <a:off x="5814127" y="6505129"/>
            <a:ext cx="431165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20" b="1">
                <a:latin typeface="Arial"/>
                <a:cs typeface="Arial"/>
              </a:rPr>
              <a:t>SHA</a:t>
            </a:r>
            <a:r>
              <a:rPr dirty="0" sz="1100" spc="-10" b="1">
                <a:latin typeface="Arial"/>
                <a:cs typeface="Arial"/>
              </a:rPr>
              <a:t>M</a:t>
            </a:r>
            <a:endParaRPr sz="1100">
              <a:latin typeface="Arial"/>
              <a:cs typeface="Arial"/>
            </a:endParaRPr>
          </a:p>
        </p:txBody>
      </p:sp>
      <p:sp>
        <p:nvSpPr>
          <p:cNvPr id="245" name="object 245"/>
          <p:cNvSpPr txBox="1"/>
          <p:nvPr/>
        </p:nvSpPr>
        <p:spPr>
          <a:xfrm>
            <a:off x="6560918" y="6505129"/>
            <a:ext cx="2044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10" b="1">
                <a:latin typeface="Arial"/>
                <a:cs typeface="Arial"/>
              </a:rPr>
              <a:t>I</a:t>
            </a:r>
            <a:r>
              <a:rPr dirty="0" sz="1100" spc="5" b="1">
                <a:latin typeface="Arial"/>
                <a:cs typeface="Arial"/>
              </a:rPr>
              <a:t>R</a:t>
            </a:r>
            <a:r>
              <a:rPr dirty="0" sz="1100" spc="-5" b="1">
                <a:latin typeface="Arial"/>
                <a:cs typeface="Arial"/>
              </a:rPr>
              <a:t>I</a:t>
            </a:r>
            <a:endParaRPr sz="1100">
              <a:latin typeface="Arial"/>
              <a:cs typeface="Arial"/>
            </a:endParaRPr>
          </a:p>
        </p:txBody>
      </p:sp>
      <p:grpSp>
        <p:nvGrpSpPr>
          <p:cNvPr id="246" name="object 246"/>
          <p:cNvGrpSpPr/>
          <p:nvPr/>
        </p:nvGrpSpPr>
        <p:grpSpPr>
          <a:xfrm>
            <a:off x="4279601" y="4611098"/>
            <a:ext cx="2826385" cy="1908810"/>
            <a:chOff x="4279601" y="4611098"/>
            <a:chExt cx="2826385" cy="1908810"/>
          </a:xfrm>
        </p:grpSpPr>
        <p:sp>
          <p:nvSpPr>
            <p:cNvPr id="247" name="object 247"/>
            <p:cNvSpPr/>
            <p:nvPr/>
          </p:nvSpPr>
          <p:spPr>
            <a:xfrm>
              <a:off x="4334532" y="6455497"/>
              <a:ext cx="2762250" cy="0"/>
            </a:xfrm>
            <a:custGeom>
              <a:avLst/>
              <a:gdLst/>
              <a:ahLst/>
              <a:cxnLst/>
              <a:rect l="l" t="t" r="r" b="b"/>
              <a:pathLst>
                <a:path w="2762250" h="0">
                  <a:moveTo>
                    <a:pt x="0" y="0"/>
                  </a:moveTo>
                  <a:lnTo>
                    <a:pt x="2761945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48" name="object 248"/>
            <p:cNvSpPr/>
            <p:nvPr/>
          </p:nvSpPr>
          <p:spPr>
            <a:xfrm>
              <a:off x="4764373" y="6455502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w="0" h="55245">
                  <a:moveTo>
                    <a:pt x="0" y="54775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49" name="object 249"/>
            <p:cNvSpPr/>
            <p:nvPr/>
          </p:nvSpPr>
          <p:spPr>
            <a:xfrm>
              <a:off x="5396942" y="6455502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w="0" h="55245">
                  <a:moveTo>
                    <a:pt x="0" y="54775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50" name="object 250"/>
            <p:cNvSpPr/>
            <p:nvPr/>
          </p:nvSpPr>
          <p:spPr>
            <a:xfrm>
              <a:off x="6029499" y="6455502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w="0" h="55245">
                  <a:moveTo>
                    <a:pt x="0" y="54775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51" name="object 251"/>
            <p:cNvSpPr/>
            <p:nvPr/>
          </p:nvSpPr>
          <p:spPr>
            <a:xfrm>
              <a:off x="6662055" y="6455502"/>
              <a:ext cx="0" cy="55244"/>
            </a:xfrm>
            <a:custGeom>
              <a:avLst/>
              <a:gdLst/>
              <a:ahLst/>
              <a:cxnLst/>
              <a:rect l="l" t="t" r="r" b="b"/>
              <a:pathLst>
                <a:path w="0" h="55245">
                  <a:moveTo>
                    <a:pt x="0" y="54775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52" name="object 252"/>
            <p:cNvSpPr/>
            <p:nvPr/>
          </p:nvSpPr>
          <p:spPr>
            <a:xfrm>
              <a:off x="4343685" y="4620305"/>
              <a:ext cx="0" cy="1844675"/>
            </a:xfrm>
            <a:custGeom>
              <a:avLst/>
              <a:gdLst/>
              <a:ahLst/>
              <a:cxnLst/>
              <a:rect l="l" t="t" r="r" b="b"/>
              <a:pathLst>
                <a:path w="0" h="1844675">
                  <a:moveTo>
                    <a:pt x="0" y="1844319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53" name="object 253"/>
            <p:cNvSpPr/>
            <p:nvPr/>
          </p:nvSpPr>
          <p:spPr>
            <a:xfrm>
              <a:off x="4288809" y="6090285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5" h="0">
                  <a:moveTo>
                    <a:pt x="54876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54" name="object 254"/>
            <p:cNvSpPr/>
            <p:nvPr/>
          </p:nvSpPr>
          <p:spPr>
            <a:xfrm>
              <a:off x="4288809" y="5725073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5" h="0">
                  <a:moveTo>
                    <a:pt x="54876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55" name="object 255"/>
            <p:cNvSpPr/>
            <p:nvPr/>
          </p:nvSpPr>
          <p:spPr>
            <a:xfrm>
              <a:off x="4288809" y="5359862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5" h="0">
                  <a:moveTo>
                    <a:pt x="54876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56" name="object 256"/>
            <p:cNvSpPr/>
            <p:nvPr/>
          </p:nvSpPr>
          <p:spPr>
            <a:xfrm>
              <a:off x="4288809" y="4994656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5" h="0">
                  <a:moveTo>
                    <a:pt x="54876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57" name="object 257"/>
            <p:cNvSpPr/>
            <p:nvPr/>
          </p:nvSpPr>
          <p:spPr>
            <a:xfrm>
              <a:off x="4288809" y="4629444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5" h="0">
                  <a:moveTo>
                    <a:pt x="54876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58" name="object 258"/>
            <p:cNvSpPr/>
            <p:nvPr/>
          </p:nvSpPr>
          <p:spPr>
            <a:xfrm>
              <a:off x="4288809" y="6455497"/>
              <a:ext cx="55244" cy="0"/>
            </a:xfrm>
            <a:custGeom>
              <a:avLst/>
              <a:gdLst/>
              <a:ahLst/>
              <a:cxnLst/>
              <a:rect l="l" t="t" r="r" b="b"/>
              <a:pathLst>
                <a:path w="55245" h="0">
                  <a:moveTo>
                    <a:pt x="54876" y="0"/>
                  </a:moveTo>
                  <a:lnTo>
                    <a:pt x="0" y="0"/>
                  </a:lnTo>
                </a:path>
              </a:pathLst>
            </a:custGeom>
            <a:ln w="18262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59" name="object 259"/>
            <p:cNvSpPr/>
            <p:nvPr/>
          </p:nvSpPr>
          <p:spPr>
            <a:xfrm>
              <a:off x="6662055" y="5413130"/>
              <a:ext cx="0" cy="139065"/>
            </a:xfrm>
            <a:custGeom>
              <a:avLst/>
              <a:gdLst/>
              <a:ahLst/>
              <a:cxnLst/>
              <a:rect l="l" t="t" r="r" b="b"/>
              <a:pathLst>
                <a:path w="0" h="139064">
                  <a:moveTo>
                    <a:pt x="0" y="0"/>
                  </a:moveTo>
                  <a:lnTo>
                    <a:pt x="0" y="138468"/>
                  </a:lnTo>
                </a:path>
              </a:pathLst>
            </a:custGeom>
            <a:ln w="9131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60" name="object 260"/>
            <p:cNvSpPr/>
            <p:nvPr/>
          </p:nvSpPr>
          <p:spPr>
            <a:xfrm>
              <a:off x="6662055" y="5551601"/>
              <a:ext cx="0" cy="137160"/>
            </a:xfrm>
            <a:custGeom>
              <a:avLst/>
              <a:gdLst/>
              <a:ahLst/>
              <a:cxnLst/>
              <a:rect l="l" t="t" r="r" b="b"/>
              <a:pathLst>
                <a:path w="0" h="137160">
                  <a:moveTo>
                    <a:pt x="0" y="0"/>
                  </a:moveTo>
                  <a:lnTo>
                    <a:pt x="0" y="136956"/>
                  </a:lnTo>
                </a:path>
              </a:pathLst>
            </a:custGeom>
            <a:ln w="9131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61" name="object 261"/>
            <p:cNvSpPr/>
            <p:nvPr/>
          </p:nvSpPr>
          <p:spPr>
            <a:xfrm>
              <a:off x="6556883" y="5413130"/>
              <a:ext cx="210820" cy="0"/>
            </a:xfrm>
            <a:custGeom>
              <a:avLst/>
              <a:gdLst/>
              <a:ahLst/>
              <a:cxnLst/>
              <a:rect l="l" t="t" r="r" b="b"/>
              <a:pathLst>
                <a:path w="210820" h="0">
                  <a:moveTo>
                    <a:pt x="0" y="0"/>
                  </a:moveTo>
                  <a:lnTo>
                    <a:pt x="210337" y="0"/>
                  </a:lnTo>
                </a:path>
              </a:pathLst>
            </a:custGeom>
            <a:ln w="9131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62" name="object 262"/>
            <p:cNvSpPr/>
            <p:nvPr/>
          </p:nvSpPr>
          <p:spPr>
            <a:xfrm>
              <a:off x="6556883" y="5688561"/>
              <a:ext cx="210820" cy="0"/>
            </a:xfrm>
            <a:custGeom>
              <a:avLst/>
              <a:gdLst/>
              <a:ahLst/>
              <a:cxnLst/>
              <a:rect l="l" t="t" r="r" b="b"/>
              <a:pathLst>
                <a:path w="210820" h="0">
                  <a:moveTo>
                    <a:pt x="0" y="0"/>
                  </a:moveTo>
                  <a:lnTo>
                    <a:pt x="210337" y="0"/>
                  </a:lnTo>
                </a:path>
              </a:pathLst>
            </a:custGeom>
            <a:ln w="9131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63" name="object 263"/>
            <p:cNvSpPr/>
            <p:nvPr/>
          </p:nvSpPr>
          <p:spPr>
            <a:xfrm>
              <a:off x="6625480" y="5662690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59" h="73660">
                  <a:moveTo>
                    <a:pt x="73164" y="0"/>
                  </a:moveTo>
                  <a:lnTo>
                    <a:pt x="0" y="0"/>
                  </a:lnTo>
                  <a:lnTo>
                    <a:pt x="36576" y="73037"/>
                  </a:lnTo>
                  <a:lnTo>
                    <a:pt x="73164" y="0"/>
                  </a:lnTo>
                  <a:close/>
                </a:path>
              </a:pathLst>
            </a:custGeom>
            <a:solidFill>
              <a:srgbClr val="1349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64" name="object 264"/>
            <p:cNvSpPr/>
            <p:nvPr/>
          </p:nvSpPr>
          <p:spPr>
            <a:xfrm>
              <a:off x="6625480" y="5662690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59" h="73660">
                  <a:moveTo>
                    <a:pt x="0" y="0"/>
                  </a:moveTo>
                  <a:lnTo>
                    <a:pt x="73164" y="0"/>
                  </a:lnTo>
                  <a:lnTo>
                    <a:pt x="36576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265" name="object 265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6624718" y="4960414"/>
              <a:ext cx="74688" cy="74561"/>
            </a:xfrm>
            <a:prstGeom prst="rect">
              <a:avLst/>
            </a:prstGeom>
          </p:spPr>
        </p:pic>
        <p:pic>
          <p:nvPicPr>
            <p:cNvPr id="266" name="object 266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6450949" y="5591929"/>
              <a:ext cx="74688" cy="74561"/>
            </a:xfrm>
            <a:prstGeom prst="rect">
              <a:avLst/>
            </a:prstGeom>
          </p:spPr>
        </p:pic>
        <p:pic>
          <p:nvPicPr>
            <p:cNvPr id="267" name="object 26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6624718" y="5217583"/>
              <a:ext cx="74688" cy="74561"/>
            </a:xfrm>
            <a:prstGeom prst="rect">
              <a:avLst/>
            </a:prstGeom>
          </p:spPr>
        </p:pic>
        <p:sp>
          <p:nvSpPr>
            <p:cNvPr id="268" name="object 268"/>
            <p:cNvSpPr/>
            <p:nvPr/>
          </p:nvSpPr>
          <p:spPr>
            <a:xfrm>
              <a:off x="6625480" y="5417694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59" h="73660">
                  <a:moveTo>
                    <a:pt x="73164" y="0"/>
                  </a:moveTo>
                  <a:lnTo>
                    <a:pt x="0" y="0"/>
                  </a:lnTo>
                  <a:lnTo>
                    <a:pt x="36576" y="73037"/>
                  </a:lnTo>
                  <a:lnTo>
                    <a:pt x="73164" y="0"/>
                  </a:lnTo>
                  <a:close/>
                </a:path>
              </a:pathLst>
            </a:custGeom>
            <a:solidFill>
              <a:srgbClr val="1349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69" name="object 269"/>
            <p:cNvSpPr/>
            <p:nvPr/>
          </p:nvSpPr>
          <p:spPr>
            <a:xfrm>
              <a:off x="6625480" y="5417694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59" h="73660">
                  <a:moveTo>
                    <a:pt x="0" y="0"/>
                  </a:moveTo>
                  <a:lnTo>
                    <a:pt x="73164" y="0"/>
                  </a:lnTo>
                  <a:lnTo>
                    <a:pt x="36576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13499F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270" name="object 270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6624718" y="6107792"/>
              <a:ext cx="74688" cy="74561"/>
            </a:xfrm>
            <a:prstGeom prst="rect">
              <a:avLst/>
            </a:prstGeom>
          </p:spPr>
        </p:pic>
        <p:pic>
          <p:nvPicPr>
            <p:cNvPr id="271" name="object 271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6798475" y="5640621"/>
              <a:ext cx="74688" cy="74561"/>
            </a:xfrm>
            <a:prstGeom prst="rect">
              <a:avLst/>
            </a:prstGeom>
          </p:spPr>
        </p:pic>
        <p:pic>
          <p:nvPicPr>
            <p:cNvPr id="272" name="object 272"/>
            <p:cNvPicPr/>
            <p:nvPr/>
          </p:nvPicPr>
          <p:blipFill>
            <a:blip r:embed="rId23" cstate="print"/>
            <a:stretch>
              <a:fillRect/>
            </a:stretch>
          </p:blipFill>
          <p:spPr>
            <a:xfrm>
              <a:off x="5818391" y="6016486"/>
              <a:ext cx="422214" cy="136958"/>
            </a:xfrm>
            <a:prstGeom prst="rect">
              <a:avLst/>
            </a:prstGeom>
          </p:spPr>
        </p:pic>
        <p:sp>
          <p:nvSpPr>
            <p:cNvPr id="273" name="object 273"/>
            <p:cNvSpPr/>
            <p:nvPr/>
          </p:nvSpPr>
          <p:spPr>
            <a:xfrm>
              <a:off x="5396942" y="5807251"/>
              <a:ext cx="0" cy="22860"/>
            </a:xfrm>
            <a:custGeom>
              <a:avLst/>
              <a:gdLst/>
              <a:ahLst/>
              <a:cxnLst/>
              <a:rect l="l" t="t" r="r" b="b"/>
              <a:pathLst>
                <a:path w="0" h="22860">
                  <a:moveTo>
                    <a:pt x="0" y="0"/>
                  </a:moveTo>
                  <a:lnTo>
                    <a:pt x="0" y="22821"/>
                  </a:lnTo>
                </a:path>
              </a:pathLst>
            </a:custGeom>
            <a:ln w="9131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74" name="object 274"/>
            <p:cNvSpPr/>
            <p:nvPr/>
          </p:nvSpPr>
          <p:spPr>
            <a:xfrm>
              <a:off x="5396942" y="5830072"/>
              <a:ext cx="0" cy="21590"/>
            </a:xfrm>
            <a:custGeom>
              <a:avLst/>
              <a:gdLst/>
              <a:ahLst/>
              <a:cxnLst/>
              <a:rect l="l" t="t" r="r" b="b"/>
              <a:pathLst>
                <a:path w="0" h="21589">
                  <a:moveTo>
                    <a:pt x="0" y="0"/>
                  </a:moveTo>
                  <a:lnTo>
                    <a:pt x="0" y="21310"/>
                  </a:lnTo>
                </a:path>
              </a:pathLst>
            </a:custGeom>
            <a:ln w="9131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75" name="object 275"/>
            <p:cNvSpPr/>
            <p:nvPr/>
          </p:nvSpPr>
          <p:spPr>
            <a:xfrm>
              <a:off x="5291757" y="5807251"/>
              <a:ext cx="210820" cy="0"/>
            </a:xfrm>
            <a:custGeom>
              <a:avLst/>
              <a:gdLst/>
              <a:ahLst/>
              <a:cxnLst/>
              <a:rect l="l" t="t" r="r" b="b"/>
              <a:pathLst>
                <a:path w="210820" h="0">
                  <a:moveTo>
                    <a:pt x="0" y="0"/>
                  </a:moveTo>
                  <a:lnTo>
                    <a:pt x="210350" y="0"/>
                  </a:lnTo>
                </a:path>
              </a:pathLst>
            </a:custGeom>
            <a:ln w="9131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76" name="object 276"/>
            <p:cNvSpPr/>
            <p:nvPr/>
          </p:nvSpPr>
          <p:spPr>
            <a:xfrm>
              <a:off x="5291757" y="5851379"/>
              <a:ext cx="210820" cy="0"/>
            </a:xfrm>
            <a:custGeom>
              <a:avLst/>
              <a:gdLst/>
              <a:ahLst/>
              <a:cxnLst/>
              <a:rect l="l" t="t" r="r" b="b"/>
              <a:pathLst>
                <a:path w="210820" h="0">
                  <a:moveTo>
                    <a:pt x="0" y="0"/>
                  </a:moveTo>
                  <a:lnTo>
                    <a:pt x="210350" y="0"/>
                  </a:lnTo>
                </a:path>
              </a:pathLst>
            </a:custGeom>
            <a:ln w="9131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77" name="object 277"/>
            <p:cNvSpPr/>
            <p:nvPr/>
          </p:nvSpPr>
          <p:spPr>
            <a:xfrm>
              <a:off x="5360352" y="5747905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164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164" y="73037"/>
                  </a:lnTo>
                  <a:lnTo>
                    <a:pt x="73164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78" name="object 278"/>
            <p:cNvSpPr/>
            <p:nvPr/>
          </p:nvSpPr>
          <p:spPr>
            <a:xfrm>
              <a:off x="5360352" y="5747905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164" y="0"/>
                  </a:lnTo>
                  <a:lnTo>
                    <a:pt x="73164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79" name="object 279"/>
            <p:cNvSpPr/>
            <p:nvPr/>
          </p:nvSpPr>
          <p:spPr>
            <a:xfrm>
              <a:off x="5534113" y="5767692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177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177" y="73037"/>
                  </a:lnTo>
                  <a:lnTo>
                    <a:pt x="73177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80" name="object 280"/>
            <p:cNvSpPr/>
            <p:nvPr/>
          </p:nvSpPr>
          <p:spPr>
            <a:xfrm>
              <a:off x="5534113" y="5767692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177" y="0"/>
                  </a:lnTo>
                  <a:lnTo>
                    <a:pt x="73177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81" name="object 281"/>
            <p:cNvSpPr/>
            <p:nvPr/>
          </p:nvSpPr>
          <p:spPr>
            <a:xfrm>
              <a:off x="5273471" y="5846813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164" y="0"/>
                  </a:moveTo>
                  <a:lnTo>
                    <a:pt x="0" y="0"/>
                  </a:lnTo>
                  <a:lnTo>
                    <a:pt x="0" y="73037"/>
                  </a:lnTo>
                  <a:lnTo>
                    <a:pt x="73164" y="73037"/>
                  </a:lnTo>
                  <a:lnTo>
                    <a:pt x="73164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82" name="object 282"/>
            <p:cNvSpPr/>
            <p:nvPr/>
          </p:nvSpPr>
          <p:spPr>
            <a:xfrm>
              <a:off x="5273471" y="5846813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164" y="0"/>
                  </a:lnTo>
                  <a:lnTo>
                    <a:pt x="73164" y="73037"/>
                  </a:lnTo>
                  <a:lnTo>
                    <a:pt x="0" y="73037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83" name="object 283"/>
            <p:cNvSpPr/>
            <p:nvPr/>
          </p:nvSpPr>
          <p:spPr>
            <a:xfrm>
              <a:off x="5186591" y="5755513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177" y="0"/>
                  </a:moveTo>
                  <a:lnTo>
                    <a:pt x="0" y="0"/>
                  </a:lnTo>
                  <a:lnTo>
                    <a:pt x="0" y="73050"/>
                  </a:lnTo>
                  <a:lnTo>
                    <a:pt x="73177" y="73050"/>
                  </a:lnTo>
                  <a:lnTo>
                    <a:pt x="73177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84" name="object 284"/>
            <p:cNvSpPr/>
            <p:nvPr/>
          </p:nvSpPr>
          <p:spPr>
            <a:xfrm>
              <a:off x="5186591" y="5755513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177" y="0"/>
                  </a:lnTo>
                  <a:lnTo>
                    <a:pt x="73177" y="73050"/>
                  </a:lnTo>
                  <a:lnTo>
                    <a:pt x="0" y="73050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85" name="object 285"/>
            <p:cNvSpPr/>
            <p:nvPr/>
          </p:nvSpPr>
          <p:spPr>
            <a:xfrm>
              <a:off x="5447233" y="5845289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164" y="0"/>
                  </a:moveTo>
                  <a:lnTo>
                    <a:pt x="0" y="0"/>
                  </a:lnTo>
                  <a:lnTo>
                    <a:pt x="0" y="73050"/>
                  </a:lnTo>
                  <a:lnTo>
                    <a:pt x="73164" y="73050"/>
                  </a:lnTo>
                  <a:lnTo>
                    <a:pt x="73164" y="0"/>
                  </a:lnTo>
                  <a:close/>
                </a:path>
              </a:pathLst>
            </a:custGeom>
            <a:solidFill>
              <a:srgbClr val="3A77B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86" name="object 286"/>
            <p:cNvSpPr/>
            <p:nvPr/>
          </p:nvSpPr>
          <p:spPr>
            <a:xfrm>
              <a:off x="5447233" y="5845289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0" y="0"/>
                  </a:moveTo>
                  <a:lnTo>
                    <a:pt x="73164" y="0"/>
                  </a:lnTo>
                  <a:lnTo>
                    <a:pt x="73164" y="73050"/>
                  </a:lnTo>
                  <a:lnTo>
                    <a:pt x="0" y="73050"/>
                  </a:lnTo>
                  <a:lnTo>
                    <a:pt x="0" y="0"/>
                  </a:lnTo>
                  <a:close/>
                </a:path>
              </a:pathLst>
            </a:custGeom>
            <a:ln w="3175">
              <a:solidFill>
                <a:srgbClr val="3A77B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87" name="object 287"/>
            <p:cNvSpPr/>
            <p:nvPr/>
          </p:nvSpPr>
          <p:spPr>
            <a:xfrm>
              <a:off x="4764373" y="5977684"/>
              <a:ext cx="0" cy="94615"/>
            </a:xfrm>
            <a:custGeom>
              <a:avLst/>
              <a:gdLst/>
              <a:ahLst/>
              <a:cxnLst/>
              <a:rect l="l" t="t" r="r" b="b"/>
              <a:pathLst>
                <a:path w="0" h="94614">
                  <a:moveTo>
                    <a:pt x="0" y="0"/>
                  </a:moveTo>
                  <a:lnTo>
                    <a:pt x="0" y="94348"/>
                  </a:lnTo>
                </a:path>
              </a:pathLst>
            </a:custGeom>
            <a:ln w="9131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88" name="object 288"/>
            <p:cNvSpPr/>
            <p:nvPr/>
          </p:nvSpPr>
          <p:spPr>
            <a:xfrm>
              <a:off x="4764373" y="6072028"/>
              <a:ext cx="0" cy="95885"/>
            </a:xfrm>
            <a:custGeom>
              <a:avLst/>
              <a:gdLst/>
              <a:ahLst/>
              <a:cxnLst/>
              <a:rect l="l" t="t" r="r" b="b"/>
              <a:pathLst>
                <a:path w="0" h="95885">
                  <a:moveTo>
                    <a:pt x="0" y="0"/>
                  </a:moveTo>
                  <a:lnTo>
                    <a:pt x="0" y="95872"/>
                  </a:lnTo>
                </a:path>
              </a:pathLst>
            </a:custGeom>
            <a:ln w="9131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89" name="object 289"/>
            <p:cNvSpPr/>
            <p:nvPr/>
          </p:nvSpPr>
          <p:spPr>
            <a:xfrm>
              <a:off x="4659200" y="5977684"/>
              <a:ext cx="210820" cy="0"/>
            </a:xfrm>
            <a:custGeom>
              <a:avLst/>
              <a:gdLst/>
              <a:ahLst/>
              <a:cxnLst/>
              <a:rect l="l" t="t" r="r" b="b"/>
              <a:pathLst>
                <a:path w="210820" h="0">
                  <a:moveTo>
                    <a:pt x="0" y="0"/>
                  </a:moveTo>
                  <a:lnTo>
                    <a:pt x="210337" y="0"/>
                  </a:lnTo>
                </a:path>
              </a:pathLst>
            </a:custGeom>
            <a:ln w="9131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90" name="object 290"/>
            <p:cNvSpPr/>
            <p:nvPr/>
          </p:nvSpPr>
          <p:spPr>
            <a:xfrm>
              <a:off x="4659200" y="6167899"/>
              <a:ext cx="210820" cy="0"/>
            </a:xfrm>
            <a:custGeom>
              <a:avLst/>
              <a:gdLst/>
              <a:ahLst/>
              <a:cxnLst/>
              <a:rect l="l" t="t" r="r" b="b"/>
              <a:pathLst>
                <a:path w="210820" h="0">
                  <a:moveTo>
                    <a:pt x="0" y="0"/>
                  </a:moveTo>
                  <a:lnTo>
                    <a:pt x="210337" y="0"/>
                  </a:lnTo>
                </a:path>
              </a:pathLst>
            </a:custGeom>
            <a:ln w="9131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291" name="object 291"/>
            <p:cNvPicPr/>
            <p:nvPr/>
          </p:nvPicPr>
          <p:blipFill>
            <a:blip r:embed="rId24" cstate="print"/>
            <a:stretch>
              <a:fillRect/>
            </a:stretch>
          </p:blipFill>
          <p:spPr>
            <a:xfrm>
              <a:off x="4727032" y="5693876"/>
              <a:ext cx="74688" cy="74574"/>
            </a:xfrm>
            <a:prstGeom prst="rect">
              <a:avLst/>
            </a:prstGeom>
          </p:spPr>
        </p:pic>
        <p:sp>
          <p:nvSpPr>
            <p:cNvPr id="292" name="object 292"/>
            <p:cNvSpPr/>
            <p:nvPr/>
          </p:nvSpPr>
          <p:spPr>
            <a:xfrm>
              <a:off x="4727794" y="6002030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39624" y="0"/>
                  </a:moveTo>
                  <a:lnTo>
                    <a:pt x="33528" y="0"/>
                  </a:lnTo>
                  <a:lnTo>
                    <a:pt x="28968" y="1523"/>
                  </a:lnTo>
                  <a:lnTo>
                    <a:pt x="22860" y="3035"/>
                  </a:lnTo>
                  <a:lnTo>
                    <a:pt x="1511" y="28905"/>
                  </a:lnTo>
                  <a:lnTo>
                    <a:pt x="0" y="33477"/>
                  </a:lnTo>
                  <a:lnTo>
                    <a:pt x="0" y="39560"/>
                  </a:lnTo>
                  <a:lnTo>
                    <a:pt x="1511" y="44132"/>
                  </a:lnTo>
                  <a:lnTo>
                    <a:pt x="3048" y="50215"/>
                  </a:lnTo>
                  <a:lnTo>
                    <a:pt x="6096" y="56311"/>
                  </a:lnTo>
                  <a:lnTo>
                    <a:pt x="10668" y="62382"/>
                  </a:lnTo>
                  <a:lnTo>
                    <a:pt x="16764" y="66954"/>
                  </a:lnTo>
                  <a:lnTo>
                    <a:pt x="28968" y="73037"/>
                  </a:lnTo>
                  <a:lnTo>
                    <a:pt x="44208" y="73037"/>
                  </a:lnTo>
                  <a:lnTo>
                    <a:pt x="56400" y="66954"/>
                  </a:lnTo>
                  <a:lnTo>
                    <a:pt x="62484" y="62382"/>
                  </a:lnTo>
                  <a:lnTo>
                    <a:pt x="67068" y="56311"/>
                  </a:lnTo>
                  <a:lnTo>
                    <a:pt x="73164" y="44132"/>
                  </a:lnTo>
                  <a:lnTo>
                    <a:pt x="73164" y="36525"/>
                  </a:lnTo>
                  <a:lnTo>
                    <a:pt x="73164" y="28905"/>
                  </a:lnTo>
                  <a:lnTo>
                    <a:pt x="44208" y="1523"/>
                  </a:lnTo>
                  <a:lnTo>
                    <a:pt x="39624" y="0"/>
                  </a:lnTo>
                  <a:close/>
                </a:path>
              </a:pathLst>
            </a:custGeom>
            <a:solidFill>
              <a:srgbClr val="EE332E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93" name="object 293"/>
            <p:cNvSpPr/>
            <p:nvPr/>
          </p:nvSpPr>
          <p:spPr>
            <a:xfrm>
              <a:off x="4727794" y="6002030"/>
              <a:ext cx="73660" cy="73660"/>
            </a:xfrm>
            <a:custGeom>
              <a:avLst/>
              <a:gdLst/>
              <a:ahLst/>
              <a:cxnLst/>
              <a:rect l="l" t="t" r="r" b="b"/>
              <a:pathLst>
                <a:path w="73660" h="73660">
                  <a:moveTo>
                    <a:pt x="73164" y="36525"/>
                  </a:moveTo>
                  <a:lnTo>
                    <a:pt x="73164" y="44132"/>
                  </a:lnTo>
                  <a:lnTo>
                    <a:pt x="70116" y="50215"/>
                  </a:lnTo>
                  <a:lnTo>
                    <a:pt x="67068" y="56311"/>
                  </a:lnTo>
                  <a:lnTo>
                    <a:pt x="62484" y="62382"/>
                  </a:lnTo>
                  <a:lnTo>
                    <a:pt x="56400" y="66954"/>
                  </a:lnTo>
                  <a:lnTo>
                    <a:pt x="50292" y="70002"/>
                  </a:lnTo>
                  <a:lnTo>
                    <a:pt x="44208" y="73037"/>
                  </a:lnTo>
                  <a:lnTo>
                    <a:pt x="36576" y="73037"/>
                  </a:lnTo>
                  <a:lnTo>
                    <a:pt x="28968" y="73037"/>
                  </a:lnTo>
                  <a:lnTo>
                    <a:pt x="1511" y="44132"/>
                  </a:lnTo>
                  <a:lnTo>
                    <a:pt x="0" y="39560"/>
                  </a:lnTo>
                  <a:lnTo>
                    <a:pt x="0" y="36525"/>
                  </a:lnTo>
                  <a:lnTo>
                    <a:pt x="0" y="33477"/>
                  </a:lnTo>
                  <a:lnTo>
                    <a:pt x="1511" y="28905"/>
                  </a:lnTo>
                  <a:lnTo>
                    <a:pt x="28968" y="1523"/>
                  </a:lnTo>
                  <a:lnTo>
                    <a:pt x="33528" y="0"/>
                  </a:lnTo>
                  <a:lnTo>
                    <a:pt x="36576" y="0"/>
                  </a:lnTo>
                  <a:lnTo>
                    <a:pt x="39624" y="0"/>
                  </a:lnTo>
                  <a:lnTo>
                    <a:pt x="44208" y="1523"/>
                  </a:lnTo>
                  <a:lnTo>
                    <a:pt x="70116" y="22821"/>
                  </a:lnTo>
                  <a:lnTo>
                    <a:pt x="73164" y="28905"/>
                  </a:lnTo>
                  <a:lnTo>
                    <a:pt x="73164" y="36525"/>
                  </a:lnTo>
                </a:path>
              </a:pathLst>
            </a:custGeom>
            <a:ln w="3175">
              <a:solidFill>
                <a:srgbClr val="EE332E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294" name="object 294"/>
            <p:cNvPicPr/>
            <p:nvPr/>
          </p:nvPicPr>
          <p:blipFill>
            <a:blip r:embed="rId25" cstate="print"/>
            <a:stretch>
              <a:fillRect/>
            </a:stretch>
          </p:blipFill>
          <p:spPr>
            <a:xfrm>
              <a:off x="4727032" y="5832360"/>
              <a:ext cx="74688" cy="74561"/>
            </a:xfrm>
            <a:prstGeom prst="rect">
              <a:avLst/>
            </a:prstGeom>
          </p:spPr>
        </p:pic>
        <p:pic>
          <p:nvPicPr>
            <p:cNvPr id="295" name="object 295"/>
            <p:cNvPicPr/>
            <p:nvPr/>
          </p:nvPicPr>
          <p:blipFill>
            <a:blip r:embed="rId26" cstate="print"/>
            <a:stretch>
              <a:fillRect/>
            </a:stretch>
          </p:blipFill>
          <p:spPr>
            <a:xfrm>
              <a:off x="4900790" y="6228007"/>
              <a:ext cx="74688" cy="74561"/>
            </a:xfrm>
            <a:prstGeom prst="rect">
              <a:avLst/>
            </a:prstGeom>
          </p:spPr>
        </p:pic>
        <p:pic>
          <p:nvPicPr>
            <p:cNvPr id="296" name="object 296"/>
            <p:cNvPicPr/>
            <p:nvPr/>
          </p:nvPicPr>
          <p:blipFill>
            <a:blip r:embed="rId27" cstate="print"/>
            <a:stretch>
              <a:fillRect/>
            </a:stretch>
          </p:blipFill>
          <p:spPr>
            <a:xfrm>
              <a:off x="4727032" y="6193009"/>
              <a:ext cx="74688" cy="74561"/>
            </a:xfrm>
            <a:prstGeom prst="rect">
              <a:avLst/>
            </a:prstGeom>
          </p:spPr>
        </p:pic>
        <p:pic>
          <p:nvPicPr>
            <p:cNvPr id="297" name="object 297"/>
            <p:cNvPicPr/>
            <p:nvPr/>
          </p:nvPicPr>
          <p:blipFill>
            <a:blip r:embed="rId28" cstate="print"/>
            <a:stretch>
              <a:fillRect/>
            </a:stretch>
          </p:blipFill>
          <p:spPr>
            <a:xfrm>
              <a:off x="4553263" y="6264520"/>
              <a:ext cx="74688" cy="74574"/>
            </a:xfrm>
            <a:prstGeom prst="rect">
              <a:avLst/>
            </a:prstGeom>
          </p:spPr>
        </p:pic>
      </p:grpSp>
      <p:sp>
        <p:nvSpPr>
          <p:cNvPr id="298" name="object 298"/>
          <p:cNvSpPr txBox="1"/>
          <p:nvPr/>
        </p:nvSpPr>
        <p:spPr>
          <a:xfrm>
            <a:off x="4180098" y="6354515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5" b="1">
                <a:latin typeface="Arial"/>
                <a:cs typeface="Arial"/>
              </a:rPr>
              <a:t>0</a:t>
            </a:r>
            <a:endParaRPr sz="1100">
              <a:latin typeface="Arial"/>
              <a:cs typeface="Arial"/>
            </a:endParaRPr>
          </a:p>
        </p:txBody>
      </p:sp>
      <p:sp>
        <p:nvSpPr>
          <p:cNvPr id="299" name="object 299"/>
          <p:cNvSpPr txBox="1"/>
          <p:nvPr/>
        </p:nvSpPr>
        <p:spPr>
          <a:xfrm>
            <a:off x="4180098" y="5989216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5" b="1">
                <a:latin typeface="Arial"/>
                <a:cs typeface="Arial"/>
              </a:rPr>
              <a:t>1</a:t>
            </a:r>
            <a:endParaRPr sz="1100">
              <a:latin typeface="Arial"/>
              <a:cs typeface="Arial"/>
            </a:endParaRPr>
          </a:p>
        </p:txBody>
      </p:sp>
      <p:sp>
        <p:nvSpPr>
          <p:cNvPr id="300" name="object 300"/>
          <p:cNvSpPr txBox="1"/>
          <p:nvPr/>
        </p:nvSpPr>
        <p:spPr>
          <a:xfrm>
            <a:off x="4180098" y="5624055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5" b="1">
                <a:latin typeface="Arial"/>
                <a:cs typeface="Arial"/>
              </a:rPr>
              <a:t>2</a:t>
            </a:r>
            <a:endParaRPr sz="1100">
              <a:latin typeface="Arial"/>
              <a:cs typeface="Arial"/>
            </a:endParaRPr>
          </a:p>
        </p:txBody>
      </p:sp>
      <p:sp>
        <p:nvSpPr>
          <p:cNvPr id="301" name="object 301"/>
          <p:cNvSpPr txBox="1"/>
          <p:nvPr/>
        </p:nvSpPr>
        <p:spPr>
          <a:xfrm>
            <a:off x="4180098" y="5258895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5" b="1">
                <a:latin typeface="Arial"/>
                <a:cs typeface="Arial"/>
              </a:rPr>
              <a:t>3</a:t>
            </a:r>
            <a:endParaRPr sz="1100">
              <a:latin typeface="Arial"/>
              <a:cs typeface="Arial"/>
            </a:endParaRPr>
          </a:p>
        </p:txBody>
      </p:sp>
      <p:sp>
        <p:nvSpPr>
          <p:cNvPr id="302" name="object 302"/>
          <p:cNvSpPr txBox="1"/>
          <p:nvPr/>
        </p:nvSpPr>
        <p:spPr>
          <a:xfrm>
            <a:off x="4180098" y="4893734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5" b="1">
                <a:latin typeface="Arial"/>
                <a:cs typeface="Arial"/>
              </a:rPr>
              <a:t>4</a:t>
            </a:r>
            <a:endParaRPr sz="1100">
              <a:latin typeface="Arial"/>
              <a:cs typeface="Arial"/>
            </a:endParaRPr>
          </a:p>
        </p:txBody>
      </p:sp>
      <p:sp>
        <p:nvSpPr>
          <p:cNvPr id="303" name="object 303"/>
          <p:cNvSpPr txBox="1"/>
          <p:nvPr/>
        </p:nvSpPr>
        <p:spPr>
          <a:xfrm>
            <a:off x="4180098" y="4528574"/>
            <a:ext cx="10287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5" b="1">
                <a:latin typeface="Arial"/>
                <a:cs typeface="Arial"/>
              </a:rPr>
              <a:t>5</a:t>
            </a:r>
            <a:endParaRPr sz="1100">
              <a:latin typeface="Arial"/>
              <a:cs typeface="Arial"/>
            </a:endParaRPr>
          </a:p>
        </p:txBody>
      </p:sp>
      <p:sp>
        <p:nvSpPr>
          <p:cNvPr id="304" name="object 304"/>
          <p:cNvSpPr txBox="1"/>
          <p:nvPr/>
        </p:nvSpPr>
        <p:spPr>
          <a:xfrm>
            <a:off x="3955096" y="4570406"/>
            <a:ext cx="196215" cy="1943735"/>
          </a:xfrm>
          <a:prstGeom prst="rect">
            <a:avLst/>
          </a:prstGeom>
        </p:spPr>
        <p:txBody>
          <a:bodyPr wrap="square" lIns="0" tIns="0" rIns="0" bIns="0" rtlCol="0" vert="vert270">
            <a:spAutoFit/>
          </a:bodyPr>
          <a:lstStyle/>
          <a:p>
            <a:pPr marL="12700">
              <a:lnSpc>
                <a:spcPts val="1425"/>
              </a:lnSpc>
            </a:pPr>
            <a:r>
              <a:rPr dirty="0" sz="1200" spc="-20" b="1">
                <a:latin typeface="Arial"/>
                <a:cs typeface="Arial"/>
              </a:rPr>
              <a:t>mRNA</a:t>
            </a:r>
            <a:r>
              <a:rPr dirty="0" sz="1200" spc="-40" b="1">
                <a:latin typeface="Arial"/>
                <a:cs typeface="Arial"/>
              </a:rPr>
              <a:t> </a:t>
            </a:r>
            <a:r>
              <a:rPr dirty="0" sz="1200" spc="-20" b="1">
                <a:latin typeface="Arial"/>
                <a:cs typeface="Arial"/>
              </a:rPr>
              <a:t>GCLM</a:t>
            </a:r>
            <a:r>
              <a:rPr dirty="0" sz="1200" spc="-40" b="1">
                <a:latin typeface="Arial"/>
                <a:cs typeface="Arial"/>
              </a:rPr>
              <a:t> </a:t>
            </a:r>
            <a:r>
              <a:rPr dirty="0" sz="1200" spc="-10" b="1">
                <a:latin typeface="Arial"/>
                <a:cs typeface="Arial"/>
              </a:rPr>
              <a:t>(fold</a:t>
            </a:r>
            <a:r>
              <a:rPr dirty="0" sz="1200" spc="-35" b="1">
                <a:latin typeface="Arial"/>
                <a:cs typeface="Arial"/>
              </a:rPr>
              <a:t> </a:t>
            </a:r>
            <a:r>
              <a:rPr dirty="0" sz="1200" spc="-15" b="1">
                <a:latin typeface="Arial"/>
                <a:cs typeface="Arial"/>
              </a:rPr>
              <a:t>change)</a:t>
            </a:r>
            <a:endParaRPr sz="1200">
              <a:latin typeface="Arial"/>
              <a:cs typeface="Arial"/>
            </a:endParaRPr>
          </a:p>
        </p:txBody>
      </p:sp>
      <p:sp>
        <p:nvSpPr>
          <p:cNvPr id="305" name="object 305"/>
          <p:cNvSpPr/>
          <p:nvPr/>
        </p:nvSpPr>
        <p:spPr>
          <a:xfrm>
            <a:off x="4592141" y="6778107"/>
            <a:ext cx="1012190" cy="0"/>
          </a:xfrm>
          <a:custGeom>
            <a:avLst/>
            <a:gdLst/>
            <a:ahLst/>
            <a:cxnLst/>
            <a:rect l="l" t="t" r="r" b="b"/>
            <a:pathLst>
              <a:path w="1012189" h="0">
                <a:moveTo>
                  <a:pt x="0" y="0"/>
                </a:moveTo>
                <a:lnTo>
                  <a:pt x="1012088" y="0"/>
                </a:lnTo>
              </a:path>
            </a:pathLst>
          </a:custGeom>
          <a:ln w="18262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06" name="object 306"/>
          <p:cNvSpPr txBox="1"/>
          <p:nvPr/>
        </p:nvSpPr>
        <p:spPr>
          <a:xfrm>
            <a:off x="4994089" y="6824614"/>
            <a:ext cx="236854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45" b="1">
                <a:latin typeface="Arial"/>
                <a:cs typeface="Arial"/>
              </a:rPr>
              <a:t>W</a:t>
            </a:r>
            <a:r>
              <a:rPr dirty="0" sz="1100" spc="-5" b="1">
                <a:latin typeface="Arial"/>
                <a:cs typeface="Arial"/>
              </a:rPr>
              <a:t>T</a:t>
            </a:r>
            <a:endParaRPr sz="1100">
              <a:latin typeface="Arial"/>
              <a:cs typeface="Arial"/>
            </a:endParaRPr>
          </a:p>
        </p:txBody>
      </p:sp>
      <p:sp>
        <p:nvSpPr>
          <p:cNvPr id="307" name="object 307"/>
          <p:cNvSpPr txBox="1"/>
          <p:nvPr/>
        </p:nvSpPr>
        <p:spPr>
          <a:xfrm>
            <a:off x="5987915" y="6824614"/>
            <a:ext cx="647700" cy="191770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1100" spc="-20" b="1">
                <a:latin typeface="Arial"/>
                <a:cs typeface="Arial"/>
              </a:rPr>
              <a:t>CC</a:t>
            </a:r>
            <a:r>
              <a:rPr dirty="0" sz="1100" spc="-5" b="1">
                <a:latin typeface="Arial"/>
                <a:cs typeface="Arial"/>
              </a:rPr>
              <a:t>N2</a:t>
            </a:r>
            <a:r>
              <a:rPr dirty="0" sz="1100" spc="-15" b="1">
                <a:latin typeface="Arial"/>
                <a:cs typeface="Arial"/>
              </a:rPr>
              <a:t> </a:t>
            </a:r>
            <a:r>
              <a:rPr dirty="0" sz="1100" spc="-10" b="1">
                <a:latin typeface="Arial"/>
                <a:cs typeface="Arial"/>
              </a:rPr>
              <a:t>KO</a:t>
            </a:r>
            <a:endParaRPr sz="1100">
              <a:latin typeface="Arial"/>
              <a:cs typeface="Arial"/>
            </a:endParaRPr>
          </a:p>
        </p:txBody>
      </p:sp>
      <p:sp>
        <p:nvSpPr>
          <p:cNvPr id="308" name="object 308"/>
          <p:cNvSpPr/>
          <p:nvPr/>
        </p:nvSpPr>
        <p:spPr>
          <a:xfrm>
            <a:off x="5866408" y="6781145"/>
            <a:ext cx="1012190" cy="0"/>
          </a:xfrm>
          <a:custGeom>
            <a:avLst/>
            <a:gdLst/>
            <a:ahLst/>
            <a:cxnLst/>
            <a:rect l="l" t="t" r="r" b="b"/>
            <a:pathLst>
              <a:path w="1012190" h="0">
                <a:moveTo>
                  <a:pt x="0" y="0"/>
                </a:moveTo>
                <a:lnTo>
                  <a:pt x="1012088" y="0"/>
                </a:lnTo>
              </a:path>
            </a:pathLst>
          </a:custGeom>
          <a:ln w="18262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09" name="object 309"/>
          <p:cNvSpPr txBox="1"/>
          <p:nvPr/>
        </p:nvSpPr>
        <p:spPr>
          <a:xfrm>
            <a:off x="6277483" y="4633535"/>
            <a:ext cx="163195" cy="17716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1000" spc="-45">
                <a:latin typeface="Arial"/>
                <a:cs typeface="Arial"/>
              </a:rPr>
              <a:t>**</a:t>
            </a:r>
            <a:r>
              <a:rPr dirty="0" sz="1000" spc="-5">
                <a:latin typeface="Arial"/>
                <a:cs typeface="Arial"/>
              </a:rPr>
              <a:t>*</a:t>
            </a:r>
            <a:endParaRPr sz="1000">
              <a:latin typeface="Arial"/>
              <a:cs typeface="Arial"/>
            </a:endParaRPr>
          </a:p>
        </p:txBody>
      </p:sp>
      <p:grpSp>
        <p:nvGrpSpPr>
          <p:cNvPr id="310" name="object 310"/>
          <p:cNvGrpSpPr/>
          <p:nvPr/>
        </p:nvGrpSpPr>
        <p:grpSpPr>
          <a:xfrm>
            <a:off x="6048552" y="4789982"/>
            <a:ext cx="615950" cy="47625"/>
            <a:chOff x="6048552" y="4789982"/>
            <a:chExt cx="615950" cy="47625"/>
          </a:xfrm>
        </p:grpSpPr>
        <p:sp>
          <p:nvSpPr>
            <p:cNvPr id="311" name="object 311"/>
            <p:cNvSpPr/>
            <p:nvPr/>
          </p:nvSpPr>
          <p:spPr>
            <a:xfrm>
              <a:off x="6049315" y="4790312"/>
              <a:ext cx="614680" cy="46355"/>
            </a:xfrm>
            <a:custGeom>
              <a:avLst/>
              <a:gdLst/>
              <a:ahLst/>
              <a:cxnLst/>
              <a:rect l="l" t="t" r="r" b="b"/>
              <a:pathLst>
                <a:path w="614679" h="46354">
                  <a:moveTo>
                    <a:pt x="614273" y="4991"/>
                  </a:moveTo>
                  <a:lnTo>
                    <a:pt x="614260" y="6350"/>
                  </a:lnTo>
                  <a:lnTo>
                    <a:pt x="614260" y="6527"/>
                  </a:lnTo>
                  <a:lnTo>
                    <a:pt x="614260" y="9563"/>
                  </a:lnTo>
                  <a:lnTo>
                    <a:pt x="614260" y="10160"/>
                  </a:lnTo>
                  <a:lnTo>
                    <a:pt x="612521" y="10160"/>
                  </a:lnTo>
                  <a:lnTo>
                    <a:pt x="612521" y="9563"/>
                  </a:lnTo>
                  <a:lnTo>
                    <a:pt x="614260" y="9563"/>
                  </a:lnTo>
                  <a:lnTo>
                    <a:pt x="614260" y="6527"/>
                  </a:lnTo>
                  <a:lnTo>
                    <a:pt x="612521" y="8267"/>
                  </a:lnTo>
                  <a:lnTo>
                    <a:pt x="612521" y="6350"/>
                  </a:lnTo>
                  <a:lnTo>
                    <a:pt x="614260" y="6350"/>
                  </a:lnTo>
                  <a:lnTo>
                    <a:pt x="614260" y="4991"/>
                  </a:lnTo>
                  <a:lnTo>
                    <a:pt x="614260" y="3810"/>
                  </a:lnTo>
                  <a:lnTo>
                    <a:pt x="612686" y="3810"/>
                  </a:lnTo>
                  <a:lnTo>
                    <a:pt x="612686" y="0"/>
                  </a:lnTo>
                  <a:lnTo>
                    <a:pt x="1562" y="0"/>
                  </a:lnTo>
                  <a:lnTo>
                    <a:pt x="1562" y="3810"/>
                  </a:lnTo>
                  <a:lnTo>
                    <a:pt x="0" y="3810"/>
                  </a:lnTo>
                  <a:lnTo>
                    <a:pt x="0" y="5080"/>
                  </a:lnTo>
                  <a:lnTo>
                    <a:pt x="0" y="6350"/>
                  </a:lnTo>
                  <a:lnTo>
                    <a:pt x="0" y="10160"/>
                  </a:lnTo>
                  <a:lnTo>
                    <a:pt x="0" y="45720"/>
                  </a:lnTo>
                  <a:lnTo>
                    <a:pt x="9144" y="45720"/>
                  </a:lnTo>
                  <a:lnTo>
                    <a:pt x="9144" y="10160"/>
                  </a:lnTo>
                  <a:lnTo>
                    <a:pt x="9144" y="9563"/>
                  </a:lnTo>
                  <a:lnTo>
                    <a:pt x="605129" y="9563"/>
                  </a:lnTo>
                  <a:lnTo>
                    <a:pt x="605129" y="10160"/>
                  </a:lnTo>
                  <a:lnTo>
                    <a:pt x="605129" y="45720"/>
                  </a:lnTo>
                  <a:lnTo>
                    <a:pt x="614260" y="45720"/>
                  </a:lnTo>
                  <a:lnTo>
                    <a:pt x="614260" y="46075"/>
                  </a:lnTo>
                  <a:lnTo>
                    <a:pt x="614273" y="4991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2" name="object 312"/>
            <p:cNvSpPr/>
            <p:nvPr/>
          </p:nvSpPr>
          <p:spPr>
            <a:xfrm>
              <a:off x="6049314" y="4790744"/>
              <a:ext cx="614680" cy="45720"/>
            </a:xfrm>
            <a:custGeom>
              <a:avLst/>
              <a:gdLst/>
              <a:ahLst/>
              <a:cxnLst/>
              <a:rect l="l" t="t" r="r" b="b"/>
              <a:pathLst>
                <a:path w="614679" h="45720">
                  <a:moveTo>
                    <a:pt x="605129" y="4559"/>
                  </a:moveTo>
                  <a:lnTo>
                    <a:pt x="614273" y="4559"/>
                  </a:lnTo>
                  <a:lnTo>
                    <a:pt x="614273" y="45643"/>
                  </a:lnTo>
                  <a:lnTo>
                    <a:pt x="605129" y="45643"/>
                  </a:lnTo>
                  <a:lnTo>
                    <a:pt x="605129" y="4559"/>
                  </a:lnTo>
                  <a:close/>
                </a:path>
                <a:path w="614679" h="45720">
                  <a:moveTo>
                    <a:pt x="605129" y="45656"/>
                  </a:moveTo>
                  <a:lnTo>
                    <a:pt x="605129" y="4559"/>
                  </a:lnTo>
                  <a:lnTo>
                    <a:pt x="614260" y="4559"/>
                  </a:lnTo>
                  <a:lnTo>
                    <a:pt x="614260" y="45656"/>
                  </a:lnTo>
                  <a:lnTo>
                    <a:pt x="605129" y="45656"/>
                  </a:lnTo>
                  <a:close/>
                </a:path>
                <a:path w="614679" h="45720">
                  <a:moveTo>
                    <a:pt x="9144" y="45656"/>
                  </a:moveTo>
                  <a:lnTo>
                    <a:pt x="0" y="45656"/>
                  </a:lnTo>
                  <a:lnTo>
                    <a:pt x="0" y="4571"/>
                  </a:lnTo>
                  <a:lnTo>
                    <a:pt x="9144" y="4571"/>
                  </a:lnTo>
                  <a:lnTo>
                    <a:pt x="9144" y="45656"/>
                  </a:lnTo>
                  <a:close/>
                </a:path>
                <a:path w="614679" h="45720">
                  <a:moveTo>
                    <a:pt x="9144" y="4559"/>
                  </a:moveTo>
                  <a:lnTo>
                    <a:pt x="9144" y="45656"/>
                  </a:lnTo>
                  <a:lnTo>
                    <a:pt x="0" y="45656"/>
                  </a:lnTo>
                  <a:lnTo>
                    <a:pt x="0" y="4559"/>
                  </a:lnTo>
                  <a:lnTo>
                    <a:pt x="9144" y="4559"/>
                  </a:lnTo>
                  <a:close/>
                </a:path>
                <a:path w="614679" h="45720">
                  <a:moveTo>
                    <a:pt x="4572" y="0"/>
                  </a:moveTo>
                  <a:lnTo>
                    <a:pt x="609688" y="0"/>
                  </a:lnTo>
                  <a:lnTo>
                    <a:pt x="611212" y="0"/>
                  </a:lnTo>
                  <a:lnTo>
                    <a:pt x="612736" y="1524"/>
                  </a:lnTo>
                  <a:lnTo>
                    <a:pt x="614260" y="3048"/>
                  </a:lnTo>
                  <a:lnTo>
                    <a:pt x="614260" y="4559"/>
                  </a:lnTo>
                  <a:lnTo>
                    <a:pt x="614260" y="6083"/>
                  </a:lnTo>
                  <a:lnTo>
                    <a:pt x="612736" y="7607"/>
                  </a:lnTo>
                  <a:lnTo>
                    <a:pt x="611212" y="9131"/>
                  </a:lnTo>
                  <a:lnTo>
                    <a:pt x="609688" y="9131"/>
                  </a:lnTo>
                  <a:lnTo>
                    <a:pt x="4572" y="9131"/>
                  </a:lnTo>
                  <a:lnTo>
                    <a:pt x="3035" y="9131"/>
                  </a:lnTo>
                  <a:lnTo>
                    <a:pt x="1511" y="7607"/>
                  </a:lnTo>
                  <a:lnTo>
                    <a:pt x="0" y="6083"/>
                  </a:lnTo>
                  <a:lnTo>
                    <a:pt x="0" y="4559"/>
                  </a:lnTo>
                  <a:lnTo>
                    <a:pt x="0" y="3048"/>
                  </a:lnTo>
                  <a:lnTo>
                    <a:pt x="1511" y="1524"/>
                  </a:lnTo>
                  <a:lnTo>
                    <a:pt x="3035" y="0"/>
                  </a:lnTo>
                  <a:lnTo>
                    <a:pt x="4572" y="0"/>
                  </a:lnTo>
                  <a:close/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Microsoft Office PowerPoint</Application>
  <PresentationFormat>On-screen Show (4:3)</PresentationFormat>
  <ScaleCrop>false</ScaleCrop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3</dc:title>
  <dcterms:created xsi:type="dcterms:W3CDTF">2021-11-29T10:38:33Z</dcterms:created>
  <dcterms:modified xsi:type="dcterms:W3CDTF">2021-11-29T10:38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1-11-29T00:00:00Z</vt:filetime>
  </property>
  <property fmtid="{D5CDD505-2E9C-101B-9397-08002B2CF9AE}" pid="3" name="Creator">
    <vt:lpwstr>Adobe Illustrator CC 22.1 (Windows)</vt:lpwstr>
  </property>
  <property fmtid="{D5CDD505-2E9C-101B-9397-08002B2CF9AE}" pid="4" name="LastSaved">
    <vt:filetime>2021-11-29T00:00:00Z</vt:filetime>
  </property>
</Properties>
</file>